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  <p:sldMasterId id="2147483672" r:id="rId2"/>
  </p:sldMasterIdLst>
  <p:sldIdLst>
    <p:sldId id="637" r:id="rId3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64" d="100"/>
          <a:sy n="64" d="100"/>
        </p:scale>
        <p:origin x="1292" y="5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1.xml"/><Relationship Id="rId7" Type="http://schemas.openxmlformats.org/officeDocument/2006/relationships/tableStyles" Target="tableStyle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733288551579461"/>
          <c:y val="3.3444583631591508E-2"/>
          <c:w val="0.80937533253777616"/>
          <c:h val="0.81476088216245701"/>
        </c:manualLayout>
      </c:layout>
      <c:scatterChart>
        <c:scatterStyle val="lineMarker"/>
        <c:varyColors val="0"/>
        <c:ser>
          <c:idx val="0"/>
          <c:order val="0"/>
          <c:tx>
            <c:strRef>
              <c:f>'Real Ultras. &amp; differnt group'!$P$9</c:f>
              <c:strCache>
                <c:ptCount val="1"/>
                <c:pt idx="0">
                  <c:v>Vehicle (n=7)</c:v>
                </c:pt>
              </c:strCache>
            </c:strRef>
          </c:tx>
          <c:spPr>
            <a:ln w="12700">
              <a:solidFill>
                <a:srgbClr val="FF0000"/>
              </a:solidFill>
              <a:prstDash val="solid"/>
            </a:ln>
          </c:spPr>
          <c:marker>
            <c:symbol val="triangle"/>
            <c:size val="5"/>
            <c:spPr>
              <a:solidFill>
                <a:srgbClr val="FF0000"/>
              </a:solidFill>
              <a:ln>
                <a:solidFill>
                  <a:srgbClr val="FF0000"/>
                </a:solidFill>
                <a:prstDash val="solid"/>
              </a:ln>
            </c:spPr>
          </c:marker>
          <c:errBars>
            <c:errDir val="y"/>
            <c:errBarType val="plus"/>
            <c:errValType val="cust"/>
            <c:noEndCap val="0"/>
            <c:plus>
              <c:numRef>
                <c:f>'Real Ultras. &amp; differnt group'!$AF$11:$AF$2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13</c:v>
                  </c:pt>
                  <c:pt idx="2">
                    <c:v>9.4</c:v>
                  </c:pt>
                  <c:pt idx="3">
                    <c:v>11.29</c:v>
                  </c:pt>
                  <c:pt idx="4">
                    <c:v>12.71</c:v>
                  </c:pt>
                  <c:pt idx="5">
                    <c:v>23.96</c:v>
                  </c:pt>
                  <c:pt idx="6">
                    <c:v>29.76</c:v>
                  </c:pt>
                  <c:pt idx="7">
                    <c:v>36.31</c:v>
                  </c:pt>
                  <c:pt idx="8">
                    <c:v>59.45</c:v>
                  </c:pt>
                  <c:pt idx="9">
                    <c:v>91.41</c:v>
                  </c:pt>
                  <c:pt idx="10">
                    <c:v>106.42</c:v>
                  </c:pt>
                </c:numCache>
              </c:numRef>
            </c:plus>
            <c:spPr>
              <a:ln w="12700">
                <a:solidFill>
                  <a:srgbClr val="FF0000"/>
                </a:solidFill>
                <a:prstDash val="solid"/>
              </a:ln>
            </c:spPr>
          </c:errBars>
          <c:xVal>
            <c:numRef>
              <c:f>'Real Ultras. &amp; differnt group'!$O$12:$O$21</c:f>
              <c:numCache>
                <c:formatCode>General</c:formatCode>
                <c:ptCount val="10"/>
                <c:pt idx="0">
                  <c:v>54</c:v>
                </c:pt>
                <c:pt idx="1">
                  <c:v>57</c:v>
                </c:pt>
                <c:pt idx="2">
                  <c:v>64</c:v>
                </c:pt>
                <c:pt idx="3">
                  <c:v>68</c:v>
                </c:pt>
                <c:pt idx="4">
                  <c:v>72</c:v>
                </c:pt>
                <c:pt idx="5">
                  <c:v>76</c:v>
                </c:pt>
                <c:pt idx="6">
                  <c:v>80</c:v>
                </c:pt>
                <c:pt idx="7">
                  <c:v>85</c:v>
                </c:pt>
                <c:pt idx="8">
                  <c:v>91</c:v>
                </c:pt>
                <c:pt idx="9">
                  <c:v>97</c:v>
                </c:pt>
              </c:numCache>
            </c:numRef>
          </c:xVal>
          <c:yVal>
            <c:numRef>
              <c:f>'Real Ultras. &amp; differnt group'!$P$12:$P$21</c:f>
              <c:numCache>
                <c:formatCode>0.00</c:formatCode>
                <c:ptCount val="10"/>
                <c:pt idx="0" formatCode="General">
                  <c:v>64.03</c:v>
                </c:pt>
                <c:pt idx="1">
                  <c:v>55.58</c:v>
                </c:pt>
                <c:pt idx="2">
                  <c:v>71.14</c:v>
                </c:pt>
                <c:pt idx="3" formatCode="General">
                  <c:v>79.52</c:v>
                </c:pt>
                <c:pt idx="4" formatCode="General">
                  <c:v>120.24</c:v>
                </c:pt>
                <c:pt idx="5" formatCode="General">
                  <c:v>157.43</c:v>
                </c:pt>
                <c:pt idx="6" formatCode="General">
                  <c:v>188.93</c:v>
                </c:pt>
                <c:pt idx="7" formatCode="General">
                  <c:v>283.83999999999997</c:v>
                </c:pt>
                <c:pt idx="8" formatCode="General">
                  <c:v>405.59</c:v>
                </c:pt>
                <c:pt idx="9" formatCode="General">
                  <c:v>504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0-4BB5-4719-A238-D9CE96DECC78}"/>
            </c:ext>
          </c:extLst>
        </c:ser>
        <c:ser>
          <c:idx val="4"/>
          <c:order val="1"/>
          <c:tx>
            <c:strRef>
              <c:f>'Real Ultras. &amp; differnt group'!$T$9</c:f>
              <c:strCache>
                <c:ptCount val="1"/>
                <c:pt idx="0">
                  <c:v>5mpk KRB456 (n=7)</c:v>
                </c:pt>
              </c:strCache>
            </c:strRef>
          </c:tx>
          <c:spPr>
            <a:ln w="12700" cap="rnd">
              <a:solidFill>
                <a:srgbClr val="00B050"/>
              </a:solidFill>
              <a:round/>
            </a:ln>
            <a:effectLst/>
          </c:spPr>
          <c:marker>
            <c:symbol val="square"/>
            <c:size val="5"/>
            <c:spPr>
              <a:solidFill>
                <a:srgbClr val="00B050"/>
              </a:solidFill>
              <a:ln w="9525">
                <a:solidFill>
                  <a:srgbClr val="00B050"/>
                </a:solidFill>
              </a:ln>
              <a:effectLst/>
            </c:spPr>
          </c:marker>
          <c:errBars>
            <c:errDir val="y"/>
            <c:errBarType val="minus"/>
            <c:errValType val="cust"/>
            <c:noEndCap val="0"/>
            <c:minus>
              <c:numRef>
                <c:f>'Real Ultras. &amp; differnt group'!$AJ$11:$AJ$21</c:f>
                <c:numCache>
                  <c:formatCode>General</c:formatCode>
                  <c:ptCount val="11"/>
                  <c:pt idx="0">
                    <c:v>0</c:v>
                  </c:pt>
                  <c:pt idx="1">
                    <c:v>6.09</c:v>
                  </c:pt>
                  <c:pt idx="2">
                    <c:v>4.71</c:v>
                  </c:pt>
                  <c:pt idx="3">
                    <c:v>3.72</c:v>
                  </c:pt>
                  <c:pt idx="4">
                    <c:v>16.98</c:v>
                  </c:pt>
                  <c:pt idx="5">
                    <c:v>22.34</c:v>
                  </c:pt>
                  <c:pt idx="6">
                    <c:v>16.55</c:v>
                  </c:pt>
                  <c:pt idx="7">
                    <c:v>17.12</c:v>
                  </c:pt>
                  <c:pt idx="8">
                    <c:v>21.26</c:v>
                  </c:pt>
                  <c:pt idx="9">
                    <c:v>25.01</c:v>
                  </c:pt>
                  <c:pt idx="10">
                    <c:v>23.27</c:v>
                  </c:pt>
                </c:numCache>
              </c:numRef>
            </c:minus>
            <c:spPr>
              <a:ln w="12700" cap="rnd">
                <a:solidFill>
                  <a:srgbClr val="00B050"/>
                </a:solidFill>
                <a:round/>
              </a:ln>
              <a:effectLst/>
            </c:spPr>
          </c:errBars>
          <c:xVal>
            <c:numRef>
              <c:f>'Real Ultras. &amp; differnt group'!$O$12:$O$21</c:f>
              <c:numCache>
                <c:formatCode>General</c:formatCode>
                <c:ptCount val="10"/>
                <c:pt idx="0">
                  <c:v>54</c:v>
                </c:pt>
                <c:pt idx="1">
                  <c:v>57</c:v>
                </c:pt>
                <c:pt idx="2">
                  <c:v>64</c:v>
                </c:pt>
                <c:pt idx="3">
                  <c:v>68</c:v>
                </c:pt>
                <c:pt idx="4">
                  <c:v>72</c:v>
                </c:pt>
                <c:pt idx="5">
                  <c:v>76</c:v>
                </c:pt>
                <c:pt idx="6">
                  <c:v>80</c:v>
                </c:pt>
                <c:pt idx="7">
                  <c:v>85</c:v>
                </c:pt>
                <c:pt idx="8">
                  <c:v>91</c:v>
                </c:pt>
                <c:pt idx="9">
                  <c:v>97</c:v>
                </c:pt>
              </c:numCache>
            </c:numRef>
          </c:xVal>
          <c:yVal>
            <c:numRef>
              <c:f>'Real Ultras. &amp; differnt group'!$T$12:$T$21</c:f>
              <c:numCache>
                <c:formatCode>0.00</c:formatCode>
                <c:ptCount val="10"/>
                <c:pt idx="0" formatCode="General">
                  <c:v>29.09</c:v>
                </c:pt>
                <c:pt idx="1">
                  <c:v>27.87</c:v>
                </c:pt>
                <c:pt idx="2">
                  <c:v>28.47</c:v>
                </c:pt>
                <c:pt idx="3" formatCode="General">
                  <c:v>40.33</c:v>
                </c:pt>
                <c:pt idx="4" formatCode="General">
                  <c:v>54.83</c:v>
                </c:pt>
                <c:pt idx="5" formatCode="General">
                  <c:v>68.08</c:v>
                </c:pt>
                <c:pt idx="6" formatCode="General">
                  <c:v>98.27</c:v>
                </c:pt>
                <c:pt idx="7" formatCode="General">
                  <c:v>115.29</c:v>
                </c:pt>
                <c:pt idx="8" formatCode="General">
                  <c:v>132.86000000000001</c:v>
                </c:pt>
                <c:pt idx="9" formatCode="General">
                  <c:v>151.9499999999999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4BB5-4719-A238-D9CE96DECC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1190192511"/>
        <c:axId val="1"/>
      </c:scatterChart>
      <c:valAx>
        <c:axId val="1190192511"/>
        <c:scaling>
          <c:orientation val="minMax"/>
          <c:max val="100"/>
          <c:min val="0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 b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Days after orthotopic implantation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0" vert="horz"/>
          <a:lstStyle/>
          <a:p>
            <a:pPr>
              <a:defRPr sz="1000" b="1" i="0" u="none" strike="noStrike" baseline="0">
                <a:solidFill>
                  <a:srgbClr val="333333"/>
                </a:solidFill>
                <a:latin typeface="Arial"/>
                <a:ea typeface="Arial"/>
                <a:cs typeface="Arial"/>
              </a:defRPr>
            </a:pPr>
            <a:endParaRPr lang="en-US"/>
          </a:p>
        </c:txPr>
        <c:crossAx val="1"/>
        <c:crosses val="autoZero"/>
        <c:crossBetween val="midCat"/>
        <c:majorUnit val="10"/>
        <c:minorUnit val="5"/>
      </c:valAx>
      <c:valAx>
        <c:axId val="1"/>
        <c:scaling>
          <c:orientation val="minMax"/>
          <c:max val="7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1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400" b="1">
                    <a:solidFill>
                      <a:sysClr val="windowText" lastClr="000000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Tumor vol (mm3)</a:t>
                </a:r>
              </a:p>
            </c:rich>
          </c:tx>
          <c:layout>
            <c:manualLayout>
              <c:xMode val="edge"/>
              <c:yMode val="edge"/>
              <c:x val="7.1249888947662677E-3"/>
              <c:y val="0.23716595779460628"/>
            </c:manualLayout>
          </c:layout>
          <c:overlay val="0"/>
          <c:spPr>
            <a:noFill/>
            <a:ln w="25400">
              <a:noFill/>
            </a:ln>
          </c:spPr>
        </c:title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1190192511"/>
        <c:crosses val="autoZero"/>
        <c:crossBetween val="midCat"/>
        <c:majorUnit val="10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9525">
      <a:noFill/>
    </a:ln>
  </c:spPr>
  <c:txPr>
    <a:bodyPr/>
    <a:lstStyle/>
    <a:p>
      <a:pPr>
        <a:defRPr/>
      </a:pPr>
      <a:endParaRPr lang="en-US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590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8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787123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4CCEB6-B101-42D6-AA14-5889A476F00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29021D6-3FEE-4AA1-ACD4-2592FA57474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3BC869E-6439-4B95-971E-08A0F8006B4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03E87EF-0317-4734-8169-8F02D57C63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93C7249-8A65-4887-8CEC-1AE20C608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6371894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5DE35AC-B878-4B58-87D2-FE2913AB15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AB3F5AD-0AA3-4804-90A7-96FE3C5F23A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6566C6-77E6-4D5F-8ADD-EF5960F799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E1AB55-1053-4F13-8942-A4D2098495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3999F24-6DB3-4CAD-96C8-1605461B1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0545838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93631A-2C9B-4DC9-AB1F-553282DC36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040151-9789-419F-AF25-19FA396FE2D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C9ED2FE-6FFF-4D2F-A4CB-0AD2E0CD86C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5AB9B5C-5DE4-475F-AD3C-5712D890DDE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4BC12CD-DB7C-4201-8A78-9FC7A71966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533962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A2E8EC-93E5-471A-A411-CDB2FDD25D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1A3D7A8-6F96-4199-A218-46D291B893D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E8D2094-0FA0-4F72-9DB0-B37A6CD1D5F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A38618F-3830-4FFF-AE50-D92E851A9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CE146C-CDF3-43BB-902F-B0394A5A23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9CE579B-8E36-42E4-AAAB-8E0B58D2F4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502272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F66B271-E7A8-4A9E-8580-C3BF08FCA4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2A9DC9-FBC5-47FF-8AB7-BF826C82A36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93974E5-60A3-44EF-801C-3F8942A02BF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9B1D51-8401-4F89-831D-DCFF1BFDB56E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0DDB4CB3-95C3-4DD2-837C-FF55351C5B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5C8C7566-B4C9-475D-8F99-01BEABDF34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C9E358CC-A388-435D-A083-3D6F533703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A3E7C51-996E-4A93-9788-D8D7719BA1B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8001456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6DC0149-A6E5-4EC3-9131-4DAC01AC27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FA2CA2E-4087-4F80-ACF6-5EB9B32D9E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F67216F-09A7-4A8F-9EBA-72B2DA93E4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66969AA-AC28-48E9-BDEE-509F65F9E7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9319033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ED04223F-3D97-48DF-AA2D-A2AE9A8A69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5A68E9-00B9-46AA-9E84-FB028B6AB11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4679E93-DDE7-4091-9345-833D2933C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6981809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A079618-F862-4CC0-ADDB-448D7D1A1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AADB4AB-271D-4F0D-B1A3-7A6D1DC5767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DB7AEBF-E074-4672-900A-B82219FC336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CD54FC2-B51B-40D5-9B84-F76AE92EB58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4BB546B-1D1A-47A4-A602-D10617AF0F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FF0584C-6EB2-47B6-AB61-117BDF19AD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006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65983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1D0A5F7-FC8D-46D6-ACBE-B174261E58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05101CE4-7974-4FA4-95FF-6A376EA2535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8BC0BED-35F8-40C5-B8EA-CF465636AED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4100D1D-1201-4037-A258-5859AB0EF7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26EBD25-CE80-46F7-817D-9003958835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81A877-39E1-4264-B450-53DC0D8BB2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7604106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9A941C-77BD-463F-B138-622A78BFBE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B45F6D1-1E9D-4C7C-AF91-D228326A5D4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3A022E-1443-4B9E-BDF3-07FF47213F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27B901-6B1A-4878-8039-04AB23C5E9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C8BE28-4A59-4665-8C36-0691DB9BE7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6350192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DA1D671-1406-433A-8810-ED4778BD65B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79FB6AA-DE01-4AC2-90F3-D23EC279D6D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505DBEE-99D6-4567-870F-156B03C9B5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F60DAC-CD66-4E2B-9F30-F12CF603B8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80EDD6F-8F0F-4D4C-9C35-D49FC9FEB4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760830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18856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24435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27002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96884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97696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54784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08822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A4BE860-9EB7-4C3F-A854-13F8A02CDDAB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249456-8B37-4B2B-A126-ED526368B16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189945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D6FC384-0F10-4AAA-B059-B4BFF0F435D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F5C7AD-8811-4B4F-9D46-6AF3601BC4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117AEB5-C7E6-427A-B42F-6B84C374E3D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F11C52-2874-4553-A926-2BEBE90ABB03}" type="datetimeFigureOut">
              <a:rPr lang="en-US" smtClean="0"/>
              <a:t>10/30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82CC4A-DFF4-4099-8B8C-0230D015A9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E838A4A-6A1C-4788-A47C-715F0365C55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BBBF00-2C6E-4944-A829-410886EB394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1122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8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10" Type="http://schemas.openxmlformats.org/officeDocument/2006/relationships/image" Target="../media/image8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6" name="Rectangle 55">
            <a:extLst>
              <a:ext uri="{FF2B5EF4-FFF2-40B4-BE49-F238E27FC236}">
                <a16:creationId xmlns:a16="http://schemas.microsoft.com/office/drawing/2014/main" id="{75FB676B-6FAB-4D05-90CB-FEEC7A9160F2}"/>
              </a:ext>
            </a:extLst>
          </p:cNvPr>
          <p:cNvSpPr/>
          <p:nvPr/>
        </p:nvSpPr>
        <p:spPr>
          <a:xfrm>
            <a:off x="-75005" y="25460"/>
            <a:ext cx="2452916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+mn-ea"/>
                <a:cs typeface="Arial" panose="020B0604020202020204" pitchFamily="34" charset="0"/>
              </a:rPr>
              <a:t>Supplementary Figure S8: </a:t>
            </a:r>
            <a:endParaRPr kumimoji="0" lang="en-US" sz="36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CAA772F-2F61-4CF5-8108-02EDD13641B3}"/>
              </a:ext>
            </a:extLst>
          </p:cNvPr>
          <p:cNvGrpSpPr/>
          <p:nvPr/>
        </p:nvGrpSpPr>
        <p:grpSpPr>
          <a:xfrm>
            <a:off x="1193132" y="126170"/>
            <a:ext cx="7565013" cy="6602883"/>
            <a:chOff x="1193132" y="126170"/>
            <a:chExt cx="7565013" cy="6602883"/>
          </a:xfrm>
        </p:grpSpPr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id="{F70C4B00-17BE-4E52-808E-BCFDA85F58EA}"/>
                </a:ext>
              </a:extLst>
            </p:cNvPr>
            <p:cNvSpPr/>
            <p:nvPr/>
          </p:nvSpPr>
          <p:spPr>
            <a:xfrm>
              <a:off x="2476646" y="171019"/>
              <a:ext cx="4780204" cy="3396648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ot="0" spcFirstLastPara="0" vertOverflow="overflow" horzOverflow="overflow" vert="horz" wrap="square" lIns="68580" tIns="34290" rIns="68580" bIns="34290" numCol="1" spcCol="0" rtlCol="0" fromWordArt="0" anchor="ctr" anchorCtr="0" forceAA="0" compatLnSpc="1">
              <a:prstTxWarp prst="textNoShape">
                <a:avLst/>
              </a:prstTxWarp>
              <a:noAutofit/>
            </a:bodyPr>
            <a:lstStyle/>
            <a:p>
              <a:pPr marL="0" marR="0" lvl="0" indent="0" algn="ctr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35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3BD8EB96-BFF3-4833-8B2C-049DA787CC47}"/>
                </a:ext>
              </a:extLst>
            </p:cNvPr>
            <p:cNvGrpSpPr>
              <a:grpSpLocks noChangeAspect="1"/>
            </p:cNvGrpSpPr>
            <p:nvPr/>
          </p:nvGrpSpPr>
          <p:grpSpPr>
            <a:xfrm>
              <a:off x="2456561" y="126170"/>
              <a:ext cx="4783723" cy="3330657"/>
              <a:chOff x="133729" y="1088705"/>
              <a:chExt cx="4405675" cy="3067442"/>
            </a:xfrm>
          </p:grpSpPr>
          <p:grpSp>
            <p:nvGrpSpPr>
              <p:cNvPr id="57" name="Group 56">
                <a:extLst>
                  <a:ext uri="{FF2B5EF4-FFF2-40B4-BE49-F238E27FC236}">
                    <a16:creationId xmlns:a16="http://schemas.microsoft.com/office/drawing/2014/main" id="{89F18CE3-8AC0-433B-9390-E63074CB85F6}"/>
                  </a:ext>
                </a:extLst>
              </p:cNvPr>
              <p:cNvGrpSpPr>
                <a:grpSpLocks noChangeAspect="1"/>
              </p:cNvGrpSpPr>
              <p:nvPr/>
            </p:nvGrpSpPr>
            <p:grpSpPr>
              <a:xfrm>
                <a:off x="258073" y="1226434"/>
                <a:ext cx="4281331" cy="2929713"/>
                <a:chOff x="206817" y="203919"/>
                <a:chExt cx="3957376" cy="2708031"/>
              </a:xfrm>
            </p:grpSpPr>
            <p:graphicFrame>
              <p:nvGraphicFramePr>
                <p:cNvPr id="58" name="Chart 57">
                  <a:extLst>
                    <a:ext uri="{FF2B5EF4-FFF2-40B4-BE49-F238E27FC236}">
                      <a16:creationId xmlns:a16="http://schemas.microsoft.com/office/drawing/2014/main" id="{8FDE7A2D-620A-4402-9755-581D6360E700}"/>
                    </a:ext>
                  </a:extLst>
                </p:cNvPr>
                <p:cNvGraphicFramePr>
                  <a:graphicFrameLocks/>
                </p:cNvGraphicFramePr>
                <p:nvPr>
                  <p:extLst/>
                </p:nvPr>
              </p:nvGraphicFramePr>
              <p:xfrm>
                <a:off x="206817" y="203919"/>
                <a:ext cx="3957376" cy="2708031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59" name="TextBox 58">
                  <a:extLst>
                    <a:ext uri="{FF2B5EF4-FFF2-40B4-BE49-F238E27FC236}">
                      <a16:creationId xmlns:a16="http://schemas.microsoft.com/office/drawing/2014/main" id="{F1CBE51B-6E08-439B-9B3A-EBDB340A5BE6}"/>
                    </a:ext>
                  </a:extLst>
                </p:cNvPr>
                <p:cNvSpPr txBox="1"/>
                <p:nvPr/>
              </p:nvSpPr>
              <p:spPr>
                <a:xfrm>
                  <a:off x="841568" y="313220"/>
                  <a:ext cx="886732" cy="44540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Vehicle</a:t>
                  </a:r>
                </a:p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srgbClr val="00B050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KRB-456</a:t>
                  </a:r>
                </a:p>
              </p:txBody>
            </p:sp>
            <p:cxnSp>
              <p:nvCxnSpPr>
                <p:cNvPr id="61" name="Straight Arrow Connector 60">
                  <a:extLst>
                    <a:ext uri="{FF2B5EF4-FFF2-40B4-BE49-F238E27FC236}">
                      <a16:creationId xmlns:a16="http://schemas.microsoft.com/office/drawing/2014/main" id="{E0B3BDD9-BE29-49DB-B922-847BF01F5134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443417" y="2141831"/>
                  <a:ext cx="0" cy="280252"/>
                </a:xfrm>
                <a:prstGeom prst="straightConnector1">
                  <a:avLst/>
                </a:prstGeom>
                <a:ln w="28575">
                  <a:solidFill>
                    <a:schemeClr val="tx1"/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65" name="TextBox 64">
                  <a:extLst>
                    <a:ext uri="{FF2B5EF4-FFF2-40B4-BE49-F238E27FC236}">
                      <a16:creationId xmlns:a16="http://schemas.microsoft.com/office/drawing/2014/main" id="{038685F3-4A39-411B-A770-1B4DE55E2BFB}"/>
                    </a:ext>
                  </a:extLst>
                </p:cNvPr>
                <p:cNvSpPr txBox="1"/>
                <p:nvPr/>
              </p:nvSpPr>
              <p:spPr>
                <a:xfrm>
                  <a:off x="1189240" y="1932622"/>
                  <a:ext cx="505180" cy="26200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4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Start</a:t>
                  </a:r>
                </a:p>
              </p:txBody>
            </p:sp>
            <p:sp>
              <p:nvSpPr>
                <p:cNvPr id="68" name="TextBox 67">
                  <a:extLst>
                    <a:ext uri="{FF2B5EF4-FFF2-40B4-BE49-F238E27FC236}">
                      <a16:creationId xmlns:a16="http://schemas.microsoft.com/office/drawing/2014/main" id="{13047B0F-43DD-4783-93C0-4B7685B4C1DC}"/>
                    </a:ext>
                  </a:extLst>
                </p:cNvPr>
                <p:cNvSpPr txBox="1"/>
                <p:nvPr/>
              </p:nvSpPr>
              <p:spPr>
                <a:xfrm>
                  <a:off x="2540289" y="2379434"/>
                  <a:ext cx="207695" cy="2358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69" name="TextBox 68">
                  <a:extLst>
                    <a:ext uri="{FF2B5EF4-FFF2-40B4-BE49-F238E27FC236}">
                      <a16:creationId xmlns:a16="http://schemas.microsoft.com/office/drawing/2014/main" id="{C7BC9437-D8D4-4491-8C9B-B64DFA87169E}"/>
                    </a:ext>
                  </a:extLst>
                </p:cNvPr>
                <p:cNvSpPr txBox="1"/>
                <p:nvPr/>
              </p:nvSpPr>
              <p:spPr>
                <a:xfrm>
                  <a:off x="2723518" y="2378021"/>
                  <a:ext cx="258185" cy="2358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*</a:t>
                  </a:r>
                </a:p>
              </p:txBody>
            </p:sp>
            <p:sp>
              <p:nvSpPr>
                <p:cNvPr id="70" name="TextBox 69">
                  <a:extLst>
                    <a:ext uri="{FF2B5EF4-FFF2-40B4-BE49-F238E27FC236}">
                      <a16:creationId xmlns:a16="http://schemas.microsoft.com/office/drawing/2014/main" id="{7F32E634-399B-4E1F-A027-611FFEA0E5D5}"/>
                    </a:ext>
                  </a:extLst>
                </p:cNvPr>
                <p:cNvSpPr txBox="1"/>
                <p:nvPr/>
              </p:nvSpPr>
              <p:spPr>
                <a:xfrm>
                  <a:off x="2877191" y="2346705"/>
                  <a:ext cx="207695" cy="2358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1" name="TextBox 70">
                  <a:extLst>
                    <a:ext uri="{FF2B5EF4-FFF2-40B4-BE49-F238E27FC236}">
                      <a16:creationId xmlns:a16="http://schemas.microsoft.com/office/drawing/2014/main" id="{E2EE9F33-3186-40F8-AD4C-56A08E983962}"/>
                    </a:ext>
                  </a:extLst>
                </p:cNvPr>
                <p:cNvSpPr txBox="1"/>
                <p:nvPr/>
              </p:nvSpPr>
              <p:spPr>
                <a:xfrm>
                  <a:off x="2432735" y="2379116"/>
                  <a:ext cx="209588" cy="22925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05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2" name="TextBox 71">
                  <a:extLst>
                    <a:ext uri="{FF2B5EF4-FFF2-40B4-BE49-F238E27FC236}">
                      <a16:creationId xmlns:a16="http://schemas.microsoft.com/office/drawing/2014/main" id="{785FF433-092A-43BF-9D87-0F154FC82F2A}"/>
                    </a:ext>
                  </a:extLst>
                </p:cNvPr>
                <p:cNvSpPr txBox="1"/>
                <p:nvPr/>
              </p:nvSpPr>
              <p:spPr>
                <a:xfrm>
                  <a:off x="3133985" y="2306270"/>
                  <a:ext cx="207695" cy="2358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3" name="TextBox 72">
                  <a:extLst>
                    <a:ext uri="{FF2B5EF4-FFF2-40B4-BE49-F238E27FC236}">
                      <a16:creationId xmlns:a16="http://schemas.microsoft.com/office/drawing/2014/main" id="{FCA7433E-D8D5-4F2A-A984-33C994481608}"/>
                    </a:ext>
                  </a:extLst>
                </p:cNvPr>
                <p:cNvSpPr txBox="1"/>
                <p:nvPr/>
              </p:nvSpPr>
              <p:spPr>
                <a:xfrm>
                  <a:off x="3267964" y="2192760"/>
                  <a:ext cx="207695" cy="2358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4" name="TextBox 73">
                  <a:extLst>
                    <a:ext uri="{FF2B5EF4-FFF2-40B4-BE49-F238E27FC236}">
                      <a16:creationId xmlns:a16="http://schemas.microsoft.com/office/drawing/2014/main" id="{338B3538-8A19-4E69-98C2-C46C7F275647}"/>
                    </a:ext>
                  </a:extLst>
                </p:cNvPr>
                <p:cNvSpPr txBox="1"/>
                <p:nvPr/>
              </p:nvSpPr>
              <p:spPr>
                <a:xfrm>
                  <a:off x="3426022" y="2141831"/>
                  <a:ext cx="207695" cy="2358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5" name="TextBox 74">
                  <a:extLst>
                    <a:ext uri="{FF2B5EF4-FFF2-40B4-BE49-F238E27FC236}">
                      <a16:creationId xmlns:a16="http://schemas.microsoft.com/office/drawing/2014/main" id="{AA49A6DC-6CA4-4875-92E6-19CC8C03C154}"/>
                    </a:ext>
                  </a:extLst>
                </p:cNvPr>
                <p:cNvSpPr txBox="1"/>
                <p:nvPr/>
              </p:nvSpPr>
              <p:spPr>
                <a:xfrm>
                  <a:off x="3008548" y="2325470"/>
                  <a:ext cx="207695" cy="2358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</a:t>
                  </a:r>
                </a:p>
              </p:txBody>
            </p:sp>
            <p:sp>
              <p:nvSpPr>
                <p:cNvPr id="76" name="TextBox 75">
                  <a:extLst>
                    <a:ext uri="{FF2B5EF4-FFF2-40B4-BE49-F238E27FC236}">
                      <a16:creationId xmlns:a16="http://schemas.microsoft.com/office/drawing/2014/main" id="{93D9321D-96A9-4E16-8A36-CEE11BDCE92A}"/>
                    </a:ext>
                  </a:extLst>
                </p:cNvPr>
                <p:cNvSpPr txBox="1"/>
                <p:nvPr/>
              </p:nvSpPr>
              <p:spPr>
                <a:xfrm>
                  <a:off x="3776233" y="2047535"/>
                  <a:ext cx="258185" cy="2358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*</a:t>
                  </a:r>
                </a:p>
              </p:txBody>
            </p:sp>
            <p:sp>
              <p:nvSpPr>
                <p:cNvPr id="77" name="TextBox 76">
                  <a:extLst>
                    <a:ext uri="{FF2B5EF4-FFF2-40B4-BE49-F238E27FC236}">
                      <a16:creationId xmlns:a16="http://schemas.microsoft.com/office/drawing/2014/main" id="{DFAA5275-2DE0-4262-BD23-D19DEE89B4FC}"/>
                    </a:ext>
                  </a:extLst>
                </p:cNvPr>
                <p:cNvSpPr txBox="1"/>
                <p:nvPr/>
              </p:nvSpPr>
              <p:spPr>
                <a:xfrm>
                  <a:off x="3614810" y="2100269"/>
                  <a:ext cx="207695" cy="235805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marL="0" marR="0" lvl="0" indent="0" algn="l" defTabSz="914400" rtl="0" eaLnBrk="1" fontAlgn="auto" latinLnBrk="0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ClrTx/>
                    <a:buSzTx/>
                    <a:buFontTx/>
                    <a:buNone/>
                    <a:tabLst/>
                    <a:defRPr/>
                  </a:pPr>
                  <a:r>
                    <a:rPr kumimoji="0" lang="en-US" sz="1200" b="1" i="0" u="none" strike="noStrike" kern="1200" cap="none" spc="0" normalizeH="0" baseline="0" noProof="0" dirty="0">
                      <a:ln>
                        <a:noFill/>
                      </a:ln>
                      <a:solidFill>
                        <a:prstClr val="black"/>
                      </a:solidFill>
                      <a:effectLst/>
                      <a:uLnTx/>
                      <a:uFillTx/>
                      <a:latin typeface="Arial" panose="020B0604020202020204" pitchFamily="34" charset="0"/>
                      <a:ea typeface="+mn-ea"/>
                      <a:cs typeface="Arial" panose="020B0604020202020204" pitchFamily="34" charset="0"/>
                    </a:rPr>
                    <a:t>*</a:t>
                  </a:r>
                </a:p>
              </p:txBody>
            </p:sp>
          </p:grp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6E8D304F-F56D-4487-BD1A-B5F47C7580FF}"/>
                  </a:ext>
                </a:extLst>
              </p:cNvPr>
              <p:cNvSpPr txBox="1"/>
              <p:nvPr/>
            </p:nvSpPr>
            <p:spPr>
              <a:xfrm>
                <a:off x="133729" y="1088705"/>
                <a:ext cx="347230" cy="3401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8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a.</a:t>
                </a:r>
              </a:p>
            </p:txBody>
          </p:sp>
          <p:cxnSp>
            <p:nvCxnSpPr>
              <p:cNvPr id="48" name="Straight Arrow Connector 47">
                <a:extLst>
                  <a:ext uri="{FF2B5EF4-FFF2-40B4-BE49-F238E27FC236}">
                    <a16:creationId xmlns:a16="http://schemas.microsoft.com/office/drawing/2014/main" id="{45230202-A928-4D39-A7E9-89C737668F52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2632577" y="3328431"/>
                <a:ext cx="0" cy="303194"/>
              </a:xfrm>
              <a:prstGeom prst="straightConnector1">
                <a:avLst/>
              </a:prstGeom>
              <a:ln w="28575"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0C474806-156E-4018-B719-DEFD335B5B11}"/>
                  </a:ext>
                </a:extLst>
              </p:cNvPr>
              <p:cNvSpPr txBox="1"/>
              <p:nvPr/>
            </p:nvSpPr>
            <p:spPr>
              <a:xfrm>
                <a:off x="2364986" y="3102096"/>
                <a:ext cx="536200" cy="2834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algn="l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4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Stop</a:t>
                </a:r>
              </a:p>
            </p:txBody>
          </p:sp>
        </p:grpSp>
        <p:cxnSp>
          <p:nvCxnSpPr>
            <p:cNvPr id="5" name="Straight Connector 4">
              <a:extLst>
                <a:ext uri="{FF2B5EF4-FFF2-40B4-BE49-F238E27FC236}">
                  <a16:creationId xmlns:a16="http://schemas.microsoft.com/office/drawing/2014/main" id="{8948A1CA-AC8A-482A-9407-C0CC9E0AE1FD}"/>
                </a:ext>
              </a:extLst>
            </p:cNvPr>
            <p:cNvCxnSpPr/>
            <p:nvPr/>
          </p:nvCxnSpPr>
          <p:spPr>
            <a:xfrm>
              <a:off x="3871817" y="2273324"/>
              <a:ext cx="13716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8" name="TextBox 77">
              <a:extLst>
                <a:ext uri="{FF2B5EF4-FFF2-40B4-BE49-F238E27FC236}">
                  <a16:creationId xmlns:a16="http://schemas.microsoft.com/office/drawing/2014/main" id="{7665C049-C519-4416-81AC-00ECBCDCE6E7}"/>
                </a:ext>
              </a:extLst>
            </p:cNvPr>
            <p:cNvSpPr txBox="1"/>
            <p:nvPr/>
          </p:nvSpPr>
          <p:spPr>
            <a:xfrm>
              <a:off x="4091267" y="2012181"/>
              <a:ext cx="109010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4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Treatment </a:t>
              </a:r>
            </a:p>
          </p:txBody>
        </p: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D7C6C5BB-213C-48F6-B3EF-664075743BCC}"/>
                </a:ext>
              </a:extLst>
            </p:cNvPr>
            <p:cNvGrpSpPr/>
            <p:nvPr/>
          </p:nvGrpSpPr>
          <p:grpSpPr>
            <a:xfrm>
              <a:off x="1193132" y="3659490"/>
              <a:ext cx="7445594" cy="3003673"/>
              <a:chOff x="1658196" y="171733"/>
              <a:chExt cx="7445594" cy="3003673"/>
            </a:xfrm>
          </p:grpSpPr>
          <p:pic>
            <p:nvPicPr>
              <p:cNvPr id="45" name="Picture 44">
                <a:extLst>
                  <a:ext uri="{FF2B5EF4-FFF2-40B4-BE49-F238E27FC236}">
                    <a16:creationId xmlns:a16="http://schemas.microsoft.com/office/drawing/2014/main" id="{FA10BC27-B0A0-45FA-A47B-401BDC8CEFF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r="23629"/>
              <a:stretch/>
            </p:blipFill>
            <p:spPr>
              <a:xfrm>
                <a:off x="5705001" y="498678"/>
                <a:ext cx="1660841" cy="1330951"/>
              </a:xfrm>
              <a:prstGeom prst="rect">
                <a:avLst/>
              </a:prstGeom>
            </p:spPr>
          </p:pic>
          <p:pic>
            <p:nvPicPr>
              <p:cNvPr id="47" name="Picture 46">
                <a:extLst>
                  <a:ext uri="{FF2B5EF4-FFF2-40B4-BE49-F238E27FC236}">
                    <a16:creationId xmlns:a16="http://schemas.microsoft.com/office/drawing/2014/main" id="{98EAFD72-8F9F-49C5-ACCD-96F7185A88B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l="10520" t="-484" r="14246" b="484"/>
              <a:stretch/>
            </p:blipFill>
            <p:spPr>
              <a:xfrm>
                <a:off x="5705001" y="1829629"/>
                <a:ext cx="1660872" cy="1328015"/>
              </a:xfrm>
              <a:prstGeom prst="rect">
                <a:avLst/>
              </a:prstGeom>
            </p:spPr>
          </p:pic>
          <p:sp>
            <p:nvSpPr>
              <p:cNvPr id="60" name="Freeform: Shape 59">
                <a:extLst>
                  <a:ext uri="{FF2B5EF4-FFF2-40B4-BE49-F238E27FC236}">
                    <a16:creationId xmlns:a16="http://schemas.microsoft.com/office/drawing/2014/main" id="{334597CF-5EA0-4DE7-A7B7-208ABCDA4549}"/>
                  </a:ext>
                </a:extLst>
              </p:cNvPr>
              <p:cNvSpPr/>
              <p:nvPr/>
            </p:nvSpPr>
            <p:spPr>
              <a:xfrm>
                <a:off x="6605230" y="671458"/>
                <a:ext cx="364087" cy="251282"/>
              </a:xfrm>
              <a:custGeom>
                <a:avLst/>
                <a:gdLst>
                  <a:gd name="connsiteX0" fmla="*/ 16526 w 485449"/>
                  <a:gd name="connsiteY0" fmla="*/ 53049 h 335043"/>
                  <a:gd name="connsiteX1" fmla="*/ 45834 w 485449"/>
                  <a:gd name="connsiteY1" fmla="*/ 41326 h 335043"/>
                  <a:gd name="connsiteX2" fmla="*/ 69280 w 485449"/>
                  <a:gd name="connsiteY2" fmla="*/ 23741 h 335043"/>
                  <a:gd name="connsiteX3" fmla="*/ 122034 w 485449"/>
                  <a:gd name="connsiteY3" fmla="*/ 17880 h 335043"/>
                  <a:gd name="connsiteX4" fmla="*/ 151342 w 485449"/>
                  <a:gd name="connsiteY4" fmla="*/ 12018 h 335043"/>
                  <a:gd name="connsiteX5" fmla="*/ 168926 w 485449"/>
                  <a:gd name="connsiteY5" fmla="*/ 6157 h 335043"/>
                  <a:gd name="connsiteX6" fmla="*/ 362357 w 485449"/>
                  <a:gd name="connsiteY6" fmla="*/ 295 h 335043"/>
                  <a:gd name="connsiteX7" fmla="*/ 420972 w 485449"/>
                  <a:gd name="connsiteY7" fmla="*/ 6157 h 335043"/>
                  <a:gd name="connsiteX8" fmla="*/ 426834 w 485449"/>
                  <a:gd name="connsiteY8" fmla="*/ 41326 h 335043"/>
                  <a:gd name="connsiteX9" fmla="*/ 438557 w 485449"/>
                  <a:gd name="connsiteY9" fmla="*/ 58911 h 335043"/>
                  <a:gd name="connsiteX10" fmla="*/ 444419 w 485449"/>
                  <a:gd name="connsiteY10" fmla="*/ 76495 h 335043"/>
                  <a:gd name="connsiteX11" fmla="*/ 462003 w 485449"/>
                  <a:gd name="connsiteY11" fmla="*/ 99941 h 335043"/>
                  <a:gd name="connsiteX12" fmla="*/ 473726 w 485449"/>
                  <a:gd name="connsiteY12" fmla="*/ 117526 h 335043"/>
                  <a:gd name="connsiteX13" fmla="*/ 485449 w 485449"/>
                  <a:gd name="connsiteY13" fmla="*/ 176141 h 335043"/>
                  <a:gd name="connsiteX14" fmla="*/ 479588 w 485449"/>
                  <a:gd name="connsiteY14" fmla="*/ 205449 h 335043"/>
                  <a:gd name="connsiteX15" fmla="*/ 467865 w 485449"/>
                  <a:gd name="connsiteY15" fmla="*/ 223034 h 335043"/>
                  <a:gd name="connsiteX16" fmla="*/ 438557 w 485449"/>
                  <a:gd name="connsiteY16" fmla="*/ 228895 h 335043"/>
                  <a:gd name="connsiteX17" fmla="*/ 420972 w 485449"/>
                  <a:gd name="connsiteY17" fmla="*/ 246480 h 335043"/>
                  <a:gd name="connsiteX18" fmla="*/ 409249 w 485449"/>
                  <a:gd name="connsiteY18" fmla="*/ 264065 h 335043"/>
                  <a:gd name="connsiteX19" fmla="*/ 379942 w 485449"/>
                  <a:gd name="connsiteY19" fmla="*/ 287511 h 335043"/>
                  <a:gd name="connsiteX20" fmla="*/ 362357 w 485449"/>
                  <a:gd name="connsiteY20" fmla="*/ 293372 h 335043"/>
                  <a:gd name="connsiteX21" fmla="*/ 338911 w 485449"/>
                  <a:gd name="connsiteY21" fmla="*/ 305095 h 335043"/>
                  <a:gd name="connsiteX22" fmla="*/ 333049 w 485449"/>
                  <a:gd name="connsiteY22" fmla="*/ 322680 h 335043"/>
                  <a:gd name="connsiteX23" fmla="*/ 262711 w 485449"/>
                  <a:gd name="connsiteY23" fmla="*/ 322680 h 335043"/>
                  <a:gd name="connsiteX24" fmla="*/ 256849 w 485449"/>
                  <a:gd name="connsiteY24" fmla="*/ 305095 h 335043"/>
                  <a:gd name="connsiteX25" fmla="*/ 250988 w 485449"/>
                  <a:gd name="connsiteY25" fmla="*/ 275788 h 335043"/>
                  <a:gd name="connsiteX26" fmla="*/ 227542 w 485449"/>
                  <a:gd name="connsiteY26" fmla="*/ 269926 h 335043"/>
                  <a:gd name="connsiteX27" fmla="*/ 209957 w 485449"/>
                  <a:gd name="connsiteY27" fmla="*/ 264065 h 335043"/>
                  <a:gd name="connsiteX28" fmla="*/ 186511 w 485449"/>
                  <a:gd name="connsiteY28" fmla="*/ 258203 h 335043"/>
                  <a:gd name="connsiteX29" fmla="*/ 133757 w 485449"/>
                  <a:gd name="connsiteY29" fmla="*/ 246480 h 335043"/>
                  <a:gd name="connsiteX30" fmla="*/ 98588 w 485449"/>
                  <a:gd name="connsiteY30" fmla="*/ 234757 h 335043"/>
                  <a:gd name="connsiteX31" fmla="*/ 51695 w 485449"/>
                  <a:gd name="connsiteY31" fmla="*/ 211311 h 335043"/>
                  <a:gd name="connsiteX32" fmla="*/ 16526 w 485449"/>
                  <a:gd name="connsiteY32" fmla="*/ 187865 h 335043"/>
                  <a:gd name="connsiteX33" fmla="*/ 4803 w 485449"/>
                  <a:gd name="connsiteY33" fmla="*/ 170280 h 335043"/>
                  <a:gd name="connsiteX34" fmla="*/ 16526 w 485449"/>
                  <a:gd name="connsiteY34" fmla="*/ 53049 h 33504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</a:cxnLst>
                <a:rect l="l" t="t" r="r" b="b"/>
                <a:pathLst>
                  <a:path w="485449" h="335043">
                    <a:moveTo>
                      <a:pt x="16526" y="53049"/>
                    </a:moveTo>
                    <a:cubicBezTo>
                      <a:pt x="23364" y="31557"/>
                      <a:pt x="36636" y="46436"/>
                      <a:pt x="45834" y="41326"/>
                    </a:cubicBezTo>
                    <a:cubicBezTo>
                      <a:pt x="54374" y="36582"/>
                      <a:pt x="59943" y="26614"/>
                      <a:pt x="69280" y="23741"/>
                    </a:cubicBezTo>
                    <a:cubicBezTo>
                      <a:pt x="86190" y="18538"/>
                      <a:pt x="104519" y="20382"/>
                      <a:pt x="122034" y="17880"/>
                    </a:cubicBezTo>
                    <a:cubicBezTo>
                      <a:pt x="131897" y="16471"/>
                      <a:pt x="141677" y="14434"/>
                      <a:pt x="151342" y="12018"/>
                    </a:cubicBezTo>
                    <a:cubicBezTo>
                      <a:pt x="157336" y="10520"/>
                      <a:pt x="162757" y="6500"/>
                      <a:pt x="168926" y="6157"/>
                    </a:cubicBezTo>
                    <a:cubicBezTo>
                      <a:pt x="233333" y="2579"/>
                      <a:pt x="297880" y="2249"/>
                      <a:pt x="362357" y="295"/>
                    </a:cubicBezTo>
                    <a:cubicBezTo>
                      <a:pt x="381895" y="2249"/>
                      <a:pt x="404406" y="-4385"/>
                      <a:pt x="420972" y="6157"/>
                    </a:cubicBezTo>
                    <a:cubicBezTo>
                      <a:pt x="430999" y="12538"/>
                      <a:pt x="423076" y="30051"/>
                      <a:pt x="426834" y="41326"/>
                    </a:cubicBezTo>
                    <a:cubicBezTo>
                      <a:pt x="429062" y="48009"/>
                      <a:pt x="435406" y="52610"/>
                      <a:pt x="438557" y="58911"/>
                    </a:cubicBezTo>
                    <a:cubicBezTo>
                      <a:pt x="441320" y="64437"/>
                      <a:pt x="441354" y="71131"/>
                      <a:pt x="444419" y="76495"/>
                    </a:cubicBezTo>
                    <a:cubicBezTo>
                      <a:pt x="449266" y="84977"/>
                      <a:pt x="456325" y="91992"/>
                      <a:pt x="462003" y="99941"/>
                    </a:cubicBezTo>
                    <a:cubicBezTo>
                      <a:pt x="466098" y="105674"/>
                      <a:pt x="469818" y="111664"/>
                      <a:pt x="473726" y="117526"/>
                    </a:cubicBezTo>
                    <a:cubicBezTo>
                      <a:pt x="477600" y="133022"/>
                      <a:pt x="485449" y="161764"/>
                      <a:pt x="485449" y="176141"/>
                    </a:cubicBezTo>
                    <a:cubicBezTo>
                      <a:pt x="485449" y="186104"/>
                      <a:pt x="483086" y="196121"/>
                      <a:pt x="479588" y="205449"/>
                    </a:cubicBezTo>
                    <a:cubicBezTo>
                      <a:pt x="477115" y="212045"/>
                      <a:pt x="473982" y="219539"/>
                      <a:pt x="467865" y="223034"/>
                    </a:cubicBezTo>
                    <a:cubicBezTo>
                      <a:pt x="459215" y="227977"/>
                      <a:pt x="448326" y="226941"/>
                      <a:pt x="438557" y="228895"/>
                    </a:cubicBezTo>
                    <a:cubicBezTo>
                      <a:pt x="432695" y="234757"/>
                      <a:pt x="426279" y="240112"/>
                      <a:pt x="420972" y="246480"/>
                    </a:cubicBezTo>
                    <a:cubicBezTo>
                      <a:pt x="416462" y="251892"/>
                      <a:pt x="414230" y="259084"/>
                      <a:pt x="409249" y="264065"/>
                    </a:cubicBezTo>
                    <a:cubicBezTo>
                      <a:pt x="400403" y="272911"/>
                      <a:pt x="390551" y="280881"/>
                      <a:pt x="379942" y="287511"/>
                    </a:cubicBezTo>
                    <a:cubicBezTo>
                      <a:pt x="374702" y="290786"/>
                      <a:pt x="368036" y="290938"/>
                      <a:pt x="362357" y="293372"/>
                    </a:cubicBezTo>
                    <a:cubicBezTo>
                      <a:pt x="354326" y="296814"/>
                      <a:pt x="346726" y="301187"/>
                      <a:pt x="338911" y="305095"/>
                    </a:cubicBezTo>
                    <a:cubicBezTo>
                      <a:pt x="336957" y="310957"/>
                      <a:pt x="336909" y="317855"/>
                      <a:pt x="333049" y="322680"/>
                    </a:cubicBezTo>
                    <a:cubicBezTo>
                      <a:pt x="313383" y="347263"/>
                      <a:pt x="289340" y="328598"/>
                      <a:pt x="262711" y="322680"/>
                    </a:cubicBezTo>
                    <a:cubicBezTo>
                      <a:pt x="260757" y="316818"/>
                      <a:pt x="258348" y="311089"/>
                      <a:pt x="256849" y="305095"/>
                    </a:cubicBezTo>
                    <a:cubicBezTo>
                      <a:pt x="254433" y="295430"/>
                      <a:pt x="257366" y="283441"/>
                      <a:pt x="250988" y="275788"/>
                    </a:cubicBezTo>
                    <a:cubicBezTo>
                      <a:pt x="245831" y="269599"/>
                      <a:pt x="235288" y="272139"/>
                      <a:pt x="227542" y="269926"/>
                    </a:cubicBezTo>
                    <a:cubicBezTo>
                      <a:pt x="221601" y="268229"/>
                      <a:pt x="215898" y="265762"/>
                      <a:pt x="209957" y="264065"/>
                    </a:cubicBezTo>
                    <a:cubicBezTo>
                      <a:pt x="202211" y="261852"/>
                      <a:pt x="194375" y="259951"/>
                      <a:pt x="186511" y="258203"/>
                    </a:cubicBezTo>
                    <a:cubicBezTo>
                      <a:pt x="165008" y="253424"/>
                      <a:pt x="154170" y="252604"/>
                      <a:pt x="133757" y="246480"/>
                    </a:cubicBezTo>
                    <a:cubicBezTo>
                      <a:pt x="121921" y="242929"/>
                      <a:pt x="109641" y="240283"/>
                      <a:pt x="98588" y="234757"/>
                    </a:cubicBezTo>
                    <a:cubicBezTo>
                      <a:pt x="82957" y="226942"/>
                      <a:pt x="66236" y="221005"/>
                      <a:pt x="51695" y="211311"/>
                    </a:cubicBezTo>
                    <a:lnTo>
                      <a:pt x="16526" y="187865"/>
                    </a:lnTo>
                    <a:cubicBezTo>
                      <a:pt x="12618" y="182003"/>
                      <a:pt x="7578" y="176755"/>
                      <a:pt x="4803" y="170280"/>
                    </a:cubicBezTo>
                    <a:cubicBezTo>
                      <a:pt x="-8639" y="138913"/>
                      <a:pt x="9688" y="74541"/>
                      <a:pt x="16526" y="53049"/>
                    </a:cubicBez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35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2" name="TextBox 61">
                <a:extLst>
                  <a:ext uri="{FF2B5EF4-FFF2-40B4-BE49-F238E27FC236}">
                    <a16:creationId xmlns:a16="http://schemas.microsoft.com/office/drawing/2014/main" id="{859D1A16-BFAB-493F-B2C9-0500AEF2DDF3}"/>
                  </a:ext>
                </a:extLst>
              </p:cNvPr>
              <p:cNvSpPr txBox="1"/>
              <p:nvPr/>
            </p:nvSpPr>
            <p:spPr>
              <a:xfrm>
                <a:off x="6680068" y="645740"/>
                <a:ext cx="214410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63" name="Freeform: Shape 62">
                <a:extLst>
                  <a:ext uri="{FF2B5EF4-FFF2-40B4-BE49-F238E27FC236}">
                    <a16:creationId xmlns:a16="http://schemas.microsoft.com/office/drawing/2014/main" id="{006663EE-F11B-4403-B3A6-B4E73629FC18}"/>
                  </a:ext>
                </a:extLst>
              </p:cNvPr>
              <p:cNvSpPr/>
              <p:nvPr/>
            </p:nvSpPr>
            <p:spPr>
              <a:xfrm>
                <a:off x="6129652" y="1999317"/>
                <a:ext cx="589085" cy="479181"/>
              </a:xfrm>
              <a:custGeom>
                <a:avLst/>
                <a:gdLst>
                  <a:gd name="connsiteX0" fmla="*/ 263770 w 785447"/>
                  <a:gd name="connsiteY0" fmla="*/ 29308 h 638908"/>
                  <a:gd name="connsiteX1" fmla="*/ 146539 w 785447"/>
                  <a:gd name="connsiteY1" fmla="*/ 152400 h 638908"/>
                  <a:gd name="connsiteX2" fmla="*/ 123093 w 785447"/>
                  <a:gd name="connsiteY2" fmla="*/ 169985 h 638908"/>
                  <a:gd name="connsiteX3" fmla="*/ 87924 w 785447"/>
                  <a:gd name="connsiteY3" fmla="*/ 199292 h 638908"/>
                  <a:gd name="connsiteX4" fmla="*/ 76200 w 785447"/>
                  <a:gd name="connsiteY4" fmla="*/ 211015 h 638908"/>
                  <a:gd name="connsiteX5" fmla="*/ 52754 w 785447"/>
                  <a:gd name="connsiteY5" fmla="*/ 257908 h 638908"/>
                  <a:gd name="connsiteX6" fmla="*/ 41031 w 785447"/>
                  <a:gd name="connsiteY6" fmla="*/ 275492 h 638908"/>
                  <a:gd name="connsiteX7" fmla="*/ 29308 w 785447"/>
                  <a:gd name="connsiteY7" fmla="*/ 322385 h 638908"/>
                  <a:gd name="connsiteX8" fmla="*/ 23447 w 785447"/>
                  <a:gd name="connsiteY8" fmla="*/ 369277 h 638908"/>
                  <a:gd name="connsiteX9" fmla="*/ 17585 w 785447"/>
                  <a:gd name="connsiteY9" fmla="*/ 386861 h 638908"/>
                  <a:gd name="connsiteX10" fmla="*/ 11724 w 785447"/>
                  <a:gd name="connsiteY10" fmla="*/ 410308 h 638908"/>
                  <a:gd name="connsiteX11" fmla="*/ 5862 w 785447"/>
                  <a:gd name="connsiteY11" fmla="*/ 427892 h 638908"/>
                  <a:gd name="connsiteX12" fmla="*/ 0 w 785447"/>
                  <a:gd name="connsiteY12" fmla="*/ 457200 h 638908"/>
                  <a:gd name="connsiteX13" fmla="*/ 5862 w 785447"/>
                  <a:gd name="connsiteY13" fmla="*/ 545123 h 638908"/>
                  <a:gd name="connsiteX14" fmla="*/ 41031 w 785447"/>
                  <a:gd name="connsiteY14" fmla="*/ 586154 h 638908"/>
                  <a:gd name="connsiteX15" fmla="*/ 70339 w 785447"/>
                  <a:gd name="connsiteY15" fmla="*/ 603738 h 638908"/>
                  <a:gd name="connsiteX16" fmla="*/ 87924 w 785447"/>
                  <a:gd name="connsiteY16" fmla="*/ 615461 h 638908"/>
                  <a:gd name="connsiteX17" fmla="*/ 105508 w 785447"/>
                  <a:gd name="connsiteY17" fmla="*/ 621323 h 638908"/>
                  <a:gd name="connsiteX18" fmla="*/ 128954 w 785447"/>
                  <a:gd name="connsiteY18" fmla="*/ 633046 h 638908"/>
                  <a:gd name="connsiteX19" fmla="*/ 164124 w 785447"/>
                  <a:gd name="connsiteY19" fmla="*/ 638908 h 638908"/>
                  <a:gd name="connsiteX20" fmla="*/ 257908 w 785447"/>
                  <a:gd name="connsiteY20" fmla="*/ 627185 h 638908"/>
                  <a:gd name="connsiteX21" fmla="*/ 287216 w 785447"/>
                  <a:gd name="connsiteY21" fmla="*/ 621323 h 638908"/>
                  <a:gd name="connsiteX22" fmla="*/ 310662 w 785447"/>
                  <a:gd name="connsiteY22" fmla="*/ 609600 h 638908"/>
                  <a:gd name="connsiteX23" fmla="*/ 363416 w 785447"/>
                  <a:gd name="connsiteY23" fmla="*/ 597877 h 638908"/>
                  <a:gd name="connsiteX24" fmla="*/ 375139 w 785447"/>
                  <a:gd name="connsiteY24" fmla="*/ 580292 h 638908"/>
                  <a:gd name="connsiteX25" fmla="*/ 392724 w 785447"/>
                  <a:gd name="connsiteY25" fmla="*/ 574431 h 638908"/>
                  <a:gd name="connsiteX26" fmla="*/ 463062 w 785447"/>
                  <a:gd name="connsiteY26" fmla="*/ 562708 h 638908"/>
                  <a:gd name="connsiteX27" fmla="*/ 509954 w 785447"/>
                  <a:gd name="connsiteY27" fmla="*/ 556846 h 638908"/>
                  <a:gd name="connsiteX28" fmla="*/ 580293 w 785447"/>
                  <a:gd name="connsiteY28" fmla="*/ 539261 h 638908"/>
                  <a:gd name="connsiteX29" fmla="*/ 603739 w 785447"/>
                  <a:gd name="connsiteY29" fmla="*/ 515815 h 638908"/>
                  <a:gd name="connsiteX30" fmla="*/ 621324 w 785447"/>
                  <a:gd name="connsiteY30" fmla="*/ 509954 h 638908"/>
                  <a:gd name="connsiteX31" fmla="*/ 633047 w 785447"/>
                  <a:gd name="connsiteY31" fmla="*/ 492369 h 638908"/>
                  <a:gd name="connsiteX32" fmla="*/ 656493 w 785447"/>
                  <a:gd name="connsiteY32" fmla="*/ 474785 h 638908"/>
                  <a:gd name="connsiteX33" fmla="*/ 674077 w 785447"/>
                  <a:gd name="connsiteY33" fmla="*/ 451338 h 638908"/>
                  <a:gd name="connsiteX34" fmla="*/ 697524 w 785447"/>
                  <a:gd name="connsiteY34" fmla="*/ 439615 h 638908"/>
                  <a:gd name="connsiteX35" fmla="*/ 720970 w 785447"/>
                  <a:gd name="connsiteY35" fmla="*/ 422031 h 638908"/>
                  <a:gd name="connsiteX36" fmla="*/ 762000 w 785447"/>
                  <a:gd name="connsiteY36" fmla="*/ 381000 h 638908"/>
                  <a:gd name="connsiteX37" fmla="*/ 767862 w 785447"/>
                  <a:gd name="connsiteY37" fmla="*/ 363415 h 638908"/>
                  <a:gd name="connsiteX38" fmla="*/ 779585 w 785447"/>
                  <a:gd name="connsiteY38" fmla="*/ 345831 h 638908"/>
                  <a:gd name="connsiteX39" fmla="*/ 785447 w 785447"/>
                  <a:gd name="connsiteY39" fmla="*/ 322385 h 638908"/>
                  <a:gd name="connsiteX40" fmla="*/ 779585 w 785447"/>
                  <a:gd name="connsiteY40" fmla="*/ 175846 h 638908"/>
                  <a:gd name="connsiteX41" fmla="*/ 767862 w 785447"/>
                  <a:gd name="connsiteY41" fmla="*/ 111369 h 638908"/>
                  <a:gd name="connsiteX42" fmla="*/ 720970 w 785447"/>
                  <a:gd name="connsiteY42" fmla="*/ 64477 h 638908"/>
                  <a:gd name="connsiteX43" fmla="*/ 697524 w 785447"/>
                  <a:gd name="connsiteY43" fmla="*/ 58615 h 638908"/>
                  <a:gd name="connsiteX44" fmla="*/ 685800 w 785447"/>
                  <a:gd name="connsiteY44" fmla="*/ 46892 h 638908"/>
                  <a:gd name="connsiteX45" fmla="*/ 679939 w 785447"/>
                  <a:gd name="connsiteY45" fmla="*/ 29308 h 638908"/>
                  <a:gd name="connsiteX46" fmla="*/ 644770 w 785447"/>
                  <a:gd name="connsiteY46" fmla="*/ 17585 h 638908"/>
                  <a:gd name="connsiteX47" fmla="*/ 603739 w 785447"/>
                  <a:gd name="connsiteY47" fmla="*/ 0 h 638908"/>
                  <a:gd name="connsiteX48" fmla="*/ 498231 w 785447"/>
                  <a:gd name="connsiteY48" fmla="*/ 5861 h 638908"/>
                  <a:gd name="connsiteX49" fmla="*/ 427893 w 785447"/>
                  <a:gd name="connsiteY49" fmla="*/ 46892 h 638908"/>
                  <a:gd name="connsiteX50" fmla="*/ 404447 w 785447"/>
                  <a:gd name="connsiteY50" fmla="*/ 52754 h 638908"/>
                  <a:gd name="connsiteX51" fmla="*/ 252047 w 785447"/>
                  <a:gd name="connsiteY51" fmla="*/ 35169 h 638908"/>
                  <a:gd name="connsiteX52" fmla="*/ 263770 w 785447"/>
                  <a:gd name="connsiteY52" fmla="*/ 29308 h 63890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</a:cxnLst>
                <a:rect l="l" t="t" r="r" b="b"/>
                <a:pathLst>
                  <a:path w="785447" h="638908">
                    <a:moveTo>
                      <a:pt x="263770" y="29308"/>
                    </a:moveTo>
                    <a:cubicBezTo>
                      <a:pt x="246185" y="48847"/>
                      <a:pt x="259607" y="27430"/>
                      <a:pt x="146539" y="152400"/>
                    </a:cubicBezTo>
                    <a:cubicBezTo>
                      <a:pt x="139985" y="159644"/>
                      <a:pt x="130722" y="163882"/>
                      <a:pt x="123093" y="169985"/>
                    </a:cubicBezTo>
                    <a:cubicBezTo>
                      <a:pt x="111177" y="179518"/>
                      <a:pt x="99408" y="189244"/>
                      <a:pt x="87924" y="199292"/>
                    </a:cubicBezTo>
                    <a:cubicBezTo>
                      <a:pt x="83765" y="202931"/>
                      <a:pt x="79412" y="206518"/>
                      <a:pt x="76200" y="211015"/>
                    </a:cubicBezTo>
                    <a:cubicBezTo>
                      <a:pt x="35583" y="267878"/>
                      <a:pt x="72987" y="217444"/>
                      <a:pt x="52754" y="257908"/>
                    </a:cubicBezTo>
                    <a:cubicBezTo>
                      <a:pt x="49604" y="264209"/>
                      <a:pt x="44939" y="269631"/>
                      <a:pt x="41031" y="275492"/>
                    </a:cubicBezTo>
                    <a:cubicBezTo>
                      <a:pt x="33901" y="296886"/>
                      <a:pt x="33349" y="296117"/>
                      <a:pt x="29308" y="322385"/>
                    </a:cubicBezTo>
                    <a:cubicBezTo>
                      <a:pt x="26913" y="337954"/>
                      <a:pt x="26265" y="353779"/>
                      <a:pt x="23447" y="369277"/>
                    </a:cubicBezTo>
                    <a:cubicBezTo>
                      <a:pt x="22342" y="375356"/>
                      <a:pt x="19282" y="380920"/>
                      <a:pt x="17585" y="386861"/>
                    </a:cubicBezTo>
                    <a:cubicBezTo>
                      <a:pt x="15372" y="394607"/>
                      <a:pt x="13937" y="402562"/>
                      <a:pt x="11724" y="410308"/>
                    </a:cubicBezTo>
                    <a:cubicBezTo>
                      <a:pt x="10027" y="416249"/>
                      <a:pt x="7361" y="421898"/>
                      <a:pt x="5862" y="427892"/>
                    </a:cubicBezTo>
                    <a:cubicBezTo>
                      <a:pt x="3445" y="437557"/>
                      <a:pt x="1954" y="447431"/>
                      <a:pt x="0" y="457200"/>
                    </a:cubicBezTo>
                    <a:cubicBezTo>
                      <a:pt x="1954" y="486508"/>
                      <a:pt x="101" y="516321"/>
                      <a:pt x="5862" y="545123"/>
                    </a:cubicBezTo>
                    <a:cubicBezTo>
                      <a:pt x="10495" y="568286"/>
                      <a:pt x="24217" y="575646"/>
                      <a:pt x="41031" y="586154"/>
                    </a:cubicBezTo>
                    <a:cubicBezTo>
                      <a:pt x="50692" y="592192"/>
                      <a:pt x="60678" y="597700"/>
                      <a:pt x="70339" y="603738"/>
                    </a:cubicBezTo>
                    <a:cubicBezTo>
                      <a:pt x="76313" y="607472"/>
                      <a:pt x="81623" y="612310"/>
                      <a:pt x="87924" y="615461"/>
                    </a:cubicBezTo>
                    <a:cubicBezTo>
                      <a:pt x="93450" y="618224"/>
                      <a:pt x="99829" y="618889"/>
                      <a:pt x="105508" y="621323"/>
                    </a:cubicBezTo>
                    <a:cubicBezTo>
                      <a:pt x="113539" y="624765"/>
                      <a:pt x="120585" y="630535"/>
                      <a:pt x="128954" y="633046"/>
                    </a:cubicBezTo>
                    <a:cubicBezTo>
                      <a:pt x="140338" y="636461"/>
                      <a:pt x="152401" y="636954"/>
                      <a:pt x="164124" y="638908"/>
                    </a:cubicBezTo>
                    <a:lnTo>
                      <a:pt x="257908" y="627185"/>
                    </a:lnTo>
                    <a:cubicBezTo>
                      <a:pt x="267771" y="625776"/>
                      <a:pt x="277764" y="624474"/>
                      <a:pt x="287216" y="621323"/>
                    </a:cubicBezTo>
                    <a:cubicBezTo>
                      <a:pt x="295505" y="618560"/>
                      <a:pt x="302481" y="612668"/>
                      <a:pt x="310662" y="609600"/>
                    </a:cubicBezTo>
                    <a:cubicBezTo>
                      <a:pt x="320129" y="606050"/>
                      <a:pt x="355450" y="599470"/>
                      <a:pt x="363416" y="597877"/>
                    </a:cubicBezTo>
                    <a:cubicBezTo>
                      <a:pt x="367324" y="592015"/>
                      <a:pt x="369638" y="584693"/>
                      <a:pt x="375139" y="580292"/>
                    </a:cubicBezTo>
                    <a:cubicBezTo>
                      <a:pt x="379964" y="576432"/>
                      <a:pt x="386665" y="575643"/>
                      <a:pt x="392724" y="574431"/>
                    </a:cubicBezTo>
                    <a:cubicBezTo>
                      <a:pt x="416032" y="569770"/>
                      <a:pt x="439476" y="565656"/>
                      <a:pt x="463062" y="562708"/>
                    </a:cubicBezTo>
                    <a:cubicBezTo>
                      <a:pt x="478693" y="560754"/>
                      <a:pt x="494508" y="559935"/>
                      <a:pt x="509954" y="556846"/>
                    </a:cubicBezTo>
                    <a:cubicBezTo>
                      <a:pt x="533653" y="552106"/>
                      <a:pt x="580293" y="539261"/>
                      <a:pt x="580293" y="539261"/>
                    </a:cubicBezTo>
                    <a:cubicBezTo>
                      <a:pt x="588108" y="531446"/>
                      <a:pt x="594745" y="522239"/>
                      <a:pt x="603739" y="515815"/>
                    </a:cubicBezTo>
                    <a:cubicBezTo>
                      <a:pt x="608767" y="512224"/>
                      <a:pt x="616499" y="513814"/>
                      <a:pt x="621324" y="509954"/>
                    </a:cubicBezTo>
                    <a:cubicBezTo>
                      <a:pt x="626825" y="505553"/>
                      <a:pt x="628066" y="497350"/>
                      <a:pt x="633047" y="492369"/>
                    </a:cubicBezTo>
                    <a:cubicBezTo>
                      <a:pt x="639955" y="485461"/>
                      <a:pt x="649585" y="481693"/>
                      <a:pt x="656493" y="474785"/>
                    </a:cubicBezTo>
                    <a:cubicBezTo>
                      <a:pt x="663401" y="467877"/>
                      <a:pt x="666660" y="457696"/>
                      <a:pt x="674077" y="451338"/>
                    </a:cubicBezTo>
                    <a:cubicBezTo>
                      <a:pt x="680711" y="445651"/>
                      <a:pt x="690114" y="444246"/>
                      <a:pt x="697524" y="439615"/>
                    </a:cubicBezTo>
                    <a:cubicBezTo>
                      <a:pt x="705808" y="434438"/>
                      <a:pt x="713742" y="428602"/>
                      <a:pt x="720970" y="422031"/>
                    </a:cubicBezTo>
                    <a:cubicBezTo>
                      <a:pt x="735282" y="409020"/>
                      <a:pt x="762000" y="381000"/>
                      <a:pt x="762000" y="381000"/>
                    </a:cubicBezTo>
                    <a:cubicBezTo>
                      <a:pt x="763954" y="375138"/>
                      <a:pt x="765099" y="368941"/>
                      <a:pt x="767862" y="363415"/>
                    </a:cubicBezTo>
                    <a:cubicBezTo>
                      <a:pt x="771012" y="357114"/>
                      <a:pt x="776810" y="352306"/>
                      <a:pt x="779585" y="345831"/>
                    </a:cubicBezTo>
                    <a:cubicBezTo>
                      <a:pt x="782758" y="338427"/>
                      <a:pt x="783493" y="330200"/>
                      <a:pt x="785447" y="322385"/>
                    </a:cubicBezTo>
                    <a:cubicBezTo>
                      <a:pt x="783493" y="273539"/>
                      <a:pt x="782634" y="224636"/>
                      <a:pt x="779585" y="175846"/>
                    </a:cubicBezTo>
                    <a:cubicBezTo>
                      <a:pt x="779341" y="171950"/>
                      <a:pt x="773135" y="121915"/>
                      <a:pt x="767862" y="111369"/>
                    </a:cubicBezTo>
                    <a:cubicBezTo>
                      <a:pt x="759233" y="94111"/>
                      <a:pt x="736824" y="73285"/>
                      <a:pt x="720970" y="64477"/>
                    </a:cubicBezTo>
                    <a:cubicBezTo>
                      <a:pt x="713928" y="60565"/>
                      <a:pt x="705339" y="60569"/>
                      <a:pt x="697524" y="58615"/>
                    </a:cubicBezTo>
                    <a:cubicBezTo>
                      <a:pt x="693616" y="54707"/>
                      <a:pt x="688643" y="51631"/>
                      <a:pt x="685800" y="46892"/>
                    </a:cubicBezTo>
                    <a:cubicBezTo>
                      <a:pt x="682621" y="41594"/>
                      <a:pt x="684967" y="32899"/>
                      <a:pt x="679939" y="29308"/>
                    </a:cubicBezTo>
                    <a:cubicBezTo>
                      <a:pt x="669884" y="22126"/>
                      <a:pt x="655822" y="23112"/>
                      <a:pt x="644770" y="17585"/>
                    </a:cubicBezTo>
                    <a:cubicBezTo>
                      <a:pt x="615798" y="3098"/>
                      <a:pt x="629614" y="8624"/>
                      <a:pt x="603739" y="0"/>
                    </a:cubicBezTo>
                    <a:cubicBezTo>
                      <a:pt x="568570" y="1954"/>
                      <a:pt x="533012" y="296"/>
                      <a:pt x="498231" y="5861"/>
                    </a:cubicBezTo>
                    <a:cubicBezTo>
                      <a:pt x="451286" y="13372"/>
                      <a:pt x="464124" y="26763"/>
                      <a:pt x="427893" y="46892"/>
                    </a:cubicBezTo>
                    <a:cubicBezTo>
                      <a:pt x="420851" y="50804"/>
                      <a:pt x="412262" y="50800"/>
                      <a:pt x="404447" y="52754"/>
                    </a:cubicBezTo>
                    <a:cubicBezTo>
                      <a:pt x="220499" y="44756"/>
                      <a:pt x="313650" y="72130"/>
                      <a:pt x="252047" y="35169"/>
                    </a:cubicBezTo>
                    <a:cubicBezTo>
                      <a:pt x="248301" y="32921"/>
                      <a:pt x="281355" y="9769"/>
                      <a:pt x="263770" y="29308"/>
                    </a:cubicBez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35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64" name="TextBox 63">
                <a:extLst>
                  <a:ext uri="{FF2B5EF4-FFF2-40B4-BE49-F238E27FC236}">
                    <a16:creationId xmlns:a16="http://schemas.microsoft.com/office/drawing/2014/main" id="{355477A5-AF41-413F-9A91-40184C74EC7B}"/>
                  </a:ext>
                </a:extLst>
              </p:cNvPr>
              <p:cNvSpPr txBox="1"/>
              <p:nvPr/>
            </p:nvSpPr>
            <p:spPr>
              <a:xfrm>
                <a:off x="6313545" y="2100408"/>
                <a:ext cx="221877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66" name="TextBox 65">
                <a:extLst>
                  <a:ext uri="{FF2B5EF4-FFF2-40B4-BE49-F238E27FC236}">
                    <a16:creationId xmlns:a16="http://schemas.microsoft.com/office/drawing/2014/main" id="{3C23FCF4-2AFA-4B58-BF41-4618BC472DC5}"/>
                  </a:ext>
                </a:extLst>
              </p:cNvPr>
              <p:cNvSpPr txBox="1"/>
              <p:nvPr/>
            </p:nvSpPr>
            <p:spPr>
              <a:xfrm>
                <a:off x="6829681" y="2073802"/>
                <a:ext cx="445102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K</a:t>
                </a:r>
              </a:p>
            </p:txBody>
          </p:sp>
          <p:pic>
            <p:nvPicPr>
              <p:cNvPr id="67" name="Picture 66">
                <a:extLst>
                  <a:ext uri="{FF2B5EF4-FFF2-40B4-BE49-F238E27FC236}">
                    <a16:creationId xmlns:a16="http://schemas.microsoft.com/office/drawing/2014/main" id="{52E9E014-8DCF-46CA-BC27-60E76B31B1B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/>
              <a:srcRect l="13406" r="12930"/>
              <a:stretch/>
            </p:blipFill>
            <p:spPr>
              <a:xfrm>
                <a:off x="7442917" y="505635"/>
                <a:ext cx="1660873" cy="1317035"/>
              </a:xfrm>
              <a:prstGeom prst="rect">
                <a:avLst/>
              </a:prstGeom>
            </p:spPr>
          </p:pic>
          <p:pic>
            <p:nvPicPr>
              <p:cNvPr id="79" name="Picture 78">
                <a:extLst>
                  <a:ext uri="{FF2B5EF4-FFF2-40B4-BE49-F238E27FC236}">
                    <a16:creationId xmlns:a16="http://schemas.microsoft.com/office/drawing/2014/main" id="{18822AD8-94A4-403D-8056-C1D640581DE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6"/>
              <a:srcRect l="8703" r="11422"/>
              <a:stretch/>
            </p:blipFill>
            <p:spPr>
              <a:xfrm>
                <a:off x="7442917" y="1836093"/>
                <a:ext cx="1660873" cy="1321551"/>
              </a:xfrm>
              <a:prstGeom prst="rect">
                <a:avLst/>
              </a:prstGeom>
            </p:spPr>
          </p:pic>
          <p:sp>
            <p:nvSpPr>
              <p:cNvPr id="80" name="Freeform: Shape 79">
                <a:extLst>
                  <a:ext uri="{FF2B5EF4-FFF2-40B4-BE49-F238E27FC236}">
                    <a16:creationId xmlns:a16="http://schemas.microsoft.com/office/drawing/2014/main" id="{07884ADC-2D9C-49B7-8E01-82B06A595EA8}"/>
                  </a:ext>
                </a:extLst>
              </p:cNvPr>
              <p:cNvSpPr/>
              <p:nvPr/>
            </p:nvSpPr>
            <p:spPr>
              <a:xfrm>
                <a:off x="8256058" y="787253"/>
                <a:ext cx="340546" cy="278294"/>
              </a:xfrm>
              <a:custGeom>
                <a:avLst/>
                <a:gdLst>
                  <a:gd name="connsiteX0" fmla="*/ 143400 w 454061"/>
                  <a:gd name="connsiteY0" fmla="*/ 6643 h 371059"/>
                  <a:gd name="connsiteX1" fmla="*/ 96508 w 454061"/>
                  <a:gd name="connsiteY1" fmla="*/ 18366 h 371059"/>
                  <a:gd name="connsiteX2" fmla="*/ 84784 w 454061"/>
                  <a:gd name="connsiteY2" fmla="*/ 30089 h 371059"/>
                  <a:gd name="connsiteX3" fmla="*/ 49615 w 454061"/>
                  <a:gd name="connsiteY3" fmla="*/ 35950 h 371059"/>
                  <a:gd name="connsiteX4" fmla="*/ 32031 w 454061"/>
                  <a:gd name="connsiteY4" fmla="*/ 53535 h 371059"/>
                  <a:gd name="connsiteX5" fmla="*/ 2723 w 454061"/>
                  <a:gd name="connsiteY5" fmla="*/ 71120 h 371059"/>
                  <a:gd name="connsiteX6" fmla="*/ 26169 w 454061"/>
                  <a:gd name="connsiteY6" fmla="*/ 205935 h 371059"/>
                  <a:gd name="connsiteX7" fmla="*/ 32031 w 454061"/>
                  <a:gd name="connsiteY7" fmla="*/ 241104 h 371059"/>
                  <a:gd name="connsiteX8" fmla="*/ 43754 w 454061"/>
                  <a:gd name="connsiteY8" fmla="*/ 258689 h 371059"/>
                  <a:gd name="connsiteX9" fmla="*/ 55477 w 454061"/>
                  <a:gd name="connsiteY9" fmla="*/ 282135 h 371059"/>
                  <a:gd name="connsiteX10" fmla="*/ 84784 w 454061"/>
                  <a:gd name="connsiteY10" fmla="*/ 317304 h 371059"/>
                  <a:gd name="connsiteX11" fmla="*/ 108231 w 454061"/>
                  <a:gd name="connsiteY11" fmla="*/ 329027 h 371059"/>
                  <a:gd name="connsiteX12" fmla="*/ 131677 w 454061"/>
                  <a:gd name="connsiteY12" fmla="*/ 346612 h 371059"/>
                  <a:gd name="connsiteX13" fmla="*/ 160984 w 454061"/>
                  <a:gd name="connsiteY13" fmla="*/ 352474 h 371059"/>
                  <a:gd name="connsiteX14" fmla="*/ 307523 w 454061"/>
                  <a:gd name="connsiteY14" fmla="*/ 358335 h 371059"/>
                  <a:gd name="connsiteX15" fmla="*/ 360277 w 454061"/>
                  <a:gd name="connsiteY15" fmla="*/ 358335 h 371059"/>
                  <a:gd name="connsiteX16" fmla="*/ 377861 w 454061"/>
                  <a:gd name="connsiteY16" fmla="*/ 352474 h 371059"/>
                  <a:gd name="connsiteX17" fmla="*/ 395446 w 454061"/>
                  <a:gd name="connsiteY17" fmla="*/ 334889 h 371059"/>
                  <a:gd name="connsiteX18" fmla="*/ 413031 w 454061"/>
                  <a:gd name="connsiteY18" fmla="*/ 305581 h 371059"/>
                  <a:gd name="connsiteX19" fmla="*/ 454061 w 454061"/>
                  <a:gd name="connsiteY19" fmla="*/ 276274 h 371059"/>
                  <a:gd name="connsiteX20" fmla="*/ 448200 w 454061"/>
                  <a:gd name="connsiteY20" fmla="*/ 205935 h 371059"/>
                  <a:gd name="connsiteX21" fmla="*/ 424754 w 454061"/>
                  <a:gd name="connsiteY21" fmla="*/ 170766 h 371059"/>
                  <a:gd name="connsiteX22" fmla="*/ 407169 w 454061"/>
                  <a:gd name="connsiteY22" fmla="*/ 100427 h 371059"/>
                  <a:gd name="connsiteX23" fmla="*/ 383723 w 454061"/>
                  <a:gd name="connsiteY23" fmla="*/ 59397 h 371059"/>
                  <a:gd name="connsiteX24" fmla="*/ 360277 w 454061"/>
                  <a:gd name="connsiteY24" fmla="*/ 47674 h 371059"/>
                  <a:gd name="connsiteX25" fmla="*/ 301661 w 454061"/>
                  <a:gd name="connsiteY25" fmla="*/ 30089 h 371059"/>
                  <a:gd name="connsiteX26" fmla="*/ 284077 w 454061"/>
                  <a:gd name="connsiteY26" fmla="*/ 18366 h 371059"/>
                  <a:gd name="connsiteX27" fmla="*/ 260631 w 454061"/>
                  <a:gd name="connsiteY27" fmla="*/ 6643 h 371059"/>
                  <a:gd name="connsiteX28" fmla="*/ 143400 w 454061"/>
                  <a:gd name="connsiteY28" fmla="*/ 6643 h 37105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</a:cxnLst>
                <a:rect l="l" t="t" r="r" b="b"/>
                <a:pathLst>
                  <a:path w="454061" h="371059">
                    <a:moveTo>
                      <a:pt x="143400" y="6643"/>
                    </a:moveTo>
                    <a:cubicBezTo>
                      <a:pt x="116046" y="8597"/>
                      <a:pt x="105523" y="12957"/>
                      <a:pt x="96508" y="18366"/>
                    </a:cubicBezTo>
                    <a:cubicBezTo>
                      <a:pt x="91769" y="21209"/>
                      <a:pt x="89959" y="28149"/>
                      <a:pt x="84784" y="30089"/>
                    </a:cubicBezTo>
                    <a:cubicBezTo>
                      <a:pt x="73656" y="34262"/>
                      <a:pt x="61338" y="33996"/>
                      <a:pt x="49615" y="35950"/>
                    </a:cubicBezTo>
                    <a:cubicBezTo>
                      <a:pt x="43754" y="41812"/>
                      <a:pt x="38662" y="48561"/>
                      <a:pt x="32031" y="53535"/>
                    </a:cubicBezTo>
                    <a:cubicBezTo>
                      <a:pt x="22917" y="60371"/>
                      <a:pt x="4334" y="59842"/>
                      <a:pt x="2723" y="71120"/>
                    </a:cubicBezTo>
                    <a:cubicBezTo>
                      <a:pt x="-6093" y="132831"/>
                      <a:pt x="7757" y="159905"/>
                      <a:pt x="26169" y="205935"/>
                    </a:cubicBezTo>
                    <a:cubicBezTo>
                      <a:pt x="28123" y="217658"/>
                      <a:pt x="28273" y="229829"/>
                      <a:pt x="32031" y="241104"/>
                    </a:cubicBezTo>
                    <a:cubicBezTo>
                      <a:pt x="34259" y="247787"/>
                      <a:pt x="40259" y="252572"/>
                      <a:pt x="43754" y="258689"/>
                    </a:cubicBezTo>
                    <a:cubicBezTo>
                      <a:pt x="48089" y="266276"/>
                      <a:pt x="51142" y="274548"/>
                      <a:pt x="55477" y="282135"/>
                    </a:cubicBezTo>
                    <a:cubicBezTo>
                      <a:pt x="62568" y="294545"/>
                      <a:pt x="73079" y="308943"/>
                      <a:pt x="84784" y="317304"/>
                    </a:cubicBezTo>
                    <a:cubicBezTo>
                      <a:pt x="91895" y="322383"/>
                      <a:pt x="100821" y="324396"/>
                      <a:pt x="108231" y="329027"/>
                    </a:cubicBezTo>
                    <a:cubicBezTo>
                      <a:pt x="116515" y="334205"/>
                      <a:pt x="122750" y="342644"/>
                      <a:pt x="131677" y="346612"/>
                    </a:cubicBezTo>
                    <a:cubicBezTo>
                      <a:pt x="140781" y="350658"/>
                      <a:pt x="151044" y="351811"/>
                      <a:pt x="160984" y="352474"/>
                    </a:cubicBezTo>
                    <a:cubicBezTo>
                      <a:pt x="209761" y="355726"/>
                      <a:pt x="258677" y="356381"/>
                      <a:pt x="307523" y="358335"/>
                    </a:cubicBezTo>
                    <a:cubicBezTo>
                      <a:pt x="359151" y="375544"/>
                      <a:pt x="326837" y="375055"/>
                      <a:pt x="360277" y="358335"/>
                    </a:cubicBezTo>
                    <a:cubicBezTo>
                      <a:pt x="365803" y="355572"/>
                      <a:pt x="372000" y="354428"/>
                      <a:pt x="377861" y="352474"/>
                    </a:cubicBezTo>
                    <a:cubicBezTo>
                      <a:pt x="383723" y="346612"/>
                      <a:pt x="390472" y="341521"/>
                      <a:pt x="395446" y="334889"/>
                    </a:cubicBezTo>
                    <a:cubicBezTo>
                      <a:pt x="402282" y="325775"/>
                      <a:pt x="405529" y="314155"/>
                      <a:pt x="413031" y="305581"/>
                    </a:cubicBezTo>
                    <a:cubicBezTo>
                      <a:pt x="418118" y="299767"/>
                      <a:pt x="445651" y="281881"/>
                      <a:pt x="454061" y="276274"/>
                    </a:cubicBezTo>
                    <a:cubicBezTo>
                      <a:pt x="452107" y="252828"/>
                      <a:pt x="454497" y="228604"/>
                      <a:pt x="448200" y="205935"/>
                    </a:cubicBezTo>
                    <a:cubicBezTo>
                      <a:pt x="444429" y="192360"/>
                      <a:pt x="424754" y="170766"/>
                      <a:pt x="424754" y="170766"/>
                    </a:cubicBezTo>
                    <a:cubicBezTo>
                      <a:pt x="414250" y="76236"/>
                      <a:pt x="430245" y="146580"/>
                      <a:pt x="407169" y="100427"/>
                    </a:cubicBezTo>
                    <a:cubicBezTo>
                      <a:pt x="395997" y="78083"/>
                      <a:pt x="408528" y="80658"/>
                      <a:pt x="383723" y="59397"/>
                    </a:cubicBezTo>
                    <a:cubicBezTo>
                      <a:pt x="377089" y="53711"/>
                      <a:pt x="368092" y="51582"/>
                      <a:pt x="360277" y="47674"/>
                    </a:cubicBezTo>
                    <a:cubicBezTo>
                      <a:pt x="333684" y="21078"/>
                      <a:pt x="364676" y="47274"/>
                      <a:pt x="301661" y="30089"/>
                    </a:cubicBezTo>
                    <a:cubicBezTo>
                      <a:pt x="294865" y="28236"/>
                      <a:pt x="290193" y="21861"/>
                      <a:pt x="284077" y="18366"/>
                    </a:cubicBezTo>
                    <a:cubicBezTo>
                      <a:pt x="276490" y="14031"/>
                      <a:pt x="268812" y="9711"/>
                      <a:pt x="260631" y="6643"/>
                    </a:cubicBezTo>
                    <a:cubicBezTo>
                      <a:pt x="223516" y="-7275"/>
                      <a:pt x="170754" y="4689"/>
                      <a:pt x="143400" y="6643"/>
                    </a:cubicBez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35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81" name="Freeform: Shape 80">
                <a:extLst>
                  <a:ext uri="{FF2B5EF4-FFF2-40B4-BE49-F238E27FC236}">
                    <a16:creationId xmlns:a16="http://schemas.microsoft.com/office/drawing/2014/main" id="{01996E08-B2C6-4081-A3C6-D84E60E322B3}"/>
                  </a:ext>
                </a:extLst>
              </p:cNvPr>
              <p:cNvSpPr/>
              <p:nvPr/>
            </p:nvSpPr>
            <p:spPr>
              <a:xfrm>
                <a:off x="7756229" y="2126779"/>
                <a:ext cx="611066" cy="510064"/>
              </a:xfrm>
              <a:custGeom>
                <a:avLst/>
                <a:gdLst>
                  <a:gd name="connsiteX0" fmla="*/ 164123 w 814754"/>
                  <a:gd name="connsiteY0" fmla="*/ 158297 h 680085"/>
                  <a:gd name="connsiteX1" fmla="*/ 123092 w 814754"/>
                  <a:gd name="connsiteY1" fmla="*/ 205189 h 680085"/>
                  <a:gd name="connsiteX2" fmla="*/ 105507 w 814754"/>
                  <a:gd name="connsiteY2" fmla="*/ 216912 h 680085"/>
                  <a:gd name="connsiteX3" fmla="*/ 17584 w 814754"/>
                  <a:gd name="connsiteY3" fmla="*/ 316559 h 680085"/>
                  <a:gd name="connsiteX4" fmla="*/ 0 w 814754"/>
                  <a:gd name="connsiteY4" fmla="*/ 328282 h 680085"/>
                  <a:gd name="connsiteX5" fmla="*/ 11723 w 814754"/>
                  <a:gd name="connsiteY5" fmla="*/ 433789 h 680085"/>
                  <a:gd name="connsiteX6" fmla="*/ 29307 w 814754"/>
                  <a:gd name="connsiteY6" fmla="*/ 480682 h 680085"/>
                  <a:gd name="connsiteX7" fmla="*/ 46892 w 814754"/>
                  <a:gd name="connsiteY7" fmla="*/ 539297 h 680085"/>
                  <a:gd name="connsiteX8" fmla="*/ 52754 w 814754"/>
                  <a:gd name="connsiteY8" fmla="*/ 592051 h 680085"/>
                  <a:gd name="connsiteX9" fmla="*/ 76200 w 814754"/>
                  <a:gd name="connsiteY9" fmla="*/ 633082 h 680085"/>
                  <a:gd name="connsiteX10" fmla="*/ 123092 w 814754"/>
                  <a:gd name="connsiteY10" fmla="*/ 662389 h 680085"/>
                  <a:gd name="connsiteX11" fmla="*/ 240323 w 814754"/>
                  <a:gd name="connsiteY11" fmla="*/ 668251 h 680085"/>
                  <a:gd name="connsiteX12" fmla="*/ 257907 w 814754"/>
                  <a:gd name="connsiteY12" fmla="*/ 674112 h 680085"/>
                  <a:gd name="connsiteX13" fmla="*/ 386861 w 814754"/>
                  <a:gd name="connsiteY13" fmla="*/ 668251 h 680085"/>
                  <a:gd name="connsiteX14" fmla="*/ 416169 w 814754"/>
                  <a:gd name="connsiteY14" fmla="*/ 662389 h 680085"/>
                  <a:gd name="connsiteX15" fmla="*/ 451338 w 814754"/>
                  <a:gd name="connsiteY15" fmla="*/ 650666 h 680085"/>
                  <a:gd name="connsiteX16" fmla="*/ 515815 w 814754"/>
                  <a:gd name="connsiteY16" fmla="*/ 633082 h 680085"/>
                  <a:gd name="connsiteX17" fmla="*/ 533400 w 814754"/>
                  <a:gd name="connsiteY17" fmla="*/ 621359 h 680085"/>
                  <a:gd name="connsiteX18" fmla="*/ 574430 w 814754"/>
                  <a:gd name="connsiteY18" fmla="*/ 597912 h 680085"/>
                  <a:gd name="connsiteX19" fmla="*/ 615461 w 814754"/>
                  <a:gd name="connsiteY19" fmla="*/ 568605 h 680085"/>
                  <a:gd name="connsiteX20" fmla="*/ 638907 w 814754"/>
                  <a:gd name="connsiteY20" fmla="*/ 556882 h 680085"/>
                  <a:gd name="connsiteX21" fmla="*/ 656492 w 814754"/>
                  <a:gd name="connsiteY21" fmla="*/ 545159 h 680085"/>
                  <a:gd name="connsiteX22" fmla="*/ 685800 w 814754"/>
                  <a:gd name="connsiteY22" fmla="*/ 515851 h 680085"/>
                  <a:gd name="connsiteX23" fmla="*/ 697523 w 814754"/>
                  <a:gd name="connsiteY23" fmla="*/ 498266 h 680085"/>
                  <a:gd name="connsiteX24" fmla="*/ 738554 w 814754"/>
                  <a:gd name="connsiteY24" fmla="*/ 468959 h 680085"/>
                  <a:gd name="connsiteX25" fmla="*/ 762000 w 814754"/>
                  <a:gd name="connsiteY25" fmla="*/ 439651 h 680085"/>
                  <a:gd name="connsiteX26" fmla="*/ 797169 w 814754"/>
                  <a:gd name="connsiteY26" fmla="*/ 398620 h 680085"/>
                  <a:gd name="connsiteX27" fmla="*/ 803030 w 814754"/>
                  <a:gd name="connsiteY27" fmla="*/ 375174 h 680085"/>
                  <a:gd name="connsiteX28" fmla="*/ 814754 w 814754"/>
                  <a:gd name="connsiteY28" fmla="*/ 240359 h 680085"/>
                  <a:gd name="connsiteX29" fmla="*/ 791307 w 814754"/>
                  <a:gd name="connsiteY29" fmla="*/ 128989 h 680085"/>
                  <a:gd name="connsiteX30" fmla="*/ 773723 w 814754"/>
                  <a:gd name="connsiteY30" fmla="*/ 111405 h 680085"/>
                  <a:gd name="connsiteX31" fmla="*/ 767861 w 814754"/>
                  <a:gd name="connsiteY31" fmla="*/ 87959 h 680085"/>
                  <a:gd name="connsiteX32" fmla="*/ 685800 w 814754"/>
                  <a:gd name="connsiteY32" fmla="*/ 41066 h 680085"/>
                  <a:gd name="connsiteX33" fmla="*/ 650630 w 814754"/>
                  <a:gd name="connsiteY33" fmla="*/ 23482 h 680085"/>
                  <a:gd name="connsiteX34" fmla="*/ 633046 w 814754"/>
                  <a:gd name="connsiteY34" fmla="*/ 5897 h 680085"/>
                  <a:gd name="connsiteX35" fmla="*/ 504092 w 814754"/>
                  <a:gd name="connsiteY35" fmla="*/ 5897 h 680085"/>
                  <a:gd name="connsiteX36" fmla="*/ 351692 w 814754"/>
                  <a:gd name="connsiteY36" fmla="*/ 23482 h 680085"/>
                  <a:gd name="connsiteX37" fmla="*/ 322384 w 814754"/>
                  <a:gd name="connsiteY37" fmla="*/ 35205 h 680085"/>
                  <a:gd name="connsiteX38" fmla="*/ 304800 w 814754"/>
                  <a:gd name="connsiteY38" fmla="*/ 41066 h 680085"/>
                  <a:gd name="connsiteX39" fmla="*/ 252046 w 814754"/>
                  <a:gd name="connsiteY39" fmla="*/ 52789 h 680085"/>
                  <a:gd name="connsiteX40" fmla="*/ 228600 w 814754"/>
                  <a:gd name="connsiteY40" fmla="*/ 70374 h 680085"/>
                  <a:gd name="connsiteX41" fmla="*/ 193430 w 814754"/>
                  <a:gd name="connsiteY41" fmla="*/ 87959 h 680085"/>
                  <a:gd name="connsiteX42" fmla="*/ 181707 w 814754"/>
                  <a:gd name="connsiteY42" fmla="*/ 105543 h 680085"/>
                  <a:gd name="connsiteX43" fmla="*/ 164123 w 814754"/>
                  <a:gd name="connsiteY43" fmla="*/ 123128 h 680085"/>
                  <a:gd name="connsiteX44" fmla="*/ 164123 w 814754"/>
                  <a:gd name="connsiteY44" fmla="*/ 158297 h 68008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</a:cxnLst>
                <a:rect l="l" t="t" r="r" b="b"/>
                <a:pathLst>
                  <a:path w="814754" h="680085">
                    <a:moveTo>
                      <a:pt x="164123" y="158297"/>
                    </a:moveTo>
                    <a:cubicBezTo>
                      <a:pt x="157284" y="171974"/>
                      <a:pt x="138954" y="191971"/>
                      <a:pt x="123092" y="205189"/>
                    </a:cubicBezTo>
                    <a:cubicBezTo>
                      <a:pt x="117680" y="209699"/>
                      <a:pt x="110285" y="211735"/>
                      <a:pt x="105507" y="216912"/>
                    </a:cubicBezTo>
                    <a:cubicBezTo>
                      <a:pt x="94604" y="228724"/>
                      <a:pt x="41136" y="300857"/>
                      <a:pt x="17584" y="316559"/>
                    </a:cubicBezTo>
                    <a:lnTo>
                      <a:pt x="0" y="328282"/>
                    </a:lnTo>
                    <a:cubicBezTo>
                      <a:pt x="3542" y="374330"/>
                      <a:pt x="2070" y="395178"/>
                      <a:pt x="11723" y="433789"/>
                    </a:cubicBezTo>
                    <a:cubicBezTo>
                      <a:pt x="15209" y="447734"/>
                      <a:pt x="24999" y="468835"/>
                      <a:pt x="29307" y="480682"/>
                    </a:cubicBezTo>
                    <a:cubicBezTo>
                      <a:pt x="40723" y="512076"/>
                      <a:pt x="39894" y="511306"/>
                      <a:pt x="46892" y="539297"/>
                    </a:cubicBezTo>
                    <a:cubicBezTo>
                      <a:pt x="48846" y="556882"/>
                      <a:pt x="49845" y="574599"/>
                      <a:pt x="52754" y="592051"/>
                    </a:cubicBezTo>
                    <a:cubicBezTo>
                      <a:pt x="55685" y="609638"/>
                      <a:pt x="64424" y="619344"/>
                      <a:pt x="76200" y="633082"/>
                    </a:cubicBezTo>
                    <a:cubicBezTo>
                      <a:pt x="89441" y="648530"/>
                      <a:pt x="101044" y="659743"/>
                      <a:pt x="123092" y="662389"/>
                    </a:cubicBezTo>
                    <a:cubicBezTo>
                      <a:pt x="161939" y="667051"/>
                      <a:pt x="201246" y="666297"/>
                      <a:pt x="240323" y="668251"/>
                    </a:cubicBezTo>
                    <a:cubicBezTo>
                      <a:pt x="246184" y="670205"/>
                      <a:pt x="251849" y="672900"/>
                      <a:pt x="257907" y="674112"/>
                    </a:cubicBezTo>
                    <a:cubicBezTo>
                      <a:pt x="314471" y="685425"/>
                      <a:pt x="314642" y="679084"/>
                      <a:pt x="386861" y="668251"/>
                    </a:cubicBezTo>
                    <a:cubicBezTo>
                      <a:pt x="396714" y="666773"/>
                      <a:pt x="406557" y="665010"/>
                      <a:pt x="416169" y="662389"/>
                    </a:cubicBezTo>
                    <a:cubicBezTo>
                      <a:pt x="428091" y="659138"/>
                      <a:pt x="439350" y="653663"/>
                      <a:pt x="451338" y="650666"/>
                    </a:cubicBezTo>
                    <a:cubicBezTo>
                      <a:pt x="504224" y="637444"/>
                      <a:pt x="482945" y="644037"/>
                      <a:pt x="515815" y="633082"/>
                    </a:cubicBezTo>
                    <a:cubicBezTo>
                      <a:pt x="521677" y="629174"/>
                      <a:pt x="527359" y="624984"/>
                      <a:pt x="533400" y="621359"/>
                    </a:cubicBezTo>
                    <a:cubicBezTo>
                      <a:pt x="546907" y="613254"/>
                      <a:pt x="561180" y="606430"/>
                      <a:pt x="574430" y="597912"/>
                    </a:cubicBezTo>
                    <a:cubicBezTo>
                      <a:pt x="588568" y="588823"/>
                      <a:pt x="601281" y="577628"/>
                      <a:pt x="615461" y="568605"/>
                    </a:cubicBezTo>
                    <a:cubicBezTo>
                      <a:pt x="622833" y="563914"/>
                      <a:pt x="631320" y="561217"/>
                      <a:pt x="638907" y="556882"/>
                    </a:cubicBezTo>
                    <a:cubicBezTo>
                      <a:pt x="645024" y="553387"/>
                      <a:pt x="650630" y="549067"/>
                      <a:pt x="656492" y="545159"/>
                    </a:cubicBezTo>
                    <a:cubicBezTo>
                      <a:pt x="687753" y="498266"/>
                      <a:pt x="646723" y="554928"/>
                      <a:pt x="685800" y="515851"/>
                    </a:cubicBezTo>
                    <a:cubicBezTo>
                      <a:pt x="690781" y="510870"/>
                      <a:pt x="693013" y="503678"/>
                      <a:pt x="697523" y="498266"/>
                    </a:cubicBezTo>
                    <a:cubicBezTo>
                      <a:pt x="714496" y="477898"/>
                      <a:pt x="714850" y="480810"/>
                      <a:pt x="738554" y="468959"/>
                    </a:cubicBezTo>
                    <a:cubicBezTo>
                      <a:pt x="748176" y="440090"/>
                      <a:pt x="737526" y="460047"/>
                      <a:pt x="762000" y="439651"/>
                    </a:cubicBezTo>
                    <a:cubicBezTo>
                      <a:pt x="778325" y="426047"/>
                      <a:pt x="784235" y="415865"/>
                      <a:pt x="797169" y="398620"/>
                    </a:cubicBezTo>
                    <a:cubicBezTo>
                      <a:pt x="799123" y="390805"/>
                      <a:pt x="801891" y="383149"/>
                      <a:pt x="803030" y="375174"/>
                    </a:cubicBezTo>
                    <a:cubicBezTo>
                      <a:pt x="807229" y="345781"/>
                      <a:pt x="812832" y="265338"/>
                      <a:pt x="814754" y="240359"/>
                    </a:cubicBezTo>
                    <a:cubicBezTo>
                      <a:pt x="810088" y="175039"/>
                      <a:pt x="822167" y="170136"/>
                      <a:pt x="791307" y="128989"/>
                    </a:cubicBezTo>
                    <a:cubicBezTo>
                      <a:pt x="786333" y="122358"/>
                      <a:pt x="779584" y="117266"/>
                      <a:pt x="773723" y="111405"/>
                    </a:cubicBezTo>
                    <a:cubicBezTo>
                      <a:pt x="771769" y="103590"/>
                      <a:pt x="773166" y="94022"/>
                      <a:pt x="767861" y="87959"/>
                    </a:cubicBezTo>
                    <a:cubicBezTo>
                      <a:pt x="754972" y="73228"/>
                      <a:pt x="699625" y="47978"/>
                      <a:pt x="685800" y="41066"/>
                    </a:cubicBezTo>
                    <a:lnTo>
                      <a:pt x="650630" y="23482"/>
                    </a:lnTo>
                    <a:cubicBezTo>
                      <a:pt x="644769" y="17620"/>
                      <a:pt x="640743" y="8976"/>
                      <a:pt x="633046" y="5897"/>
                    </a:cubicBezTo>
                    <a:cubicBezTo>
                      <a:pt x="601571" y="-6693"/>
                      <a:pt x="523664" y="4592"/>
                      <a:pt x="504092" y="5897"/>
                    </a:cubicBezTo>
                    <a:cubicBezTo>
                      <a:pt x="446552" y="44256"/>
                      <a:pt x="509686" y="6554"/>
                      <a:pt x="351692" y="23482"/>
                    </a:cubicBezTo>
                    <a:cubicBezTo>
                      <a:pt x="341230" y="24603"/>
                      <a:pt x="332236" y="31511"/>
                      <a:pt x="322384" y="35205"/>
                    </a:cubicBezTo>
                    <a:cubicBezTo>
                      <a:pt x="316599" y="37374"/>
                      <a:pt x="310831" y="39726"/>
                      <a:pt x="304800" y="41066"/>
                    </a:cubicBezTo>
                    <a:cubicBezTo>
                      <a:pt x="242905" y="54820"/>
                      <a:pt x="291630" y="39595"/>
                      <a:pt x="252046" y="52789"/>
                    </a:cubicBezTo>
                    <a:cubicBezTo>
                      <a:pt x="244231" y="58651"/>
                      <a:pt x="236977" y="65348"/>
                      <a:pt x="228600" y="70374"/>
                    </a:cubicBezTo>
                    <a:cubicBezTo>
                      <a:pt x="217361" y="77118"/>
                      <a:pt x="203916" y="80095"/>
                      <a:pt x="193430" y="87959"/>
                    </a:cubicBezTo>
                    <a:cubicBezTo>
                      <a:pt x="187794" y="92186"/>
                      <a:pt x="186217" y="100131"/>
                      <a:pt x="181707" y="105543"/>
                    </a:cubicBezTo>
                    <a:cubicBezTo>
                      <a:pt x="176400" y="111911"/>
                      <a:pt x="169984" y="117266"/>
                      <a:pt x="164123" y="123128"/>
                    </a:cubicBezTo>
                    <a:cubicBezTo>
                      <a:pt x="157387" y="143333"/>
                      <a:pt x="170962" y="144620"/>
                      <a:pt x="164123" y="158297"/>
                    </a:cubicBez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35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82" name="TextBox 81">
                <a:extLst>
                  <a:ext uri="{FF2B5EF4-FFF2-40B4-BE49-F238E27FC236}">
                    <a16:creationId xmlns:a16="http://schemas.microsoft.com/office/drawing/2014/main" id="{8C5769E0-B82B-4474-B379-4448C5B54E5C}"/>
                  </a:ext>
                </a:extLst>
              </p:cNvPr>
              <p:cNvSpPr txBox="1"/>
              <p:nvPr/>
            </p:nvSpPr>
            <p:spPr>
              <a:xfrm>
                <a:off x="7950823" y="2271858"/>
                <a:ext cx="221877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83" name="TextBox 82">
                <a:extLst>
                  <a:ext uri="{FF2B5EF4-FFF2-40B4-BE49-F238E27FC236}">
                    <a16:creationId xmlns:a16="http://schemas.microsoft.com/office/drawing/2014/main" id="{F01E700A-707E-412D-A059-6EB952D87440}"/>
                  </a:ext>
                </a:extLst>
              </p:cNvPr>
              <p:cNvSpPr txBox="1"/>
              <p:nvPr/>
            </p:nvSpPr>
            <p:spPr>
              <a:xfrm>
                <a:off x="8297097" y="792692"/>
                <a:ext cx="221877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84" name="TextBox 83">
                <a:extLst>
                  <a:ext uri="{FF2B5EF4-FFF2-40B4-BE49-F238E27FC236}">
                    <a16:creationId xmlns:a16="http://schemas.microsoft.com/office/drawing/2014/main" id="{2CCE6D65-17A7-4F1A-BF09-0A55199EFFDC}"/>
                  </a:ext>
                </a:extLst>
              </p:cNvPr>
              <p:cNvSpPr txBox="1"/>
              <p:nvPr/>
            </p:nvSpPr>
            <p:spPr>
              <a:xfrm>
                <a:off x="8624819" y="858784"/>
                <a:ext cx="450755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K</a:t>
                </a:r>
              </a:p>
            </p:txBody>
          </p:sp>
          <p:sp>
            <p:nvSpPr>
              <p:cNvPr id="85" name="TextBox 84">
                <a:extLst>
                  <a:ext uri="{FF2B5EF4-FFF2-40B4-BE49-F238E27FC236}">
                    <a16:creationId xmlns:a16="http://schemas.microsoft.com/office/drawing/2014/main" id="{BB3D2C81-B633-479D-9854-DF6EE204379C}"/>
                  </a:ext>
                </a:extLst>
              </p:cNvPr>
              <p:cNvSpPr txBox="1"/>
              <p:nvPr/>
            </p:nvSpPr>
            <p:spPr>
              <a:xfrm>
                <a:off x="8415689" y="2262955"/>
                <a:ext cx="435897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LK</a:t>
                </a:r>
              </a:p>
            </p:txBody>
          </p:sp>
          <p:sp>
            <p:nvSpPr>
              <p:cNvPr id="86" name="TextBox 85">
                <a:extLst>
                  <a:ext uri="{FF2B5EF4-FFF2-40B4-BE49-F238E27FC236}">
                    <a16:creationId xmlns:a16="http://schemas.microsoft.com/office/drawing/2014/main" id="{C971B01C-C349-42C3-A8FE-C3AC60E63F86}"/>
                  </a:ext>
                </a:extLst>
              </p:cNvPr>
              <p:cNvSpPr txBox="1"/>
              <p:nvPr/>
            </p:nvSpPr>
            <p:spPr>
              <a:xfrm>
                <a:off x="6165740" y="171733"/>
                <a:ext cx="235323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KRB 456</a:t>
                </a:r>
              </a:p>
            </p:txBody>
          </p:sp>
          <p:pic>
            <p:nvPicPr>
              <p:cNvPr id="87" name="Picture 86">
                <a:extLst>
                  <a:ext uri="{FF2B5EF4-FFF2-40B4-BE49-F238E27FC236}">
                    <a16:creationId xmlns:a16="http://schemas.microsoft.com/office/drawing/2014/main" id="{2077E80A-DCFD-43BB-B155-D4229736C6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7"/>
              <a:srcRect r="23499"/>
              <a:stretch/>
            </p:blipFill>
            <p:spPr>
              <a:xfrm>
                <a:off x="2051330" y="481713"/>
                <a:ext cx="1660874" cy="1337982"/>
              </a:xfrm>
              <a:prstGeom prst="rect">
                <a:avLst/>
              </a:prstGeom>
            </p:spPr>
          </p:pic>
          <p:pic>
            <p:nvPicPr>
              <p:cNvPr id="88" name="Picture 87">
                <a:extLst>
                  <a:ext uri="{FF2B5EF4-FFF2-40B4-BE49-F238E27FC236}">
                    <a16:creationId xmlns:a16="http://schemas.microsoft.com/office/drawing/2014/main" id="{29627A01-622C-48CD-AB44-27E0F118927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8"/>
              <a:srcRect l="2890" r="25503"/>
              <a:stretch/>
            </p:blipFill>
            <p:spPr>
              <a:xfrm>
                <a:off x="2051329" y="1840955"/>
                <a:ext cx="1660875" cy="1333486"/>
              </a:xfrm>
              <a:prstGeom prst="rect">
                <a:avLst/>
              </a:prstGeom>
            </p:spPr>
          </p:pic>
          <p:sp>
            <p:nvSpPr>
              <p:cNvPr id="89" name="Freeform: Shape 88">
                <a:extLst>
                  <a:ext uri="{FF2B5EF4-FFF2-40B4-BE49-F238E27FC236}">
                    <a16:creationId xmlns:a16="http://schemas.microsoft.com/office/drawing/2014/main" id="{D93A121C-5370-41DC-A761-CF915F1CF2C8}"/>
                  </a:ext>
                </a:extLst>
              </p:cNvPr>
              <p:cNvSpPr/>
              <p:nvPr/>
            </p:nvSpPr>
            <p:spPr>
              <a:xfrm>
                <a:off x="2337080" y="674775"/>
                <a:ext cx="342900" cy="337946"/>
              </a:xfrm>
              <a:custGeom>
                <a:avLst/>
                <a:gdLst>
                  <a:gd name="connsiteX0" fmla="*/ 96982 w 457200"/>
                  <a:gd name="connsiteY0" fmla="*/ 323 h 450595"/>
                  <a:gd name="connsiteX1" fmla="*/ 62345 w 457200"/>
                  <a:gd name="connsiteY1" fmla="*/ 14177 h 450595"/>
                  <a:gd name="connsiteX2" fmla="*/ 13855 w 457200"/>
                  <a:gd name="connsiteY2" fmla="*/ 48814 h 450595"/>
                  <a:gd name="connsiteX3" fmla="*/ 6927 w 457200"/>
                  <a:gd name="connsiteY3" fmla="*/ 118086 h 450595"/>
                  <a:gd name="connsiteX4" fmla="*/ 0 w 457200"/>
                  <a:gd name="connsiteY4" fmla="*/ 138868 h 450595"/>
                  <a:gd name="connsiteX5" fmla="*/ 6927 w 457200"/>
                  <a:gd name="connsiteY5" fmla="*/ 339759 h 450595"/>
                  <a:gd name="connsiteX6" fmla="*/ 20782 w 457200"/>
                  <a:gd name="connsiteY6" fmla="*/ 360541 h 450595"/>
                  <a:gd name="connsiteX7" fmla="*/ 48491 w 457200"/>
                  <a:gd name="connsiteY7" fmla="*/ 388250 h 450595"/>
                  <a:gd name="connsiteX8" fmla="*/ 103909 w 457200"/>
                  <a:gd name="connsiteY8" fmla="*/ 422886 h 450595"/>
                  <a:gd name="connsiteX9" fmla="*/ 159327 w 457200"/>
                  <a:gd name="connsiteY9" fmla="*/ 450595 h 450595"/>
                  <a:gd name="connsiteX10" fmla="*/ 381000 w 457200"/>
                  <a:gd name="connsiteY10" fmla="*/ 422886 h 450595"/>
                  <a:gd name="connsiteX11" fmla="*/ 401782 w 457200"/>
                  <a:gd name="connsiteY11" fmla="*/ 409032 h 450595"/>
                  <a:gd name="connsiteX12" fmla="*/ 443345 w 457200"/>
                  <a:gd name="connsiteY12" fmla="*/ 346686 h 450595"/>
                  <a:gd name="connsiteX13" fmla="*/ 457200 w 457200"/>
                  <a:gd name="connsiteY13" fmla="*/ 291268 h 450595"/>
                  <a:gd name="connsiteX14" fmla="*/ 443345 w 457200"/>
                  <a:gd name="connsiteY14" fmla="*/ 145795 h 450595"/>
                  <a:gd name="connsiteX15" fmla="*/ 436418 w 457200"/>
                  <a:gd name="connsiteY15" fmla="*/ 118086 h 450595"/>
                  <a:gd name="connsiteX16" fmla="*/ 422564 w 457200"/>
                  <a:gd name="connsiteY16" fmla="*/ 83450 h 450595"/>
                  <a:gd name="connsiteX17" fmla="*/ 401782 w 457200"/>
                  <a:gd name="connsiteY17" fmla="*/ 62668 h 450595"/>
                  <a:gd name="connsiteX18" fmla="*/ 360218 w 457200"/>
                  <a:gd name="connsiteY18" fmla="*/ 14177 h 450595"/>
                  <a:gd name="connsiteX19" fmla="*/ 339436 w 457200"/>
                  <a:gd name="connsiteY19" fmla="*/ 7250 h 450595"/>
                  <a:gd name="connsiteX20" fmla="*/ 242455 w 457200"/>
                  <a:gd name="connsiteY20" fmla="*/ 21105 h 450595"/>
                  <a:gd name="connsiteX21" fmla="*/ 180109 w 457200"/>
                  <a:gd name="connsiteY21" fmla="*/ 28032 h 450595"/>
                  <a:gd name="connsiteX22" fmla="*/ 96982 w 457200"/>
                  <a:gd name="connsiteY22" fmla="*/ 323 h 450595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</a:cxnLst>
                <a:rect l="l" t="t" r="r" b="b"/>
                <a:pathLst>
                  <a:path w="457200" h="450595">
                    <a:moveTo>
                      <a:pt x="96982" y="323"/>
                    </a:moveTo>
                    <a:cubicBezTo>
                      <a:pt x="77355" y="-1986"/>
                      <a:pt x="73467" y="8616"/>
                      <a:pt x="62345" y="14177"/>
                    </a:cubicBezTo>
                    <a:cubicBezTo>
                      <a:pt x="52221" y="19239"/>
                      <a:pt x="20124" y="44112"/>
                      <a:pt x="13855" y="48814"/>
                    </a:cubicBezTo>
                    <a:cubicBezTo>
                      <a:pt x="11546" y="71905"/>
                      <a:pt x="10456" y="95150"/>
                      <a:pt x="6927" y="118086"/>
                    </a:cubicBezTo>
                    <a:cubicBezTo>
                      <a:pt x="5817" y="125303"/>
                      <a:pt x="0" y="131566"/>
                      <a:pt x="0" y="138868"/>
                    </a:cubicBezTo>
                    <a:cubicBezTo>
                      <a:pt x="0" y="205871"/>
                      <a:pt x="673" y="273048"/>
                      <a:pt x="6927" y="339759"/>
                    </a:cubicBezTo>
                    <a:cubicBezTo>
                      <a:pt x="7704" y="348048"/>
                      <a:pt x="15364" y="354220"/>
                      <a:pt x="20782" y="360541"/>
                    </a:cubicBezTo>
                    <a:cubicBezTo>
                      <a:pt x="29283" y="370458"/>
                      <a:pt x="38574" y="379749"/>
                      <a:pt x="48491" y="388250"/>
                    </a:cubicBezTo>
                    <a:cubicBezTo>
                      <a:pt x="59787" y="397933"/>
                      <a:pt x="95590" y="416647"/>
                      <a:pt x="103909" y="422886"/>
                    </a:cubicBezTo>
                    <a:cubicBezTo>
                      <a:pt x="146248" y="454640"/>
                      <a:pt x="99183" y="438567"/>
                      <a:pt x="159327" y="450595"/>
                    </a:cubicBezTo>
                    <a:cubicBezTo>
                      <a:pt x="194164" y="449080"/>
                      <a:pt x="328542" y="457856"/>
                      <a:pt x="381000" y="422886"/>
                    </a:cubicBezTo>
                    <a:lnTo>
                      <a:pt x="401782" y="409032"/>
                    </a:lnTo>
                    <a:cubicBezTo>
                      <a:pt x="413761" y="393060"/>
                      <a:pt x="436311" y="364974"/>
                      <a:pt x="443345" y="346686"/>
                    </a:cubicBezTo>
                    <a:cubicBezTo>
                      <a:pt x="450180" y="328914"/>
                      <a:pt x="457200" y="291268"/>
                      <a:pt x="457200" y="291268"/>
                    </a:cubicBezTo>
                    <a:cubicBezTo>
                      <a:pt x="451477" y="199690"/>
                      <a:pt x="456917" y="206867"/>
                      <a:pt x="443345" y="145795"/>
                    </a:cubicBezTo>
                    <a:cubicBezTo>
                      <a:pt x="441280" y="136501"/>
                      <a:pt x="439429" y="127118"/>
                      <a:pt x="436418" y="118086"/>
                    </a:cubicBezTo>
                    <a:cubicBezTo>
                      <a:pt x="432486" y="106289"/>
                      <a:pt x="429154" y="93995"/>
                      <a:pt x="422564" y="83450"/>
                    </a:cubicBezTo>
                    <a:cubicBezTo>
                      <a:pt x="417372" y="75142"/>
                      <a:pt x="408158" y="70106"/>
                      <a:pt x="401782" y="62668"/>
                    </a:cubicBezTo>
                    <a:cubicBezTo>
                      <a:pt x="388978" y="47730"/>
                      <a:pt x="377406" y="25636"/>
                      <a:pt x="360218" y="14177"/>
                    </a:cubicBezTo>
                    <a:cubicBezTo>
                      <a:pt x="354142" y="10127"/>
                      <a:pt x="346363" y="9559"/>
                      <a:pt x="339436" y="7250"/>
                    </a:cubicBezTo>
                    <a:lnTo>
                      <a:pt x="242455" y="21105"/>
                    </a:lnTo>
                    <a:cubicBezTo>
                      <a:pt x="221721" y="23809"/>
                      <a:pt x="200483" y="23330"/>
                      <a:pt x="180109" y="28032"/>
                    </a:cubicBezTo>
                    <a:cubicBezTo>
                      <a:pt x="84273" y="50147"/>
                      <a:pt x="116609" y="2632"/>
                      <a:pt x="96982" y="323"/>
                    </a:cubicBez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35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90" name="Freeform: Shape 89">
                <a:extLst>
                  <a:ext uri="{FF2B5EF4-FFF2-40B4-BE49-F238E27FC236}">
                    <a16:creationId xmlns:a16="http://schemas.microsoft.com/office/drawing/2014/main" id="{665306A1-A50C-49FE-919E-A80139DCA591}"/>
                  </a:ext>
                </a:extLst>
              </p:cNvPr>
              <p:cNvSpPr/>
              <p:nvPr/>
            </p:nvSpPr>
            <p:spPr>
              <a:xfrm>
                <a:off x="2357861" y="1885557"/>
                <a:ext cx="1075460" cy="971550"/>
              </a:xfrm>
              <a:custGeom>
                <a:avLst/>
                <a:gdLst>
                  <a:gd name="connsiteX0" fmla="*/ 318655 w 1433946"/>
                  <a:gd name="connsiteY0" fmla="*/ 138546 h 1295400"/>
                  <a:gd name="connsiteX1" fmla="*/ 284018 w 1433946"/>
                  <a:gd name="connsiteY1" fmla="*/ 152400 h 1295400"/>
                  <a:gd name="connsiteX2" fmla="*/ 242455 w 1433946"/>
                  <a:gd name="connsiteY2" fmla="*/ 180109 h 1295400"/>
                  <a:gd name="connsiteX3" fmla="*/ 228600 w 1433946"/>
                  <a:gd name="connsiteY3" fmla="*/ 207818 h 1295400"/>
                  <a:gd name="connsiteX4" fmla="*/ 180109 w 1433946"/>
                  <a:gd name="connsiteY4" fmla="*/ 256309 h 1295400"/>
                  <a:gd name="connsiteX5" fmla="*/ 166255 w 1433946"/>
                  <a:gd name="connsiteY5" fmla="*/ 277091 h 1295400"/>
                  <a:gd name="connsiteX6" fmla="*/ 124691 w 1433946"/>
                  <a:gd name="connsiteY6" fmla="*/ 290946 h 1295400"/>
                  <a:gd name="connsiteX7" fmla="*/ 55418 w 1433946"/>
                  <a:gd name="connsiteY7" fmla="*/ 353291 h 1295400"/>
                  <a:gd name="connsiteX8" fmla="*/ 20782 w 1433946"/>
                  <a:gd name="connsiteY8" fmla="*/ 429491 h 1295400"/>
                  <a:gd name="connsiteX9" fmla="*/ 13855 w 1433946"/>
                  <a:gd name="connsiteY9" fmla="*/ 450273 h 1295400"/>
                  <a:gd name="connsiteX10" fmla="*/ 0 w 1433946"/>
                  <a:gd name="connsiteY10" fmla="*/ 512618 h 1295400"/>
                  <a:gd name="connsiteX11" fmla="*/ 13855 w 1433946"/>
                  <a:gd name="connsiteY11" fmla="*/ 658091 h 1295400"/>
                  <a:gd name="connsiteX12" fmla="*/ 20782 w 1433946"/>
                  <a:gd name="connsiteY12" fmla="*/ 692728 h 1295400"/>
                  <a:gd name="connsiteX13" fmla="*/ 48491 w 1433946"/>
                  <a:gd name="connsiteY13" fmla="*/ 755073 h 1295400"/>
                  <a:gd name="connsiteX14" fmla="*/ 76200 w 1433946"/>
                  <a:gd name="connsiteY14" fmla="*/ 817418 h 1295400"/>
                  <a:gd name="connsiteX15" fmla="*/ 83127 w 1433946"/>
                  <a:gd name="connsiteY15" fmla="*/ 845128 h 1295400"/>
                  <a:gd name="connsiteX16" fmla="*/ 96982 w 1433946"/>
                  <a:gd name="connsiteY16" fmla="*/ 865909 h 1295400"/>
                  <a:gd name="connsiteX17" fmla="*/ 152400 w 1433946"/>
                  <a:gd name="connsiteY17" fmla="*/ 962891 h 1295400"/>
                  <a:gd name="connsiteX18" fmla="*/ 228600 w 1433946"/>
                  <a:gd name="connsiteY18" fmla="*/ 1046018 h 1295400"/>
                  <a:gd name="connsiteX19" fmla="*/ 242455 w 1433946"/>
                  <a:gd name="connsiteY19" fmla="*/ 1066800 h 1295400"/>
                  <a:gd name="connsiteX20" fmla="*/ 256309 w 1433946"/>
                  <a:gd name="connsiteY20" fmla="*/ 1101437 h 1295400"/>
                  <a:gd name="connsiteX21" fmla="*/ 332509 w 1433946"/>
                  <a:gd name="connsiteY21" fmla="*/ 1163782 h 1295400"/>
                  <a:gd name="connsiteX22" fmla="*/ 353291 w 1433946"/>
                  <a:gd name="connsiteY22" fmla="*/ 1184564 h 1295400"/>
                  <a:gd name="connsiteX23" fmla="*/ 394855 w 1433946"/>
                  <a:gd name="connsiteY23" fmla="*/ 1212273 h 1295400"/>
                  <a:gd name="connsiteX24" fmla="*/ 443346 w 1433946"/>
                  <a:gd name="connsiteY24" fmla="*/ 1233055 h 1295400"/>
                  <a:gd name="connsiteX25" fmla="*/ 505691 w 1433946"/>
                  <a:gd name="connsiteY25" fmla="*/ 1239982 h 1295400"/>
                  <a:gd name="connsiteX26" fmla="*/ 616527 w 1433946"/>
                  <a:gd name="connsiteY26" fmla="*/ 1281546 h 1295400"/>
                  <a:gd name="connsiteX27" fmla="*/ 671946 w 1433946"/>
                  <a:gd name="connsiteY27" fmla="*/ 1295400 h 1295400"/>
                  <a:gd name="connsiteX28" fmla="*/ 720436 w 1433946"/>
                  <a:gd name="connsiteY28" fmla="*/ 1281546 h 1295400"/>
                  <a:gd name="connsiteX29" fmla="*/ 741218 w 1433946"/>
                  <a:gd name="connsiteY29" fmla="*/ 1260764 h 1295400"/>
                  <a:gd name="connsiteX30" fmla="*/ 782782 w 1433946"/>
                  <a:gd name="connsiteY30" fmla="*/ 1246909 h 1295400"/>
                  <a:gd name="connsiteX31" fmla="*/ 845127 w 1433946"/>
                  <a:gd name="connsiteY31" fmla="*/ 1212273 h 1295400"/>
                  <a:gd name="connsiteX32" fmla="*/ 865909 w 1433946"/>
                  <a:gd name="connsiteY32" fmla="*/ 1191491 h 1295400"/>
                  <a:gd name="connsiteX33" fmla="*/ 886691 w 1433946"/>
                  <a:gd name="connsiteY33" fmla="*/ 1177637 h 1295400"/>
                  <a:gd name="connsiteX34" fmla="*/ 949036 w 1433946"/>
                  <a:gd name="connsiteY34" fmla="*/ 1115291 h 1295400"/>
                  <a:gd name="connsiteX35" fmla="*/ 1004455 w 1433946"/>
                  <a:gd name="connsiteY35" fmla="*/ 1046018 h 1295400"/>
                  <a:gd name="connsiteX36" fmla="*/ 1018309 w 1433946"/>
                  <a:gd name="connsiteY36" fmla="*/ 1018309 h 1295400"/>
                  <a:gd name="connsiteX37" fmla="*/ 1025236 w 1433946"/>
                  <a:gd name="connsiteY37" fmla="*/ 997528 h 1295400"/>
                  <a:gd name="connsiteX38" fmla="*/ 1066800 w 1433946"/>
                  <a:gd name="connsiteY38" fmla="*/ 976746 h 1295400"/>
                  <a:gd name="connsiteX39" fmla="*/ 1108364 w 1433946"/>
                  <a:gd name="connsiteY39" fmla="*/ 949037 h 1295400"/>
                  <a:gd name="connsiteX40" fmla="*/ 1149927 w 1433946"/>
                  <a:gd name="connsiteY40" fmla="*/ 907473 h 1295400"/>
                  <a:gd name="connsiteX41" fmla="*/ 1191491 w 1433946"/>
                  <a:gd name="connsiteY41" fmla="*/ 872837 h 1295400"/>
                  <a:gd name="connsiteX42" fmla="*/ 1205346 w 1433946"/>
                  <a:gd name="connsiteY42" fmla="*/ 831273 h 1295400"/>
                  <a:gd name="connsiteX43" fmla="*/ 1212273 w 1433946"/>
                  <a:gd name="connsiteY43" fmla="*/ 796637 h 1295400"/>
                  <a:gd name="connsiteX44" fmla="*/ 1239982 w 1433946"/>
                  <a:gd name="connsiteY44" fmla="*/ 755073 h 1295400"/>
                  <a:gd name="connsiteX45" fmla="*/ 1253836 w 1433946"/>
                  <a:gd name="connsiteY45" fmla="*/ 713509 h 1295400"/>
                  <a:gd name="connsiteX46" fmla="*/ 1288473 w 1433946"/>
                  <a:gd name="connsiteY46" fmla="*/ 671946 h 1295400"/>
                  <a:gd name="connsiteX47" fmla="*/ 1309255 w 1433946"/>
                  <a:gd name="connsiteY47" fmla="*/ 630382 h 1295400"/>
                  <a:gd name="connsiteX48" fmla="*/ 1330036 w 1433946"/>
                  <a:gd name="connsiteY48" fmla="*/ 609600 h 1295400"/>
                  <a:gd name="connsiteX49" fmla="*/ 1364673 w 1433946"/>
                  <a:gd name="connsiteY49" fmla="*/ 574964 h 1295400"/>
                  <a:gd name="connsiteX50" fmla="*/ 1378527 w 1433946"/>
                  <a:gd name="connsiteY50" fmla="*/ 554182 h 1295400"/>
                  <a:gd name="connsiteX51" fmla="*/ 1399309 w 1433946"/>
                  <a:gd name="connsiteY51" fmla="*/ 547255 h 1295400"/>
                  <a:gd name="connsiteX52" fmla="*/ 1433946 w 1433946"/>
                  <a:gd name="connsiteY52" fmla="*/ 505691 h 1295400"/>
                  <a:gd name="connsiteX53" fmla="*/ 1427018 w 1433946"/>
                  <a:gd name="connsiteY53" fmla="*/ 346364 h 1295400"/>
                  <a:gd name="connsiteX54" fmla="*/ 1406236 w 1433946"/>
                  <a:gd name="connsiteY54" fmla="*/ 325582 h 1295400"/>
                  <a:gd name="connsiteX55" fmla="*/ 1357746 w 1433946"/>
                  <a:gd name="connsiteY55" fmla="*/ 263237 h 1295400"/>
                  <a:gd name="connsiteX56" fmla="*/ 1350818 w 1433946"/>
                  <a:gd name="connsiteY56" fmla="*/ 242455 h 1295400"/>
                  <a:gd name="connsiteX57" fmla="*/ 1302327 w 1433946"/>
                  <a:gd name="connsiteY57" fmla="*/ 193964 h 1295400"/>
                  <a:gd name="connsiteX58" fmla="*/ 1246909 w 1433946"/>
                  <a:gd name="connsiteY58" fmla="*/ 187037 h 1295400"/>
                  <a:gd name="connsiteX59" fmla="*/ 1205346 w 1433946"/>
                  <a:gd name="connsiteY59" fmla="*/ 173182 h 1295400"/>
                  <a:gd name="connsiteX60" fmla="*/ 1156855 w 1433946"/>
                  <a:gd name="connsiteY60" fmla="*/ 152400 h 1295400"/>
                  <a:gd name="connsiteX61" fmla="*/ 1025236 w 1433946"/>
                  <a:gd name="connsiteY61" fmla="*/ 48491 h 1295400"/>
                  <a:gd name="connsiteX62" fmla="*/ 969818 w 1433946"/>
                  <a:gd name="connsiteY62" fmla="*/ 13855 h 1295400"/>
                  <a:gd name="connsiteX63" fmla="*/ 865909 w 1433946"/>
                  <a:gd name="connsiteY63" fmla="*/ 0 h 1295400"/>
                  <a:gd name="connsiteX64" fmla="*/ 803564 w 1433946"/>
                  <a:gd name="connsiteY64" fmla="*/ 6928 h 1295400"/>
                  <a:gd name="connsiteX65" fmla="*/ 630382 w 1433946"/>
                  <a:gd name="connsiteY65" fmla="*/ 20782 h 1295400"/>
                  <a:gd name="connsiteX66" fmla="*/ 609600 w 1433946"/>
                  <a:gd name="connsiteY66" fmla="*/ 34637 h 1295400"/>
                  <a:gd name="connsiteX67" fmla="*/ 574964 w 1433946"/>
                  <a:gd name="connsiteY67" fmla="*/ 55418 h 1295400"/>
                  <a:gd name="connsiteX68" fmla="*/ 547255 w 1433946"/>
                  <a:gd name="connsiteY68" fmla="*/ 62346 h 1295400"/>
                  <a:gd name="connsiteX69" fmla="*/ 471055 w 1433946"/>
                  <a:gd name="connsiteY69" fmla="*/ 76200 h 1295400"/>
                  <a:gd name="connsiteX70" fmla="*/ 429491 w 1433946"/>
                  <a:gd name="connsiteY70" fmla="*/ 96982 h 1295400"/>
                  <a:gd name="connsiteX71" fmla="*/ 374073 w 1433946"/>
                  <a:gd name="connsiteY71" fmla="*/ 124691 h 1295400"/>
                  <a:gd name="connsiteX72" fmla="*/ 318655 w 1433946"/>
                  <a:gd name="connsiteY72" fmla="*/ 138546 h 1295400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  <a:cxn ang="0">
                    <a:pos x="connsiteX55" y="connsiteY55"/>
                  </a:cxn>
                  <a:cxn ang="0">
                    <a:pos x="connsiteX56" y="connsiteY56"/>
                  </a:cxn>
                  <a:cxn ang="0">
                    <a:pos x="connsiteX57" y="connsiteY57"/>
                  </a:cxn>
                  <a:cxn ang="0">
                    <a:pos x="connsiteX58" y="connsiteY58"/>
                  </a:cxn>
                  <a:cxn ang="0">
                    <a:pos x="connsiteX59" y="connsiteY59"/>
                  </a:cxn>
                  <a:cxn ang="0">
                    <a:pos x="connsiteX60" y="connsiteY60"/>
                  </a:cxn>
                  <a:cxn ang="0">
                    <a:pos x="connsiteX61" y="connsiteY61"/>
                  </a:cxn>
                  <a:cxn ang="0">
                    <a:pos x="connsiteX62" y="connsiteY62"/>
                  </a:cxn>
                  <a:cxn ang="0">
                    <a:pos x="connsiteX63" y="connsiteY63"/>
                  </a:cxn>
                  <a:cxn ang="0">
                    <a:pos x="connsiteX64" y="connsiteY64"/>
                  </a:cxn>
                  <a:cxn ang="0">
                    <a:pos x="connsiteX65" y="connsiteY65"/>
                  </a:cxn>
                  <a:cxn ang="0">
                    <a:pos x="connsiteX66" y="connsiteY66"/>
                  </a:cxn>
                  <a:cxn ang="0">
                    <a:pos x="connsiteX67" y="connsiteY67"/>
                  </a:cxn>
                  <a:cxn ang="0">
                    <a:pos x="connsiteX68" y="connsiteY68"/>
                  </a:cxn>
                  <a:cxn ang="0">
                    <a:pos x="connsiteX69" y="connsiteY69"/>
                  </a:cxn>
                  <a:cxn ang="0">
                    <a:pos x="connsiteX70" y="connsiteY70"/>
                  </a:cxn>
                  <a:cxn ang="0">
                    <a:pos x="connsiteX71" y="connsiteY71"/>
                  </a:cxn>
                  <a:cxn ang="0">
                    <a:pos x="connsiteX72" y="connsiteY72"/>
                  </a:cxn>
                </a:cxnLst>
                <a:rect l="l" t="t" r="r" b="b"/>
                <a:pathLst>
                  <a:path w="1433946" h="1295400">
                    <a:moveTo>
                      <a:pt x="318655" y="138546"/>
                    </a:moveTo>
                    <a:cubicBezTo>
                      <a:pt x="303646" y="143164"/>
                      <a:pt x="294935" y="146446"/>
                      <a:pt x="284018" y="152400"/>
                    </a:cubicBezTo>
                    <a:cubicBezTo>
                      <a:pt x="269400" y="160373"/>
                      <a:pt x="242455" y="180109"/>
                      <a:pt x="242455" y="180109"/>
                    </a:cubicBezTo>
                    <a:cubicBezTo>
                      <a:pt x="237837" y="189345"/>
                      <a:pt x="235139" y="199826"/>
                      <a:pt x="228600" y="207818"/>
                    </a:cubicBezTo>
                    <a:cubicBezTo>
                      <a:pt x="214125" y="225510"/>
                      <a:pt x="192788" y="237289"/>
                      <a:pt x="180109" y="256309"/>
                    </a:cubicBezTo>
                    <a:cubicBezTo>
                      <a:pt x="175491" y="263236"/>
                      <a:pt x="173315" y="272678"/>
                      <a:pt x="166255" y="277091"/>
                    </a:cubicBezTo>
                    <a:cubicBezTo>
                      <a:pt x="153871" y="284831"/>
                      <a:pt x="124691" y="290946"/>
                      <a:pt x="124691" y="290946"/>
                    </a:cubicBezTo>
                    <a:cubicBezTo>
                      <a:pt x="99992" y="310705"/>
                      <a:pt x="75456" y="328243"/>
                      <a:pt x="55418" y="353291"/>
                    </a:cubicBezTo>
                    <a:cubicBezTo>
                      <a:pt x="33860" y="380238"/>
                      <a:pt x="31586" y="397077"/>
                      <a:pt x="20782" y="429491"/>
                    </a:cubicBezTo>
                    <a:cubicBezTo>
                      <a:pt x="18473" y="436418"/>
                      <a:pt x="15056" y="443070"/>
                      <a:pt x="13855" y="450273"/>
                    </a:cubicBezTo>
                    <a:cubicBezTo>
                      <a:pt x="5726" y="499039"/>
                      <a:pt x="11369" y="478512"/>
                      <a:pt x="0" y="512618"/>
                    </a:cubicBezTo>
                    <a:cubicBezTo>
                      <a:pt x="5236" y="585923"/>
                      <a:pt x="3781" y="597649"/>
                      <a:pt x="13855" y="658091"/>
                    </a:cubicBezTo>
                    <a:cubicBezTo>
                      <a:pt x="15791" y="669705"/>
                      <a:pt x="17399" y="681450"/>
                      <a:pt x="20782" y="692728"/>
                    </a:cubicBezTo>
                    <a:cubicBezTo>
                      <a:pt x="27416" y="714843"/>
                      <a:pt x="38256" y="734603"/>
                      <a:pt x="48491" y="755073"/>
                    </a:cubicBezTo>
                    <a:cubicBezTo>
                      <a:pt x="63993" y="832585"/>
                      <a:pt x="42165" y="749347"/>
                      <a:pt x="76200" y="817418"/>
                    </a:cubicBezTo>
                    <a:cubicBezTo>
                      <a:pt x="80458" y="825934"/>
                      <a:pt x="79377" y="836377"/>
                      <a:pt x="83127" y="845128"/>
                    </a:cubicBezTo>
                    <a:cubicBezTo>
                      <a:pt x="86407" y="852780"/>
                      <a:pt x="92851" y="858681"/>
                      <a:pt x="96982" y="865909"/>
                    </a:cubicBezTo>
                    <a:cubicBezTo>
                      <a:pt x="115535" y="898376"/>
                      <a:pt x="124672" y="935163"/>
                      <a:pt x="152400" y="962891"/>
                    </a:cubicBezTo>
                    <a:cubicBezTo>
                      <a:pt x="202234" y="1012725"/>
                      <a:pt x="198219" y="1003485"/>
                      <a:pt x="228600" y="1046018"/>
                    </a:cubicBezTo>
                    <a:cubicBezTo>
                      <a:pt x="233439" y="1052793"/>
                      <a:pt x="238732" y="1059353"/>
                      <a:pt x="242455" y="1066800"/>
                    </a:cubicBezTo>
                    <a:cubicBezTo>
                      <a:pt x="248016" y="1077922"/>
                      <a:pt x="248727" y="1091581"/>
                      <a:pt x="256309" y="1101437"/>
                    </a:cubicBezTo>
                    <a:cubicBezTo>
                      <a:pt x="298089" y="1155751"/>
                      <a:pt x="292198" y="1150346"/>
                      <a:pt x="332509" y="1163782"/>
                    </a:cubicBezTo>
                    <a:cubicBezTo>
                      <a:pt x="339436" y="1170709"/>
                      <a:pt x="345558" y="1178549"/>
                      <a:pt x="353291" y="1184564"/>
                    </a:cubicBezTo>
                    <a:cubicBezTo>
                      <a:pt x="366435" y="1194787"/>
                      <a:pt x="381000" y="1203036"/>
                      <a:pt x="394855" y="1212273"/>
                    </a:cubicBezTo>
                    <a:cubicBezTo>
                      <a:pt x="417693" y="1227499"/>
                      <a:pt x="414266" y="1228581"/>
                      <a:pt x="443346" y="1233055"/>
                    </a:cubicBezTo>
                    <a:cubicBezTo>
                      <a:pt x="464012" y="1236234"/>
                      <a:pt x="484909" y="1237673"/>
                      <a:pt x="505691" y="1239982"/>
                    </a:cubicBezTo>
                    <a:cubicBezTo>
                      <a:pt x="535672" y="1251974"/>
                      <a:pt x="582406" y="1272240"/>
                      <a:pt x="616527" y="1281546"/>
                    </a:cubicBezTo>
                    <a:cubicBezTo>
                      <a:pt x="708506" y="1306631"/>
                      <a:pt x="608873" y="1274377"/>
                      <a:pt x="671946" y="1295400"/>
                    </a:cubicBezTo>
                    <a:cubicBezTo>
                      <a:pt x="688109" y="1290782"/>
                      <a:pt x="705401" y="1289064"/>
                      <a:pt x="720436" y="1281546"/>
                    </a:cubicBezTo>
                    <a:cubicBezTo>
                      <a:pt x="729198" y="1277165"/>
                      <a:pt x="732654" y="1265522"/>
                      <a:pt x="741218" y="1260764"/>
                    </a:cubicBezTo>
                    <a:cubicBezTo>
                      <a:pt x="753984" y="1253672"/>
                      <a:pt x="782782" y="1246909"/>
                      <a:pt x="782782" y="1246909"/>
                    </a:cubicBezTo>
                    <a:cubicBezTo>
                      <a:pt x="896262" y="1161802"/>
                      <a:pt x="718107" y="1291662"/>
                      <a:pt x="845127" y="1212273"/>
                    </a:cubicBezTo>
                    <a:cubicBezTo>
                      <a:pt x="853435" y="1207081"/>
                      <a:pt x="858383" y="1197763"/>
                      <a:pt x="865909" y="1191491"/>
                    </a:cubicBezTo>
                    <a:cubicBezTo>
                      <a:pt x="872305" y="1186161"/>
                      <a:pt x="880554" y="1183263"/>
                      <a:pt x="886691" y="1177637"/>
                    </a:cubicBezTo>
                    <a:cubicBezTo>
                      <a:pt x="908356" y="1157777"/>
                      <a:pt x="935892" y="1141578"/>
                      <a:pt x="949036" y="1115291"/>
                    </a:cubicBezTo>
                    <a:cubicBezTo>
                      <a:pt x="971654" y="1070057"/>
                      <a:pt x="955589" y="1094884"/>
                      <a:pt x="1004455" y="1046018"/>
                    </a:cubicBezTo>
                    <a:cubicBezTo>
                      <a:pt x="1009073" y="1036782"/>
                      <a:pt x="1014241" y="1027801"/>
                      <a:pt x="1018309" y="1018309"/>
                    </a:cubicBezTo>
                    <a:cubicBezTo>
                      <a:pt x="1021185" y="1011598"/>
                      <a:pt x="1019692" y="1002280"/>
                      <a:pt x="1025236" y="997528"/>
                    </a:cubicBezTo>
                    <a:cubicBezTo>
                      <a:pt x="1036997" y="987447"/>
                      <a:pt x="1053912" y="985338"/>
                      <a:pt x="1066800" y="976746"/>
                    </a:cubicBezTo>
                    <a:cubicBezTo>
                      <a:pt x="1118689" y="942153"/>
                      <a:pt x="1058950" y="965507"/>
                      <a:pt x="1108364" y="949037"/>
                    </a:cubicBezTo>
                    <a:cubicBezTo>
                      <a:pt x="1132752" y="912453"/>
                      <a:pt x="1109830" y="941842"/>
                      <a:pt x="1149927" y="907473"/>
                    </a:cubicBezTo>
                    <a:cubicBezTo>
                      <a:pt x="1196593" y="867473"/>
                      <a:pt x="1145564" y="903454"/>
                      <a:pt x="1191491" y="872837"/>
                    </a:cubicBezTo>
                    <a:cubicBezTo>
                      <a:pt x="1196109" y="858982"/>
                      <a:pt x="1201503" y="845363"/>
                      <a:pt x="1205346" y="831273"/>
                    </a:cubicBezTo>
                    <a:cubicBezTo>
                      <a:pt x="1208444" y="819914"/>
                      <a:pt x="1207401" y="807356"/>
                      <a:pt x="1212273" y="796637"/>
                    </a:cubicBezTo>
                    <a:cubicBezTo>
                      <a:pt x="1219163" y="781478"/>
                      <a:pt x="1239982" y="755073"/>
                      <a:pt x="1239982" y="755073"/>
                    </a:cubicBezTo>
                    <a:cubicBezTo>
                      <a:pt x="1244600" y="741218"/>
                      <a:pt x="1247905" y="726854"/>
                      <a:pt x="1253836" y="713509"/>
                    </a:cubicBezTo>
                    <a:cubicBezTo>
                      <a:pt x="1261550" y="696152"/>
                      <a:pt x="1275425" y="684994"/>
                      <a:pt x="1288473" y="671946"/>
                    </a:cubicBezTo>
                    <a:cubicBezTo>
                      <a:pt x="1295416" y="651116"/>
                      <a:pt x="1294333" y="648289"/>
                      <a:pt x="1309255" y="630382"/>
                    </a:cubicBezTo>
                    <a:cubicBezTo>
                      <a:pt x="1315526" y="622856"/>
                      <a:pt x="1323765" y="617126"/>
                      <a:pt x="1330036" y="609600"/>
                    </a:cubicBezTo>
                    <a:cubicBezTo>
                      <a:pt x="1358897" y="574966"/>
                      <a:pt x="1326576" y="600361"/>
                      <a:pt x="1364673" y="574964"/>
                    </a:cubicBezTo>
                    <a:cubicBezTo>
                      <a:pt x="1369291" y="568037"/>
                      <a:pt x="1372026" y="559383"/>
                      <a:pt x="1378527" y="554182"/>
                    </a:cubicBezTo>
                    <a:cubicBezTo>
                      <a:pt x="1384229" y="549620"/>
                      <a:pt x="1394146" y="552418"/>
                      <a:pt x="1399309" y="547255"/>
                    </a:cubicBezTo>
                    <a:cubicBezTo>
                      <a:pt x="1469628" y="476938"/>
                      <a:pt x="1362051" y="553622"/>
                      <a:pt x="1433946" y="505691"/>
                    </a:cubicBezTo>
                    <a:cubicBezTo>
                      <a:pt x="1431637" y="452582"/>
                      <a:pt x="1435101" y="398905"/>
                      <a:pt x="1427018" y="346364"/>
                    </a:cubicBezTo>
                    <a:cubicBezTo>
                      <a:pt x="1425528" y="336681"/>
                      <a:pt x="1412114" y="333419"/>
                      <a:pt x="1406236" y="325582"/>
                    </a:cubicBezTo>
                    <a:cubicBezTo>
                      <a:pt x="1351232" y="252243"/>
                      <a:pt x="1421657" y="327148"/>
                      <a:pt x="1357746" y="263237"/>
                    </a:cubicBezTo>
                    <a:cubicBezTo>
                      <a:pt x="1355437" y="256310"/>
                      <a:pt x="1354441" y="248795"/>
                      <a:pt x="1350818" y="242455"/>
                    </a:cubicBezTo>
                    <a:cubicBezTo>
                      <a:pt x="1342125" y="227243"/>
                      <a:pt x="1320256" y="199940"/>
                      <a:pt x="1302327" y="193964"/>
                    </a:cubicBezTo>
                    <a:cubicBezTo>
                      <a:pt x="1284666" y="188077"/>
                      <a:pt x="1265382" y="189346"/>
                      <a:pt x="1246909" y="187037"/>
                    </a:cubicBezTo>
                    <a:cubicBezTo>
                      <a:pt x="1233055" y="182419"/>
                      <a:pt x="1218905" y="178606"/>
                      <a:pt x="1205346" y="173182"/>
                    </a:cubicBezTo>
                    <a:cubicBezTo>
                      <a:pt x="1119721" y="138932"/>
                      <a:pt x="1223765" y="174707"/>
                      <a:pt x="1156855" y="152400"/>
                    </a:cubicBezTo>
                    <a:cubicBezTo>
                      <a:pt x="1099638" y="102336"/>
                      <a:pt x="1093345" y="93897"/>
                      <a:pt x="1025236" y="48491"/>
                    </a:cubicBezTo>
                    <a:cubicBezTo>
                      <a:pt x="1012624" y="40083"/>
                      <a:pt x="980263" y="18033"/>
                      <a:pt x="969818" y="13855"/>
                    </a:cubicBezTo>
                    <a:cubicBezTo>
                      <a:pt x="950690" y="6204"/>
                      <a:pt x="871482" y="557"/>
                      <a:pt x="865909" y="0"/>
                    </a:cubicBezTo>
                    <a:cubicBezTo>
                      <a:pt x="845127" y="2309"/>
                      <a:pt x="824393" y="5090"/>
                      <a:pt x="803564" y="6928"/>
                    </a:cubicBezTo>
                    <a:cubicBezTo>
                      <a:pt x="745876" y="12018"/>
                      <a:pt x="687712" y="12592"/>
                      <a:pt x="630382" y="20782"/>
                    </a:cubicBezTo>
                    <a:cubicBezTo>
                      <a:pt x="622140" y="21959"/>
                      <a:pt x="616660" y="30224"/>
                      <a:pt x="609600" y="34637"/>
                    </a:cubicBezTo>
                    <a:cubicBezTo>
                      <a:pt x="598183" y="41773"/>
                      <a:pt x="587268" y="49950"/>
                      <a:pt x="574964" y="55418"/>
                    </a:cubicBezTo>
                    <a:cubicBezTo>
                      <a:pt x="566264" y="59285"/>
                      <a:pt x="556591" y="60479"/>
                      <a:pt x="547255" y="62346"/>
                    </a:cubicBezTo>
                    <a:cubicBezTo>
                      <a:pt x="521940" y="67409"/>
                      <a:pt x="496455" y="71582"/>
                      <a:pt x="471055" y="76200"/>
                    </a:cubicBezTo>
                    <a:cubicBezTo>
                      <a:pt x="425511" y="106563"/>
                      <a:pt x="474560" y="76496"/>
                      <a:pt x="429491" y="96982"/>
                    </a:cubicBezTo>
                    <a:cubicBezTo>
                      <a:pt x="410689" y="105528"/>
                      <a:pt x="394325" y="120641"/>
                      <a:pt x="374073" y="124691"/>
                    </a:cubicBezTo>
                    <a:cubicBezTo>
                      <a:pt x="334373" y="132631"/>
                      <a:pt x="333664" y="133928"/>
                      <a:pt x="318655" y="138546"/>
                    </a:cubicBez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35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91" name="TextBox 90">
                <a:extLst>
                  <a:ext uri="{FF2B5EF4-FFF2-40B4-BE49-F238E27FC236}">
                    <a16:creationId xmlns:a16="http://schemas.microsoft.com/office/drawing/2014/main" id="{1FAF29D3-96AE-4478-AB52-6DBB3B563796}"/>
                  </a:ext>
                </a:extLst>
              </p:cNvPr>
              <p:cNvSpPr txBox="1"/>
              <p:nvPr/>
            </p:nvSpPr>
            <p:spPr>
              <a:xfrm>
                <a:off x="2397591" y="735206"/>
                <a:ext cx="221877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CA3FAE4D-1B6D-4131-B51F-1B56E2ACC064}"/>
                  </a:ext>
                </a:extLst>
              </p:cNvPr>
              <p:cNvSpPr txBox="1"/>
              <p:nvPr/>
            </p:nvSpPr>
            <p:spPr>
              <a:xfrm>
                <a:off x="2685381" y="2203189"/>
                <a:ext cx="221877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</a:p>
            </p:txBody>
          </p:sp>
          <p:pic>
            <p:nvPicPr>
              <p:cNvPr id="93" name="Picture 92">
                <a:extLst>
                  <a:ext uri="{FF2B5EF4-FFF2-40B4-BE49-F238E27FC236}">
                    <a16:creationId xmlns:a16="http://schemas.microsoft.com/office/drawing/2014/main" id="{E218A199-344C-4DFB-95B2-23F8203602C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9"/>
              <a:srcRect l="12050"/>
              <a:stretch/>
            </p:blipFill>
            <p:spPr>
              <a:xfrm>
                <a:off x="3789245" y="494150"/>
                <a:ext cx="1660873" cy="1320456"/>
              </a:xfrm>
              <a:prstGeom prst="rect">
                <a:avLst/>
              </a:prstGeom>
            </p:spPr>
          </p:pic>
          <p:pic>
            <p:nvPicPr>
              <p:cNvPr id="94" name="Picture 93">
                <a:extLst>
                  <a:ext uri="{FF2B5EF4-FFF2-40B4-BE49-F238E27FC236}">
                    <a16:creationId xmlns:a16="http://schemas.microsoft.com/office/drawing/2014/main" id="{36FDDB4D-CC69-461B-BB41-360C57F1C64A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10"/>
              <a:srcRect l="11148" t="507" r="16342" b="-507"/>
              <a:stretch/>
            </p:blipFill>
            <p:spPr>
              <a:xfrm>
                <a:off x="3789245" y="1848534"/>
                <a:ext cx="1660874" cy="1326872"/>
              </a:xfrm>
              <a:prstGeom prst="rect">
                <a:avLst/>
              </a:prstGeom>
            </p:spPr>
          </p:pic>
          <p:sp>
            <p:nvSpPr>
              <p:cNvPr id="95" name="Freeform: Shape 94">
                <a:extLst>
                  <a:ext uri="{FF2B5EF4-FFF2-40B4-BE49-F238E27FC236}">
                    <a16:creationId xmlns:a16="http://schemas.microsoft.com/office/drawing/2014/main" id="{429329FD-6439-4790-9459-AF9B32251EE5}"/>
                  </a:ext>
                </a:extLst>
              </p:cNvPr>
              <p:cNvSpPr/>
              <p:nvPr/>
            </p:nvSpPr>
            <p:spPr>
              <a:xfrm>
                <a:off x="4342092" y="660143"/>
                <a:ext cx="371043" cy="348682"/>
              </a:xfrm>
              <a:custGeom>
                <a:avLst/>
                <a:gdLst>
                  <a:gd name="connsiteX0" fmla="*/ 190500 w 494724"/>
                  <a:gd name="connsiteY0" fmla="*/ 1359 h 464909"/>
                  <a:gd name="connsiteX1" fmla="*/ 133350 w 494724"/>
                  <a:gd name="connsiteY1" fmla="*/ 33109 h 464909"/>
                  <a:gd name="connsiteX2" fmla="*/ 101600 w 494724"/>
                  <a:gd name="connsiteY2" fmla="*/ 39459 h 464909"/>
                  <a:gd name="connsiteX3" fmla="*/ 63500 w 494724"/>
                  <a:gd name="connsiteY3" fmla="*/ 64859 h 464909"/>
                  <a:gd name="connsiteX4" fmla="*/ 25400 w 494724"/>
                  <a:gd name="connsiteY4" fmla="*/ 102959 h 464909"/>
                  <a:gd name="connsiteX5" fmla="*/ 19050 w 494724"/>
                  <a:gd name="connsiteY5" fmla="*/ 128359 h 464909"/>
                  <a:gd name="connsiteX6" fmla="*/ 6350 w 494724"/>
                  <a:gd name="connsiteY6" fmla="*/ 147409 h 464909"/>
                  <a:gd name="connsiteX7" fmla="*/ 0 w 494724"/>
                  <a:gd name="connsiteY7" fmla="*/ 179159 h 464909"/>
                  <a:gd name="connsiteX8" fmla="*/ 6350 w 494724"/>
                  <a:gd name="connsiteY8" fmla="*/ 363309 h 464909"/>
                  <a:gd name="connsiteX9" fmla="*/ 25400 w 494724"/>
                  <a:gd name="connsiteY9" fmla="*/ 388709 h 464909"/>
                  <a:gd name="connsiteX10" fmla="*/ 88900 w 494724"/>
                  <a:gd name="connsiteY10" fmla="*/ 407759 h 464909"/>
                  <a:gd name="connsiteX11" fmla="*/ 133350 w 494724"/>
                  <a:gd name="connsiteY11" fmla="*/ 426809 h 464909"/>
                  <a:gd name="connsiteX12" fmla="*/ 152400 w 494724"/>
                  <a:gd name="connsiteY12" fmla="*/ 439509 h 464909"/>
                  <a:gd name="connsiteX13" fmla="*/ 196850 w 494724"/>
                  <a:gd name="connsiteY13" fmla="*/ 445859 h 464909"/>
                  <a:gd name="connsiteX14" fmla="*/ 260350 w 494724"/>
                  <a:gd name="connsiteY14" fmla="*/ 464909 h 464909"/>
                  <a:gd name="connsiteX15" fmla="*/ 361950 w 494724"/>
                  <a:gd name="connsiteY15" fmla="*/ 420459 h 464909"/>
                  <a:gd name="connsiteX16" fmla="*/ 393700 w 494724"/>
                  <a:gd name="connsiteY16" fmla="*/ 407759 h 464909"/>
                  <a:gd name="connsiteX17" fmla="*/ 412750 w 494724"/>
                  <a:gd name="connsiteY17" fmla="*/ 401409 h 464909"/>
                  <a:gd name="connsiteX18" fmla="*/ 450850 w 494724"/>
                  <a:gd name="connsiteY18" fmla="*/ 376009 h 464909"/>
                  <a:gd name="connsiteX19" fmla="*/ 457200 w 494724"/>
                  <a:gd name="connsiteY19" fmla="*/ 356959 h 464909"/>
                  <a:gd name="connsiteX20" fmla="*/ 482600 w 494724"/>
                  <a:gd name="connsiteY20" fmla="*/ 331559 h 464909"/>
                  <a:gd name="connsiteX21" fmla="*/ 488950 w 494724"/>
                  <a:gd name="connsiteY21" fmla="*/ 299809 h 464909"/>
                  <a:gd name="connsiteX22" fmla="*/ 457200 w 494724"/>
                  <a:gd name="connsiteY22" fmla="*/ 90259 h 464909"/>
                  <a:gd name="connsiteX23" fmla="*/ 438150 w 494724"/>
                  <a:gd name="connsiteY23" fmla="*/ 71209 h 464909"/>
                  <a:gd name="connsiteX24" fmla="*/ 406400 w 494724"/>
                  <a:gd name="connsiteY24" fmla="*/ 64859 h 464909"/>
                  <a:gd name="connsiteX25" fmla="*/ 387350 w 494724"/>
                  <a:gd name="connsiteY25" fmla="*/ 52159 h 464909"/>
                  <a:gd name="connsiteX26" fmla="*/ 361950 w 494724"/>
                  <a:gd name="connsiteY26" fmla="*/ 45809 h 464909"/>
                  <a:gd name="connsiteX27" fmla="*/ 342900 w 494724"/>
                  <a:gd name="connsiteY27" fmla="*/ 39459 h 464909"/>
                  <a:gd name="connsiteX28" fmla="*/ 311150 w 494724"/>
                  <a:gd name="connsiteY28" fmla="*/ 33109 h 464909"/>
                  <a:gd name="connsiteX29" fmla="*/ 292100 w 494724"/>
                  <a:gd name="connsiteY29" fmla="*/ 26759 h 464909"/>
                  <a:gd name="connsiteX30" fmla="*/ 266700 w 494724"/>
                  <a:gd name="connsiteY30" fmla="*/ 20409 h 464909"/>
                  <a:gd name="connsiteX31" fmla="*/ 241300 w 494724"/>
                  <a:gd name="connsiteY31" fmla="*/ 7709 h 464909"/>
                  <a:gd name="connsiteX32" fmla="*/ 190500 w 494724"/>
                  <a:gd name="connsiteY32" fmla="*/ 1359 h 464909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</a:cxnLst>
                <a:rect l="l" t="t" r="r" b="b"/>
                <a:pathLst>
                  <a:path w="494724" h="464909">
                    <a:moveTo>
                      <a:pt x="190500" y="1359"/>
                    </a:moveTo>
                    <a:cubicBezTo>
                      <a:pt x="172508" y="5592"/>
                      <a:pt x="147015" y="28554"/>
                      <a:pt x="133350" y="33109"/>
                    </a:cubicBezTo>
                    <a:cubicBezTo>
                      <a:pt x="123111" y="36522"/>
                      <a:pt x="112183" y="37342"/>
                      <a:pt x="101600" y="39459"/>
                    </a:cubicBezTo>
                    <a:cubicBezTo>
                      <a:pt x="88900" y="47926"/>
                      <a:pt x="71967" y="52159"/>
                      <a:pt x="63500" y="64859"/>
                    </a:cubicBezTo>
                    <a:cubicBezTo>
                      <a:pt x="44929" y="92715"/>
                      <a:pt x="56905" y="79330"/>
                      <a:pt x="25400" y="102959"/>
                    </a:cubicBezTo>
                    <a:cubicBezTo>
                      <a:pt x="23283" y="111426"/>
                      <a:pt x="22488" y="120337"/>
                      <a:pt x="19050" y="128359"/>
                    </a:cubicBezTo>
                    <a:cubicBezTo>
                      <a:pt x="16044" y="135374"/>
                      <a:pt x="9030" y="140263"/>
                      <a:pt x="6350" y="147409"/>
                    </a:cubicBezTo>
                    <a:cubicBezTo>
                      <a:pt x="2560" y="157515"/>
                      <a:pt x="2117" y="168576"/>
                      <a:pt x="0" y="179159"/>
                    </a:cubicBezTo>
                    <a:cubicBezTo>
                      <a:pt x="2117" y="240542"/>
                      <a:pt x="-1041" y="302335"/>
                      <a:pt x="6350" y="363309"/>
                    </a:cubicBezTo>
                    <a:cubicBezTo>
                      <a:pt x="7624" y="373815"/>
                      <a:pt x="16594" y="382838"/>
                      <a:pt x="25400" y="388709"/>
                    </a:cubicBezTo>
                    <a:cubicBezTo>
                      <a:pt x="34676" y="394893"/>
                      <a:pt x="74701" y="404209"/>
                      <a:pt x="88900" y="407759"/>
                    </a:cubicBezTo>
                    <a:cubicBezTo>
                      <a:pt x="136726" y="439643"/>
                      <a:pt x="75943" y="402206"/>
                      <a:pt x="133350" y="426809"/>
                    </a:cubicBezTo>
                    <a:cubicBezTo>
                      <a:pt x="140365" y="429815"/>
                      <a:pt x="145090" y="437316"/>
                      <a:pt x="152400" y="439509"/>
                    </a:cubicBezTo>
                    <a:cubicBezTo>
                      <a:pt x="166736" y="443810"/>
                      <a:pt x="182087" y="443398"/>
                      <a:pt x="196850" y="445859"/>
                    </a:cubicBezTo>
                    <a:cubicBezTo>
                      <a:pt x="233645" y="451991"/>
                      <a:pt x="225056" y="450791"/>
                      <a:pt x="260350" y="464909"/>
                    </a:cubicBezTo>
                    <a:cubicBezTo>
                      <a:pt x="415291" y="402933"/>
                      <a:pt x="254718" y="469201"/>
                      <a:pt x="361950" y="420459"/>
                    </a:cubicBezTo>
                    <a:cubicBezTo>
                      <a:pt x="372327" y="415742"/>
                      <a:pt x="383027" y="411761"/>
                      <a:pt x="393700" y="407759"/>
                    </a:cubicBezTo>
                    <a:cubicBezTo>
                      <a:pt x="399967" y="405409"/>
                      <a:pt x="406899" y="404660"/>
                      <a:pt x="412750" y="401409"/>
                    </a:cubicBezTo>
                    <a:cubicBezTo>
                      <a:pt x="426093" y="393996"/>
                      <a:pt x="438150" y="384476"/>
                      <a:pt x="450850" y="376009"/>
                    </a:cubicBezTo>
                    <a:cubicBezTo>
                      <a:pt x="452967" y="369659"/>
                      <a:pt x="453309" y="362406"/>
                      <a:pt x="457200" y="356959"/>
                    </a:cubicBezTo>
                    <a:cubicBezTo>
                      <a:pt x="464160" y="347216"/>
                      <a:pt x="476785" y="342026"/>
                      <a:pt x="482600" y="331559"/>
                    </a:cubicBezTo>
                    <a:cubicBezTo>
                      <a:pt x="487842" y="322124"/>
                      <a:pt x="486833" y="310392"/>
                      <a:pt x="488950" y="299809"/>
                    </a:cubicBezTo>
                    <a:cubicBezTo>
                      <a:pt x="468537" y="-16591"/>
                      <a:pt x="531798" y="152424"/>
                      <a:pt x="457200" y="90259"/>
                    </a:cubicBezTo>
                    <a:cubicBezTo>
                      <a:pt x="450301" y="84510"/>
                      <a:pt x="446182" y="75225"/>
                      <a:pt x="438150" y="71209"/>
                    </a:cubicBezTo>
                    <a:cubicBezTo>
                      <a:pt x="428497" y="66382"/>
                      <a:pt x="416983" y="66976"/>
                      <a:pt x="406400" y="64859"/>
                    </a:cubicBezTo>
                    <a:cubicBezTo>
                      <a:pt x="400050" y="60626"/>
                      <a:pt x="394365" y="55165"/>
                      <a:pt x="387350" y="52159"/>
                    </a:cubicBezTo>
                    <a:cubicBezTo>
                      <a:pt x="379328" y="48721"/>
                      <a:pt x="370341" y="48207"/>
                      <a:pt x="361950" y="45809"/>
                    </a:cubicBezTo>
                    <a:cubicBezTo>
                      <a:pt x="355514" y="43970"/>
                      <a:pt x="349394" y="41082"/>
                      <a:pt x="342900" y="39459"/>
                    </a:cubicBezTo>
                    <a:cubicBezTo>
                      <a:pt x="332429" y="36841"/>
                      <a:pt x="321621" y="35727"/>
                      <a:pt x="311150" y="33109"/>
                    </a:cubicBezTo>
                    <a:cubicBezTo>
                      <a:pt x="304656" y="31486"/>
                      <a:pt x="298536" y="28598"/>
                      <a:pt x="292100" y="26759"/>
                    </a:cubicBezTo>
                    <a:cubicBezTo>
                      <a:pt x="283709" y="24361"/>
                      <a:pt x="274872" y="23473"/>
                      <a:pt x="266700" y="20409"/>
                    </a:cubicBezTo>
                    <a:cubicBezTo>
                      <a:pt x="257837" y="17085"/>
                      <a:pt x="250432" y="10200"/>
                      <a:pt x="241300" y="7709"/>
                    </a:cubicBezTo>
                    <a:cubicBezTo>
                      <a:pt x="226860" y="3771"/>
                      <a:pt x="208492" y="-2874"/>
                      <a:pt x="190500" y="1359"/>
                    </a:cubicBez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35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96" name="Freeform: Shape 95">
                <a:extLst>
                  <a:ext uri="{FF2B5EF4-FFF2-40B4-BE49-F238E27FC236}">
                    <a16:creationId xmlns:a16="http://schemas.microsoft.com/office/drawing/2014/main" id="{49340645-DE5C-435B-891E-FBDEE5545D31}"/>
                  </a:ext>
                </a:extLst>
              </p:cNvPr>
              <p:cNvSpPr/>
              <p:nvPr/>
            </p:nvSpPr>
            <p:spPr>
              <a:xfrm>
                <a:off x="4452820" y="2011640"/>
                <a:ext cx="760810" cy="802712"/>
              </a:xfrm>
              <a:custGeom>
                <a:avLst/>
                <a:gdLst>
                  <a:gd name="connsiteX0" fmla="*/ 201613 w 1014413"/>
                  <a:gd name="connsiteY0" fmla="*/ 129763 h 1070282"/>
                  <a:gd name="connsiteX1" fmla="*/ 112713 w 1014413"/>
                  <a:gd name="connsiteY1" fmla="*/ 193263 h 1070282"/>
                  <a:gd name="connsiteX2" fmla="*/ 74613 w 1014413"/>
                  <a:gd name="connsiteY2" fmla="*/ 218663 h 1070282"/>
                  <a:gd name="connsiteX3" fmla="*/ 49213 w 1014413"/>
                  <a:gd name="connsiteY3" fmla="*/ 225013 h 1070282"/>
                  <a:gd name="connsiteX4" fmla="*/ 30163 w 1014413"/>
                  <a:gd name="connsiteY4" fmla="*/ 231363 h 1070282"/>
                  <a:gd name="connsiteX5" fmla="*/ 17463 w 1014413"/>
                  <a:gd name="connsiteY5" fmla="*/ 364713 h 1070282"/>
                  <a:gd name="connsiteX6" fmla="*/ 42863 w 1014413"/>
                  <a:gd name="connsiteY6" fmla="*/ 447263 h 1070282"/>
                  <a:gd name="connsiteX7" fmla="*/ 61913 w 1014413"/>
                  <a:gd name="connsiteY7" fmla="*/ 479013 h 1070282"/>
                  <a:gd name="connsiteX8" fmla="*/ 87313 w 1014413"/>
                  <a:gd name="connsiteY8" fmla="*/ 523463 h 1070282"/>
                  <a:gd name="connsiteX9" fmla="*/ 131763 w 1014413"/>
                  <a:gd name="connsiteY9" fmla="*/ 567913 h 1070282"/>
                  <a:gd name="connsiteX10" fmla="*/ 144463 w 1014413"/>
                  <a:gd name="connsiteY10" fmla="*/ 586963 h 1070282"/>
                  <a:gd name="connsiteX11" fmla="*/ 214313 w 1014413"/>
                  <a:gd name="connsiteY11" fmla="*/ 625063 h 1070282"/>
                  <a:gd name="connsiteX12" fmla="*/ 258763 w 1014413"/>
                  <a:gd name="connsiteY12" fmla="*/ 682213 h 1070282"/>
                  <a:gd name="connsiteX13" fmla="*/ 284163 w 1014413"/>
                  <a:gd name="connsiteY13" fmla="*/ 707613 h 1070282"/>
                  <a:gd name="connsiteX14" fmla="*/ 290513 w 1014413"/>
                  <a:gd name="connsiteY14" fmla="*/ 726663 h 1070282"/>
                  <a:gd name="connsiteX15" fmla="*/ 360363 w 1014413"/>
                  <a:gd name="connsiteY15" fmla="*/ 783813 h 1070282"/>
                  <a:gd name="connsiteX16" fmla="*/ 417513 w 1014413"/>
                  <a:gd name="connsiteY16" fmla="*/ 821913 h 1070282"/>
                  <a:gd name="connsiteX17" fmla="*/ 436563 w 1014413"/>
                  <a:gd name="connsiteY17" fmla="*/ 834613 h 1070282"/>
                  <a:gd name="connsiteX18" fmla="*/ 455613 w 1014413"/>
                  <a:gd name="connsiteY18" fmla="*/ 840963 h 1070282"/>
                  <a:gd name="connsiteX19" fmla="*/ 500063 w 1014413"/>
                  <a:gd name="connsiteY19" fmla="*/ 866363 h 1070282"/>
                  <a:gd name="connsiteX20" fmla="*/ 544513 w 1014413"/>
                  <a:gd name="connsiteY20" fmla="*/ 910813 h 1070282"/>
                  <a:gd name="connsiteX21" fmla="*/ 550863 w 1014413"/>
                  <a:gd name="connsiteY21" fmla="*/ 929863 h 1070282"/>
                  <a:gd name="connsiteX22" fmla="*/ 614363 w 1014413"/>
                  <a:gd name="connsiteY22" fmla="*/ 980663 h 1070282"/>
                  <a:gd name="connsiteX23" fmla="*/ 671513 w 1014413"/>
                  <a:gd name="connsiteY23" fmla="*/ 1012413 h 1070282"/>
                  <a:gd name="connsiteX24" fmla="*/ 696913 w 1014413"/>
                  <a:gd name="connsiteY24" fmla="*/ 1025113 h 1070282"/>
                  <a:gd name="connsiteX25" fmla="*/ 785813 w 1014413"/>
                  <a:gd name="connsiteY25" fmla="*/ 1069563 h 1070282"/>
                  <a:gd name="connsiteX26" fmla="*/ 944563 w 1014413"/>
                  <a:gd name="connsiteY26" fmla="*/ 1063213 h 1070282"/>
                  <a:gd name="connsiteX27" fmla="*/ 969963 w 1014413"/>
                  <a:gd name="connsiteY27" fmla="*/ 1025113 h 1070282"/>
                  <a:gd name="connsiteX28" fmla="*/ 989013 w 1014413"/>
                  <a:gd name="connsiteY28" fmla="*/ 974313 h 1070282"/>
                  <a:gd name="connsiteX29" fmla="*/ 1001713 w 1014413"/>
                  <a:gd name="connsiteY29" fmla="*/ 929863 h 1070282"/>
                  <a:gd name="connsiteX30" fmla="*/ 1008063 w 1014413"/>
                  <a:gd name="connsiteY30" fmla="*/ 866363 h 1070282"/>
                  <a:gd name="connsiteX31" fmla="*/ 1014413 w 1014413"/>
                  <a:gd name="connsiteY31" fmla="*/ 821913 h 1070282"/>
                  <a:gd name="connsiteX32" fmla="*/ 1008063 w 1014413"/>
                  <a:gd name="connsiteY32" fmla="*/ 390113 h 1070282"/>
                  <a:gd name="connsiteX33" fmla="*/ 989013 w 1014413"/>
                  <a:gd name="connsiteY33" fmla="*/ 345663 h 1070282"/>
                  <a:gd name="connsiteX34" fmla="*/ 969963 w 1014413"/>
                  <a:gd name="connsiteY34" fmla="*/ 326613 h 1070282"/>
                  <a:gd name="connsiteX35" fmla="*/ 925513 w 1014413"/>
                  <a:gd name="connsiteY35" fmla="*/ 282163 h 1070282"/>
                  <a:gd name="connsiteX36" fmla="*/ 912813 w 1014413"/>
                  <a:gd name="connsiteY36" fmla="*/ 256763 h 1070282"/>
                  <a:gd name="connsiteX37" fmla="*/ 893763 w 1014413"/>
                  <a:gd name="connsiteY37" fmla="*/ 244063 h 1070282"/>
                  <a:gd name="connsiteX38" fmla="*/ 874713 w 1014413"/>
                  <a:gd name="connsiteY38" fmla="*/ 205963 h 1070282"/>
                  <a:gd name="connsiteX39" fmla="*/ 862013 w 1014413"/>
                  <a:gd name="connsiteY39" fmla="*/ 123413 h 1070282"/>
                  <a:gd name="connsiteX40" fmla="*/ 842963 w 1014413"/>
                  <a:gd name="connsiteY40" fmla="*/ 78963 h 1070282"/>
                  <a:gd name="connsiteX41" fmla="*/ 836613 w 1014413"/>
                  <a:gd name="connsiteY41" fmla="*/ 59913 h 1070282"/>
                  <a:gd name="connsiteX42" fmla="*/ 817563 w 1014413"/>
                  <a:gd name="connsiteY42" fmla="*/ 53563 h 1070282"/>
                  <a:gd name="connsiteX43" fmla="*/ 798513 w 1014413"/>
                  <a:gd name="connsiteY43" fmla="*/ 34513 h 1070282"/>
                  <a:gd name="connsiteX44" fmla="*/ 779463 w 1014413"/>
                  <a:gd name="connsiteY44" fmla="*/ 28163 h 1070282"/>
                  <a:gd name="connsiteX45" fmla="*/ 715963 w 1014413"/>
                  <a:gd name="connsiteY45" fmla="*/ 21813 h 1070282"/>
                  <a:gd name="connsiteX46" fmla="*/ 614363 w 1014413"/>
                  <a:gd name="connsiteY46" fmla="*/ 15463 h 1070282"/>
                  <a:gd name="connsiteX47" fmla="*/ 595313 w 1014413"/>
                  <a:gd name="connsiteY47" fmla="*/ 9113 h 1070282"/>
                  <a:gd name="connsiteX48" fmla="*/ 385763 w 1014413"/>
                  <a:gd name="connsiteY48" fmla="*/ 9113 h 1070282"/>
                  <a:gd name="connsiteX49" fmla="*/ 347663 w 1014413"/>
                  <a:gd name="connsiteY49" fmla="*/ 28163 h 1070282"/>
                  <a:gd name="connsiteX50" fmla="*/ 334963 w 1014413"/>
                  <a:gd name="connsiteY50" fmla="*/ 47213 h 1070282"/>
                  <a:gd name="connsiteX51" fmla="*/ 315913 w 1014413"/>
                  <a:gd name="connsiteY51" fmla="*/ 59913 h 1070282"/>
                  <a:gd name="connsiteX52" fmla="*/ 271463 w 1014413"/>
                  <a:gd name="connsiteY52" fmla="*/ 98013 h 1070282"/>
                  <a:gd name="connsiteX53" fmla="*/ 252413 w 1014413"/>
                  <a:gd name="connsiteY53" fmla="*/ 110713 h 1070282"/>
                  <a:gd name="connsiteX54" fmla="*/ 201613 w 1014413"/>
                  <a:gd name="connsiteY54" fmla="*/ 129763 h 1070282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  <a:cxn ang="0">
                    <a:pos x="connsiteX10" y="connsiteY10"/>
                  </a:cxn>
                  <a:cxn ang="0">
                    <a:pos x="connsiteX11" y="connsiteY11"/>
                  </a:cxn>
                  <a:cxn ang="0">
                    <a:pos x="connsiteX12" y="connsiteY12"/>
                  </a:cxn>
                  <a:cxn ang="0">
                    <a:pos x="connsiteX13" y="connsiteY13"/>
                  </a:cxn>
                  <a:cxn ang="0">
                    <a:pos x="connsiteX14" y="connsiteY14"/>
                  </a:cxn>
                  <a:cxn ang="0">
                    <a:pos x="connsiteX15" y="connsiteY15"/>
                  </a:cxn>
                  <a:cxn ang="0">
                    <a:pos x="connsiteX16" y="connsiteY16"/>
                  </a:cxn>
                  <a:cxn ang="0">
                    <a:pos x="connsiteX17" y="connsiteY17"/>
                  </a:cxn>
                  <a:cxn ang="0">
                    <a:pos x="connsiteX18" y="connsiteY18"/>
                  </a:cxn>
                  <a:cxn ang="0">
                    <a:pos x="connsiteX19" y="connsiteY19"/>
                  </a:cxn>
                  <a:cxn ang="0">
                    <a:pos x="connsiteX20" y="connsiteY20"/>
                  </a:cxn>
                  <a:cxn ang="0">
                    <a:pos x="connsiteX21" y="connsiteY21"/>
                  </a:cxn>
                  <a:cxn ang="0">
                    <a:pos x="connsiteX22" y="connsiteY22"/>
                  </a:cxn>
                  <a:cxn ang="0">
                    <a:pos x="connsiteX23" y="connsiteY23"/>
                  </a:cxn>
                  <a:cxn ang="0">
                    <a:pos x="connsiteX24" y="connsiteY24"/>
                  </a:cxn>
                  <a:cxn ang="0">
                    <a:pos x="connsiteX25" y="connsiteY25"/>
                  </a:cxn>
                  <a:cxn ang="0">
                    <a:pos x="connsiteX26" y="connsiteY26"/>
                  </a:cxn>
                  <a:cxn ang="0">
                    <a:pos x="connsiteX27" y="connsiteY27"/>
                  </a:cxn>
                  <a:cxn ang="0">
                    <a:pos x="connsiteX28" y="connsiteY28"/>
                  </a:cxn>
                  <a:cxn ang="0">
                    <a:pos x="connsiteX29" y="connsiteY29"/>
                  </a:cxn>
                  <a:cxn ang="0">
                    <a:pos x="connsiteX30" y="connsiteY30"/>
                  </a:cxn>
                  <a:cxn ang="0">
                    <a:pos x="connsiteX31" y="connsiteY31"/>
                  </a:cxn>
                  <a:cxn ang="0">
                    <a:pos x="connsiteX32" y="connsiteY32"/>
                  </a:cxn>
                  <a:cxn ang="0">
                    <a:pos x="connsiteX33" y="connsiteY33"/>
                  </a:cxn>
                  <a:cxn ang="0">
                    <a:pos x="connsiteX34" y="connsiteY34"/>
                  </a:cxn>
                  <a:cxn ang="0">
                    <a:pos x="connsiteX35" y="connsiteY35"/>
                  </a:cxn>
                  <a:cxn ang="0">
                    <a:pos x="connsiteX36" y="connsiteY36"/>
                  </a:cxn>
                  <a:cxn ang="0">
                    <a:pos x="connsiteX37" y="connsiteY37"/>
                  </a:cxn>
                  <a:cxn ang="0">
                    <a:pos x="connsiteX38" y="connsiteY38"/>
                  </a:cxn>
                  <a:cxn ang="0">
                    <a:pos x="connsiteX39" y="connsiteY39"/>
                  </a:cxn>
                  <a:cxn ang="0">
                    <a:pos x="connsiteX40" y="connsiteY40"/>
                  </a:cxn>
                  <a:cxn ang="0">
                    <a:pos x="connsiteX41" y="connsiteY41"/>
                  </a:cxn>
                  <a:cxn ang="0">
                    <a:pos x="connsiteX42" y="connsiteY42"/>
                  </a:cxn>
                  <a:cxn ang="0">
                    <a:pos x="connsiteX43" y="connsiteY43"/>
                  </a:cxn>
                  <a:cxn ang="0">
                    <a:pos x="connsiteX44" y="connsiteY44"/>
                  </a:cxn>
                  <a:cxn ang="0">
                    <a:pos x="connsiteX45" y="connsiteY45"/>
                  </a:cxn>
                  <a:cxn ang="0">
                    <a:pos x="connsiteX46" y="connsiteY46"/>
                  </a:cxn>
                  <a:cxn ang="0">
                    <a:pos x="connsiteX47" y="connsiteY47"/>
                  </a:cxn>
                  <a:cxn ang="0">
                    <a:pos x="connsiteX48" y="connsiteY48"/>
                  </a:cxn>
                  <a:cxn ang="0">
                    <a:pos x="connsiteX49" y="connsiteY49"/>
                  </a:cxn>
                  <a:cxn ang="0">
                    <a:pos x="connsiteX50" y="connsiteY50"/>
                  </a:cxn>
                  <a:cxn ang="0">
                    <a:pos x="connsiteX51" y="connsiteY51"/>
                  </a:cxn>
                  <a:cxn ang="0">
                    <a:pos x="connsiteX52" y="connsiteY52"/>
                  </a:cxn>
                  <a:cxn ang="0">
                    <a:pos x="connsiteX53" y="connsiteY53"/>
                  </a:cxn>
                  <a:cxn ang="0">
                    <a:pos x="connsiteX54" y="connsiteY54"/>
                  </a:cxn>
                </a:cxnLst>
                <a:rect l="l" t="t" r="r" b="b"/>
                <a:pathLst>
                  <a:path w="1014413" h="1070282">
                    <a:moveTo>
                      <a:pt x="201613" y="129763"/>
                    </a:moveTo>
                    <a:cubicBezTo>
                      <a:pt x="178330" y="143521"/>
                      <a:pt x="222982" y="114499"/>
                      <a:pt x="112713" y="193263"/>
                    </a:cubicBezTo>
                    <a:cubicBezTo>
                      <a:pt x="100293" y="202135"/>
                      <a:pt x="88265" y="211837"/>
                      <a:pt x="74613" y="218663"/>
                    </a:cubicBezTo>
                    <a:cubicBezTo>
                      <a:pt x="66807" y="222566"/>
                      <a:pt x="57604" y="222615"/>
                      <a:pt x="49213" y="225013"/>
                    </a:cubicBezTo>
                    <a:cubicBezTo>
                      <a:pt x="42777" y="226852"/>
                      <a:pt x="36513" y="229246"/>
                      <a:pt x="30163" y="231363"/>
                    </a:cubicBezTo>
                    <a:cubicBezTo>
                      <a:pt x="-14983" y="287795"/>
                      <a:pt x="-885" y="254623"/>
                      <a:pt x="17463" y="364713"/>
                    </a:cubicBezTo>
                    <a:cubicBezTo>
                      <a:pt x="21524" y="389076"/>
                      <a:pt x="31128" y="423793"/>
                      <a:pt x="42863" y="447263"/>
                    </a:cubicBezTo>
                    <a:cubicBezTo>
                      <a:pt x="48383" y="458302"/>
                      <a:pt x="55919" y="468224"/>
                      <a:pt x="61913" y="479013"/>
                    </a:cubicBezTo>
                    <a:cubicBezTo>
                      <a:pt x="70135" y="493812"/>
                      <a:pt x="75724" y="510587"/>
                      <a:pt x="87313" y="523463"/>
                    </a:cubicBezTo>
                    <a:cubicBezTo>
                      <a:pt x="101330" y="539038"/>
                      <a:pt x="120140" y="550478"/>
                      <a:pt x="131763" y="567913"/>
                    </a:cubicBezTo>
                    <a:cubicBezTo>
                      <a:pt x="135996" y="574263"/>
                      <a:pt x="138504" y="582195"/>
                      <a:pt x="144463" y="586963"/>
                    </a:cubicBezTo>
                    <a:cubicBezTo>
                      <a:pt x="179761" y="615201"/>
                      <a:pt x="183418" y="614765"/>
                      <a:pt x="214313" y="625063"/>
                    </a:cubicBezTo>
                    <a:cubicBezTo>
                      <a:pt x="281050" y="691800"/>
                      <a:pt x="199939" y="606582"/>
                      <a:pt x="258763" y="682213"/>
                    </a:cubicBezTo>
                    <a:cubicBezTo>
                      <a:pt x="266114" y="691664"/>
                      <a:pt x="275696" y="699146"/>
                      <a:pt x="284163" y="707613"/>
                    </a:cubicBezTo>
                    <a:cubicBezTo>
                      <a:pt x="286280" y="713963"/>
                      <a:pt x="286497" y="721308"/>
                      <a:pt x="290513" y="726663"/>
                    </a:cubicBezTo>
                    <a:cubicBezTo>
                      <a:pt x="315827" y="760415"/>
                      <a:pt x="327379" y="759075"/>
                      <a:pt x="360363" y="783813"/>
                    </a:cubicBezTo>
                    <a:cubicBezTo>
                      <a:pt x="402638" y="815519"/>
                      <a:pt x="368523" y="791294"/>
                      <a:pt x="417513" y="821913"/>
                    </a:cubicBezTo>
                    <a:cubicBezTo>
                      <a:pt x="423985" y="825958"/>
                      <a:pt x="429737" y="831200"/>
                      <a:pt x="436563" y="834613"/>
                    </a:cubicBezTo>
                    <a:cubicBezTo>
                      <a:pt x="442550" y="837606"/>
                      <a:pt x="449461" y="838326"/>
                      <a:pt x="455613" y="840963"/>
                    </a:cubicBezTo>
                    <a:cubicBezTo>
                      <a:pt x="466426" y="845597"/>
                      <a:pt x="490400" y="857667"/>
                      <a:pt x="500063" y="866363"/>
                    </a:cubicBezTo>
                    <a:cubicBezTo>
                      <a:pt x="515638" y="880380"/>
                      <a:pt x="544513" y="910813"/>
                      <a:pt x="544513" y="910813"/>
                    </a:cubicBezTo>
                    <a:cubicBezTo>
                      <a:pt x="546630" y="917163"/>
                      <a:pt x="546130" y="925130"/>
                      <a:pt x="550863" y="929863"/>
                    </a:cubicBezTo>
                    <a:cubicBezTo>
                      <a:pt x="570030" y="949030"/>
                      <a:pt x="590118" y="968541"/>
                      <a:pt x="614363" y="980663"/>
                    </a:cubicBezTo>
                    <a:cubicBezTo>
                      <a:pt x="675263" y="1011113"/>
                      <a:pt x="599752" y="972546"/>
                      <a:pt x="671513" y="1012413"/>
                    </a:cubicBezTo>
                    <a:cubicBezTo>
                      <a:pt x="679788" y="1017010"/>
                      <a:pt x="688694" y="1020417"/>
                      <a:pt x="696913" y="1025113"/>
                    </a:cubicBezTo>
                    <a:cubicBezTo>
                      <a:pt x="774206" y="1069281"/>
                      <a:pt x="734235" y="1056668"/>
                      <a:pt x="785813" y="1069563"/>
                    </a:cubicBezTo>
                    <a:cubicBezTo>
                      <a:pt x="838730" y="1067446"/>
                      <a:pt x="893083" y="1075639"/>
                      <a:pt x="944563" y="1063213"/>
                    </a:cubicBezTo>
                    <a:cubicBezTo>
                      <a:pt x="959400" y="1059632"/>
                      <a:pt x="969963" y="1025113"/>
                      <a:pt x="969963" y="1025113"/>
                    </a:cubicBezTo>
                    <a:cubicBezTo>
                      <a:pt x="981670" y="978284"/>
                      <a:pt x="969089" y="1020801"/>
                      <a:pt x="989013" y="974313"/>
                    </a:cubicBezTo>
                    <a:cubicBezTo>
                      <a:pt x="994479" y="961559"/>
                      <a:pt x="998491" y="942752"/>
                      <a:pt x="1001713" y="929863"/>
                    </a:cubicBezTo>
                    <a:cubicBezTo>
                      <a:pt x="1003830" y="908696"/>
                      <a:pt x="1005578" y="887490"/>
                      <a:pt x="1008063" y="866363"/>
                    </a:cubicBezTo>
                    <a:cubicBezTo>
                      <a:pt x="1009812" y="851498"/>
                      <a:pt x="1014413" y="836880"/>
                      <a:pt x="1014413" y="821913"/>
                    </a:cubicBezTo>
                    <a:cubicBezTo>
                      <a:pt x="1014413" y="677964"/>
                      <a:pt x="1012060" y="534006"/>
                      <a:pt x="1008063" y="390113"/>
                    </a:cubicBezTo>
                    <a:cubicBezTo>
                      <a:pt x="1007576" y="372584"/>
                      <a:pt x="999808" y="358617"/>
                      <a:pt x="989013" y="345663"/>
                    </a:cubicBezTo>
                    <a:cubicBezTo>
                      <a:pt x="983264" y="338764"/>
                      <a:pt x="975807" y="333431"/>
                      <a:pt x="969963" y="326613"/>
                    </a:cubicBezTo>
                    <a:cubicBezTo>
                      <a:pt x="934403" y="285126"/>
                      <a:pt x="969540" y="315183"/>
                      <a:pt x="925513" y="282163"/>
                    </a:cubicBezTo>
                    <a:cubicBezTo>
                      <a:pt x="921280" y="273696"/>
                      <a:pt x="918873" y="264035"/>
                      <a:pt x="912813" y="256763"/>
                    </a:cubicBezTo>
                    <a:cubicBezTo>
                      <a:pt x="907927" y="250900"/>
                      <a:pt x="899159" y="249459"/>
                      <a:pt x="893763" y="244063"/>
                    </a:cubicBezTo>
                    <a:cubicBezTo>
                      <a:pt x="881453" y="231753"/>
                      <a:pt x="879878" y="221457"/>
                      <a:pt x="874713" y="205963"/>
                    </a:cubicBezTo>
                    <a:cubicBezTo>
                      <a:pt x="872687" y="191784"/>
                      <a:pt x="865537" y="139272"/>
                      <a:pt x="862013" y="123413"/>
                    </a:cubicBezTo>
                    <a:cubicBezTo>
                      <a:pt x="857431" y="102793"/>
                      <a:pt x="851923" y="99869"/>
                      <a:pt x="842963" y="78963"/>
                    </a:cubicBezTo>
                    <a:cubicBezTo>
                      <a:pt x="840326" y="72811"/>
                      <a:pt x="841346" y="64646"/>
                      <a:pt x="836613" y="59913"/>
                    </a:cubicBezTo>
                    <a:cubicBezTo>
                      <a:pt x="831880" y="55180"/>
                      <a:pt x="823913" y="55680"/>
                      <a:pt x="817563" y="53563"/>
                    </a:cubicBezTo>
                    <a:cubicBezTo>
                      <a:pt x="811213" y="47213"/>
                      <a:pt x="805985" y="39494"/>
                      <a:pt x="798513" y="34513"/>
                    </a:cubicBezTo>
                    <a:cubicBezTo>
                      <a:pt x="792944" y="30800"/>
                      <a:pt x="786079" y="29181"/>
                      <a:pt x="779463" y="28163"/>
                    </a:cubicBezTo>
                    <a:cubicBezTo>
                      <a:pt x="758438" y="24928"/>
                      <a:pt x="737173" y="23445"/>
                      <a:pt x="715963" y="21813"/>
                    </a:cubicBezTo>
                    <a:cubicBezTo>
                      <a:pt x="682130" y="19210"/>
                      <a:pt x="648230" y="17580"/>
                      <a:pt x="614363" y="15463"/>
                    </a:cubicBezTo>
                    <a:cubicBezTo>
                      <a:pt x="608013" y="13346"/>
                      <a:pt x="601807" y="10736"/>
                      <a:pt x="595313" y="9113"/>
                    </a:cubicBezTo>
                    <a:cubicBezTo>
                      <a:pt x="521143" y="-9429"/>
                      <a:pt x="487900" y="5465"/>
                      <a:pt x="385763" y="9113"/>
                    </a:cubicBezTo>
                    <a:cubicBezTo>
                      <a:pt x="370269" y="14278"/>
                      <a:pt x="359973" y="15853"/>
                      <a:pt x="347663" y="28163"/>
                    </a:cubicBezTo>
                    <a:cubicBezTo>
                      <a:pt x="342267" y="33559"/>
                      <a:pt x="340359" y="41817"/>
                      <a:pt x="334963" y="47213"/>
                    </a:cubicBezTo>
                    <a:cubicBezTo>
                      <a:pt x="329567" y="52609"/>
                      <a:pt x="321776" y="55027"/>
                      <a:pt x="315913" y="59913"/>
                    </a:cubicBezTo>
                    <a:cubicBezTo>
                      <a:pt x="260527" y="106068"/>
                      <a:pt x="338050" y="50451"/>
                      <a:pt x="271463" y="98013"/>
                    </a:cubicBezTo>
                    <a:cubicBezTo>
                      <a:pt x="265253" y="102449"/>
                      <a:pt x="259585" y="108105"/>
                      <a:pt x="252413" y="110713"/>
                    </a:cubicBezTo>
                    <a:cubicBezTo>
                      <a:pt x="236009" y="116678"/>
                      <a:pt x="224896" y="116005"/>
                      <a:pt x="201613" y="129763"/>
                    </a:cubicBezTo>
                    <a:close/>
                  </a:path>
                </a:pathLst>
              </a:custGeom>
              <a:noFill/>
              <a:ln>
                <a:solidFill>
                  <a:srgbClr val="FFFF00"/>
                </a:solidFill>
              </a:ln>
            </p:spPr>
            <p:style>
              <a:lnRef idx="2">
                <a:schemeClr val="accent1">
                  <a:shade val="15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US" sz="1350" b="1" i="0" u="none" strike="noStrike" kern="1200" cap="none" spc="0" normalizeH="0" baseline="0" noProof="0">
                  <a:ln>
                    <a:noFill/>
                  </a:ln>
                  <a:solidFill>
                    <a:prstClr val="white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Box 96">
                <a:extLst>
                  <a:ext uri="{FF2B5EF4-FFF2-40B4-BE49-F238E27FC236}">
                    <a16:creationId xmlns:a16="http://schemas.microsoft.com/office/drawing/2014/main" id="{00FBDDA3-16A0-4F40-8190-E7E78FD84584}"/>
                  </a:ext>
                </a:extLst>
              </p:cNvPr>
              <p:cNvSpPr txBox="1"/>
              <p:nvPr/>
            </p:nvSpPr>
            <p:spPr>
              <a:xfrm>
                <a:off x="4416675" y="716945"/>
                <a:ext cx="221877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98" name="TextBox 97">
                <a:extLst>
                  <a:ext uri="{FF2B5EF4-FFF2-40B4-BE49-F238E27FC236}">
                    <a16:creationId xmlns:a16="http://schemas.microsoft.com/office/drawing/2014/main" id="{FCF92DC1-6B53-4D29-B4C3-226800F925B6}"/>
                  </a:ext>
                </a:extLst>
              </p:cNvPr>
              <p:cNvSpPr txBox="1"/>
              <p:nvPr/>
            </p:nvSpPr>
            <p:spPr>
              <a:xfrm>
                <a:off x="4722286" y="2203189"/>
                <a:ext cx="221877" cy="30008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350" b="1" i="0" u="none" strike="noStrike" kern="1200" cap="none" spc="0" normalizeH="0" baseline="0" noProof="0" dirty="0">
                    <a:ln>
                      <a:noFill/>
                    </a:ln>
                    <a:solidFill>
                      <a:srgbClr val="FFFF00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T</a:t>
                </a:r>
              </a:p>
            </p:txBody>
          </p:sp>
          <p:sp>
            <p:nvSpPr>
              <p:cNvPr id="99" name="TextBox 98">
                <a:extLst>
                  <a:ext uri="{FF2B5EF4-FFF2-40B4-BE49-F238E27FC236}">
                    <a16:creationId xmlns:a16="http://schemas.microsoft.com/office/drawing/2014/main" id="{576B470D-7C90-41F1-84D2-5A2BA2D1CCDE}"/>
                  </a:ext>
                </a:extLst>
              </p:cNvPr>
              <p:cNvSpPr txBox="1"/>
              <p:nvPr/>
            </p:nvSpPr>
            <p:spPr>
              <a:xfrm>
                <a:off x="2541092" y="171733"/>
                <a:ext cx="2353235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ctr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Vehicle</a:t>
                </a:r>
              </a:p>
            </p:txBody>
          </p:sp>
          <p:sp>
            <p:nvSpPr>
              <p:cNvPr id="100" name="TextBox 99">
                <a:extLst>
                  <a:ext uri="{FF2B5EF4-FFF2-40B4-BE49-F238E27FC236}">
                    <a16:creationId xmlns:a16="http://schemas.microsoft.com/office/drawing/2014/main" id="{539DF01F-88EB-4B33-938F-27DB0B4AEF6F}"/>
                  </a:ext>
                </a:extLst>
              </p:cNvPr>
              <p:cNvSpPr txBox="1"/>
              <p:nvPr/>
            </p:nvSpPr>
            <p:spPr>
              <a:xfrm rot="16200000">
                <a:off x="1397351" y="906143"/>
                <a:ext cx="87280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 54</a:t>
                </a:r>
              </a:p>
            </p:txBody>
          </p:sp>
          <p:sp>
            <p:nvSpPr>
              <p:cNvPr id="101" name="TextBox 100">
                <a:extLst>
                  <a:ext uri="{FF2B5EF4-FFF2-40B4-BE49-F238E27FC236}">
                    <a16:creationId xmlns:a16="http://schemas.microsoft.com/office/drawing/2014/main" id="{4DAE181D-AF97-4732-B951-89E1122A35DF}"/>
                  </a:ext>
                </a:extLst>
              </p:cNvPr>
              <p:cNvSpPr txBox="1"/>
              <p:nvPr/>
            </p:nvSpPr>
            <p:spPr>
              <a:xfrm rot="16200000">
                <a:off x="1391073" y="2256554"/>
                <a:ext cx="872800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marL="0" marR="0" lvl="0" indent="0" algn="l" defTabSz="6858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US" sz="1600" b="1" i="0" u="none" strike="noStrike" kern="1200" cap="none" spc="0" normalizeH="0" baseline="0" noProof="0" dirty="0">
                    <a:ln>
                      <a:noFill/>
                    </a:ln>
                    <a:solidFill>
                      <a:prstClr val="black"/>
                    </a:solidFill>
                    <a:effectLst/>
                    <a:uLnTx/>
                    <a:uFillTx/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rPr>
                  <a:t>Day 97</a:t>
                </a:r>
              </a:p>
            </p:txBody>
          </p:sp>
        </p:grp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B7A13E70-F131-4573-ADD5-51139A8A8617}"/>
                </a:ext>
              </a:extLst>
            </p:cNvPr>
            <p:cNvSpPr/>
            <p:nvPr/>
          </p:nvSpPr>
          <p:spPr>
            <a:xfrm>
              <a:off x="1193132" y="3659430"/>
              <a:ext cx="7565013" cy="3069623"/>
            </a:xfrm>
            <a:prstGeom prst="rect">
              <a:avLst/>
            </a:prstGeom>
            <a:noFill/>
            <a:ln w="285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marL="0" marR="0" lvl="0" indent="0" algn="ct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US" sz="1800" b="0" i="0" u="none" strike="noStrike" kern="1200" cap="none" spc="0" normalizeH="0" baseline="0" noProof="0">
                <a:ln>
                  <a:noFill/>
                </a:ln>
                <a:solidFill>
                  <a:prstClr val="white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102" name="TextBox 101">
              <a:extLst>
                <a:ext uri="{FF2B5EF4-FFF2-40B4-BE49-F238E27FC236}">
                  <a16:creationId xmlns:a16="http://schemas.microsoft.com/office/drawing/2014/main" id="{0C9842B6-F19F-4848-B597-E882BBB6989A}"/>
                </a:ext>
              </a:extLst>
            </p:cNvPr>
            <p:cNvSpPr txBox="1"/>
            <p:nvPr/>
          </p:nvSpPr>
          <p:spPr>
            <a:xfrm>
              <a:off x="1199384" y="3597338"/>
              <a:ext cx="389850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algn="l" defTabSz="6858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sz="1800" b="1" i="0" u="none" strike="noStrike" kern="1200" cap="none" spc="0" normalizeH="0" baseline="0" noProof="0" dirty="0">
                  <a:ln>
                    <a:noFill/>
                  </a:ln>
                  <a:solidFill>
                    <a:prstClr val="black"/>
                  </a:solidFill>
                  <a:effectLst/>
                  <a:uLnTx/>
                  <a:uFillTx/>
                  <a:latin typeface="Arial" panose="020B0604020202020204" pitchFamily="34" charset="0"/>
                  <a:ea typeface="+mn-ea"/>
                  <a:cs typeface="Arial" panose="020B0604020202020204" pitchFamily="34" charset="0"/>
                </a:rPr>
                <a:t>b.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4286172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0</Words>
  <Application>Microsoft Office PowerPoint</Application>
  <PresentationFormat>On-screen Show (4:3)</PresentationFormat>
  <Paragraphs>3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1_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id Sebti</dc:creator>
  <cp:lastModifiedBy>Said Sebti</cp:lastModifiedBy>
  <cp:revision>1</cp:revision>
  <dcterms:created xsi:type="dcterms:W3CDTF">2023-10-30T19:46:03Z</dcterms:created>
  <dcterms:modified xsi:type="dcterms:W3CDTF">2023-10-30T19:46:58Z</dcterms:modified>
</cp:coreProperties>
</file>